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sldIdLst>
    <p:sldId id="271" r:id="rId2"/>
    <p:sldId id="272" r:id="rId3"/>
    <p:sldId id="273" r:id="rId4"/>
    <p:sldId id="275" r:id="rId5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2814" y="-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51F75CE-D645-430A-8A7D-045CC4F3D677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53FA529E-B79B-4704-A197-A32902797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0674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709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095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740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106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284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85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602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609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193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868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864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6730F-1773-4634-8DFD-29B1401EC1E8}" type="datetimeFigureOut">
              <a:rPr lang="en-US" smtClean="0"/>
              <a:t>3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A07D0-66AB-4E02-8606-69349CE8E7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154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26" Type="http://schemas.openxmlformats.org/officeDocument/2006/relationships/oleObject" Target="../embeddings/oleObject13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29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28" Type="http://schemas.openxmlformats.org/officeDocument/2006/relationships/oleObject" Target="../embeddings/oleObject14.bin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13" Type="http://schemas.openxmlformats.org/officeDocument/2006/relationships/image" Target="../media/image20.emf"/><Relationship Id="rId18" Type="http://schemas.openxmlformats.org/officeDocument/2006/relationships/oleObject" Target="../embeddings/oleObject23.bin"/><Relationship Id="rId26" Type="http://schemas.openxmlformats.org/officeDocument/2006/relationships/oleObject" Target="../embeddings/oleObject27.bin"/><Relationship Id="rId3" Type="http://schemas.openxmlformats.org/officeDocument/2006/relationships/image" Target="../media/image15.emf"/><Relationship Id="rId21" Type="http://schemas.openxmlformats.org/officeDocument/2006/relationships/image" Target="../media/image24.emf"/><Relationship Id="rId7" Type="http://schemas.openxmlformats.org/officeDocument/2006/relationships/image" Target="../media/image17.emf"/><Relationship Id="rId12" Type="http://schemas.openxmlformats.org/officeDocument/2006/relationships/oleObject" Target="../embeddings/oleObject20.bin"/><Relationship Id="rId17" Type="http://schemas.openxmlformats.org/officeDocument/2006/relationships/image" Target="../media/image22.emf"/><Relationship Id="rId25" Type="http://schemas.openxmlformats.org/officeDocument/2006/relationships/image" Target="../media/image26.emf"/><Relationship Id="rId2" Type="http://schemas.openxmlformats.org/officeDocument/2006/relationships/oleObject" Target="../embeddings/oleObject15.bin"/><Relationship Id="rId16" Type="http://schemas.openxmlformats.org/officeDocument/2006/relationships/oleObject" Target="../embeddings/oleObject22.bin"/><Relationship Id="rId20" Type="http://schemas.openxmlformats.org/officeDocument/2006/relationships/oleObject" Target="../embeddings/oleObject24.bin"/><Relationship Id="rId29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7.bin"/><Relationship Id="rId11" Type="http://schemas.openxmlformats.org/officeDocument/2006/relationships/image" Target="../media/image19.emf"/><Relationship Id="rId24" Type="http://schemas.openxmlformats.org/officeDocument/2006/relationships/oleObject" Target="../embeddings/oleObject26.bin"/><Relationship Id="rId5" Type="http://schemas.openxmlformats.org/officeDocument/2006/relationships/image" Target="../media/image16.emf"/><Relationship Id="rId15" Type="http://schemas.openxmlformats.org/officeDocument/2006/relationships/image" Target="../media/image21.emf"/><Relationship Id="rId23" Type="http://schemas.openxmlformats.org/officeDocument/2006/relationships/image" Target="../media/image25.emf"/><Relationship Id="rId28" Type="http://schemas.openxmlformats.org/officeDocument/2006/relationships/oleObject" Target="../embeddings/oleObject28.bin"/><Relationship Id="rId10" Type="http://schemas.openxmlformats.org/officeDocument/2006/relationships/oleObject" Target="../embeddings/oleObject19.bin"/><Relationship Id="rId19" Type="http://schemas.openxmlformats.org/officeDocument/2006/relationships/image" Target="../media/image23.emf"/><Relationship Id="rId4" Type="http://schemas.openxmlformats.org/officeDocument/2006/relationships/oleObject" Target="../embeddings/oleObject16.bin"/><Relationship Id="rId9" Type="http://schemas.openxmlformats.org/officeDocument/2006/relationships/image" Target="../media/image18.emf"/><Relationship Id="rId14" Type="http://schemas.openxmlformats.org/officeDocument/2006/relationships/oleObject" Target="../embeddings/oleObject21.bin"/><Relationship Id="rId22" Type="http://schemas.openxmlformats.org/officeDocument/2006/relationships/oleObject" Target="../embeddings/oleObject25.bin"/><Relationship Id="rId27" Type="http://schemas.openxmlformats.org/officeDocument/2006/relationships/image" Target="../media/image2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2.bin"/><Relationship Id="rId13" Type="http://schemas.openxmlformats.org/officeDocument/2006/relationships/image" Target="../media/image34.emf"/><Relationship Id="rId18" Type="http://schemas.openxmlformats.org/officeDocument/2006/relationships/oleObject" Target="../embeddings/oleObject37.bin"/><Relationship Id="rId3" Type="http://schemas.openxmlformats.org/officeDocument/2006/relationships/image" Target="../media/image29.emf"/><Relationship Id="rId21" Type="http://schemas.openxmlformats.org/officeDocument/2006/relationships/image" Target="../media/image38.emf"/><Relationship Id="rId7" Type="http://schemas.openxmlformats.org/officeDocument/2006/relationships/image" Target="../media/image31.emf"/><Relationship Id="rId12" Type="http://schemas.openxmlformats.org/officeDocument/2006/relationships/oleObject" Target="../embeddings/oleObject34.bin"/><Relationship Id="rId17" Type="http://schemas.openxmlformats.org/officeDocument/2006/relationships/image" Target="../media/image36.emf"/><Relationship Id="rId25" Type="http://schemas.openxmlformats.org/officeDocument/2006/relationships/image" Target="../media/image40.emf"/><Relationship Id="rId2" Type="http://schemas.openxmlformats.org/officeDocument/2006/relationships/oleObject" Target="../embeddings/oleObject29.bin"/><Relationship Id="rId16" Type="http://schemas.openxmlformats.org/officeDocument/2006/relationships/oleObject" Target="../embeddings/oleObject36.bin"/><Relationship Id="rId20" Type="http://schemas.openxmlformats.org/officeDocument/2006/relationships/oleObject" Target="../embeddings/oleObject3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1.bin"/><Relationship Id="rId11" Type="http://schemas.openxmlformats.org/officeDocument/2006/relationships/image" Target="../media/image33.emf"/><Relationship Id="rId24" Type="http://schemas.openxmlformats.org/officeDocument/2006/relationships/oleObject" Target="../embeddings/oleObject40.bin"/><Relationship Id="rId5" Type="http://schemas.openxmlformats.org/officeDocument/2006/relationships/image" Target="../media/image30.emf"/><Relationship Id="rId15" Type="http://schemas.openxmlformats.org/officeDocument/2006/relationships/image" Target="../media/image35.emf"/><Relationship Id="rId23" Type="http://schemas.openxmlformats.org/officeDocument/2006/relationships/image" Target="../media/image39.emf"/><Relationship Id="rId10" Type="http://schemas.openxmlformats.org/officeDocument/2006/relationships/oleObject" Target="../embeddings/oleObject33.bin"/><Relationship Id="rId19" Type="http://schemas.openxmlformats.org/officeDocument/2006/relationships/image" Target="../media/image37.emf"/><Relationship Id="rId4" Type="http://schemas.openxmlformats.org/officeDocument/2006/relationships/oleObject" Target="../embeddings/oleObject30.bin"/><Relationship Id="rId9" Type="http://schemas.openxmlformats.org/officeDocument/2006/relationships/image" Target="../media/image32.emf"/><Relationship Id="rId14" Type="http://schemas.openxmlformats.org/officeDocument/2006/relationships/oleObject" Target="../embeddings/oleObject35.bin"/><Relationship Id="rId22" Type="http://schemas.openxmlformats.org/officeDocument/2006/relationships/oleObject" Target="../embeddings/oleObject39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4.bin"/><Relationship Id="rId13" Type="http://schemas.openxmlformats.org/officeDocument/2006/relationships/image" Target="../media/image46.emf"/><Relationship Id="rId18" Type="http://schemas.openxmlformats.org/officeDocument/2006/relationships/oleObject" Target="../embeddings/oleObject49.bin"/><Relationship Id="rId3" Type="http://schemas.openxmlformats.org/officeDocument/2006/relationships/image" Target="../media/image41.emf"/><Relationship Id="rId21" Type="http://schemas.openxmlformats.org/officeDocument/2006/relationships/image" Target="../media/image50.emf"/><Relationship Id="rId7" Type="http://schemas.openxmlformats.org/officeDocument/2006/relationships/image" Target="../media/image43.emf"/><Relationship Id="rId12" Type="http://schemas.openxmlformats.org/officeDocument/2006/relationships/oleObject" Target="../embeddings/oleObject46.bin"/><Relationship Id="rId17" Type="http://schemas.openxmlformats.org/officeDocument/2006/relationships/image" Target="../media/image48.emf"/><Relationship Id="rId2" Type="http://schemas.openxmlformats.org/officeDocument/2006/relationships/oleObject" Target="../embeddings/oleObject41.bin"/><Relationship Id="rId16" Type="http://schemas.openxmlformats.org/officeDocument/2006/relationships/oleObject" Target="../embeddings/oleObject48.bin"/><Relationship Id="rId20" Type="http://schemas.openxmlformats.org/officeDocument/2006/relationships/oleObject" Target="../embeddings/oleObject5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43.bin"/><Relationship Id="rId11" Type="http://schemas.openxmlformats.org/officeDocument/2006/relationships/image" Target="../media/image45.emf"/><Relationship Id="rId5" Type="http://schemas.openxmlformats.org/officeDocument/2006/relationships/image" Target="../media/image42.emf"/><Relationship Id="rId15" Type="http://schemas.openxmlformats.org/officeDocument/2006/relationships/image" Target="../media/image47.emf"/><Relationship Id="rId23" Type="http://schemas.openxmlformats.org/officeDocument/2006/relationships/image" Target="../media/image51.emf"/><Relationship Id="rId10" Type="http://schemas.openxmlformats.org/officeDocument/2006/relationships/oleObject" Target="../embeddings/oleObject45.bin"/><Relationship Id="rId19" Type="http://schemas.openxmlformats.org/officeDocument/2006/relationships/image" Target="../media/image49.emf"/><Relationship Id="rId4" Type="http://schemas.openxmlformats.org/officeDocument/2006/relationships/oleObject" Target="../embeddings/oleObject42.bin"/><Relationship Id="rId9" Type="http://schemas.openxmlformats.org/officeDocument/2006/relationships/image" Target="../media/image44.emf"/><Relationship Id="rId14" Type="http://schemas.openxmlformats.org/officeDocument/2006/relationships/oleObject" Target="../embeddings/oleObject47.bin"/><Relationship Id="rId22" Type="http://schemas.openxmlformats.org/officeDocument/2006/relationships/oleObject" Target="../embeddings/oleObject5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Box 72">
            <a:extLst>
              <a:ext uri="{FF2B5EF4-FFF2-40B4-BE49-F238E27FC236}">
                <a16:creationId xmlns:a16="http://schemas.microsoft.com/office/drawing/2014/main" id="{E4A7C1EB-FDA7-BA4A-8A11-202B95B00D45}"/>
              </a:ext>
            </a:extLst>
          </p:cNvPr>
          <p:cNvSpPr txBox="1"/>
          <p:nvPr/>
        </p:nvSpPr>
        <p:spPr>
          <a:xfrm>
            <a:off x="397164" y="546020"/>
            <a:ext cx="1813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Material</a:t>
            </a:r>
          </a:p>
        </p:txBody>
      </p:sp>
      <p:grpSp>
        <p:nvGrpSpPr>
          <p:cNvPr id="98" name="Group 97">
            <a:extLst>
              <a:ext uri="{FF2B5EF4-FFF2-40B4-BE49-F238E27FC236}">
                <a16:creationId xmlns:a16="http://schemas.microsoft.com/office/drawing/2014/main" id="{7628F50E-0B37-1947-A2FF-0BC223E66F3B}"/>
              </a:ext>
            </a:extLst>
          </p:cNvPr>
          <p:cNvGrpSpPr/>
          <p:nvPr/>
        </p:nvGrpSpPr>
        <p:grpSpPr>
          <a:xfrm>
            <a:off x="394641" y="1068066"/>
            <a:ext cx="6338893" cy="7242118"/>
            <a:chOff x="394641" y="1068066"/>
            <a:chExt cx="6338893" cy="7242118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24331AB-1C1B-0F45-B76D-F7137FE29B90}"/>
                </a:ext>
              </a:extLst>
            </p:cNvPr>
            <p:cNvSpPr txBox="1"/>
            <p:nvPr/>
          </p:nvSpPr>
          <p:spPr>
            <a:xfrm>
              <a:off x="397164" y="6925189"/>
              <a:ext cx="6144810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steocytic deletion of PP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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id not alter trabecular and cortical bone in 6 months old female mice A. mCT measurements of trabecular bone in proximal tibia: total volume (TV), bone volume (BV), bone mass (BV/TV), trabecular number (TbN) and trabecular thickness (TbTh). B. mCT measurements of cortical bone in midshaft tibia: total cross-sectional area (T.Ar), bone area (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.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bone mass (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.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.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cortical thickness (Ct.Th.), marrow area (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.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and bone mineral density (BMD). WT n=4,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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</a:t>
              </a:r>
              <a:r>
                <a:rPr lang="en-US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=5 per group C. Fat volume (FV) in proximal or distal or entire tibia. n=4 per group</a:t>
              </a:r>
            </a:p>
          </p:txBody>
        </p: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F9281808-CA9A-F270-238F-ED27BE7D8278}"/>
                </a:ext>
              </a:extLst>
            </p:cNvPr>
            <p:cNvGrpSpPr/>
            <p:nvPr/>
          </p:nvGrpSpPr>
          <p:grpSpPr>
            <a:xfrm>
              <a:off x="394641" y="1068066"/>
              <a:ext cx="6338893" cy="5601488"/>
              <a:chOff x="394641" y="1068066"/>
              <a:chExt cx="6338893" cy="5601488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6870B85-00CC-4247-BCA0-1FE64B3842D5}"/>
                  </a:ext>
                </a:extLst>
              </p:cNvPr>
              <p:cNvSpPr txBox="1"/>
              <p:nvPr/>
            </p:nvSpPr>
            <p:spPr>
              <a:xfrm>
                <a:off x="617326" y="1068066"/>
                <a:ext cx="13559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A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64A56D6-08DB-431E-B28C-2874DDFE3E4A}"/>
                  </a:ext>
                </a:extLst>
              </p:cNvPr>
              <p:cNvSpPr txBox="1"/>
              <p:nvPr/>
            </p:nvSpPr>
            <p:spPr>
              <a:xfrm>
                <a:off x="426810" y="2883010"/>
                <a:ext cx="13559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B</a:t>
                </a:r>
              </a:p>
            </p:txBody>
          </p:sp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0EC9B290-1E83-3C99-79EA-C4921FB42F40}"/>
                  </a:ext>
                </a:extLst>
              </p:cNvPr>
              <p:cNvGrpSpPr/>
              <p:nvPr/>
            </p:nvGrpSpPr>
            <p:grpSpPr>
              <a:xfrm>
                <a:off x="671985" y="1200712"/>
                <a:ext cx="1150417" cy="1675731"/>
                <a:chOff x="775221" y="1171216"/>
                <a:chExt cx="1150417" cy="1675731"/>
              </a:xfrm>
            </p:grpSpPr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A2751D6F-9E58-4FEB-B0C5-AC25273D549E}"/>
                    </a:ext>
                  </a:extLst>
                </p:cNvPr>
                <p:cNvSpPr txBox="1"/>
                <p:nvPr/>
              </p:nvSpPr>
              <p:spPr>
                <a:xfrm>
                  <a:off x="1289219" y="1171216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TV</a:t>
                  </a: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601D800D-D08F-4C74-B58F-26C305715A4D}"/>
                    </a:ext>
                  </a:extLst>
                </p:cNvPr>
                <p:cNvSpPr txBox="1"/>
                <p:nvPr/>
              </p:nvSpPr>
              <p:spPr>
                <a:xfrm rot="16200000">
                  <a:off x="649427" y="1809431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3</a:t>
                  </a:r>
                </a:p>
              </p:txBody>
            </p:sp>
            <p:grpSp>
              <p:nvGrpSpPr>
                <p:cNvPr id="44" name="Group 43">
                  <a:extLst>
                    <a:ext uri="{FF2B5EF4-FFF2-40B4-BE49-F238E27FC236}">
                      <a16:creationId xmlns:a16="http://schemas.microsoft.com/office/drawing/2014/main" id="{380E7065-14C4-FF0F-42AF-CDCE0B3B09D3}"/>
                    </a:ext>
                  </a:extLst>
                </p:cNvPr>
                <p:cNvGrpSpPr/>
                <p:nvPr/>
              </p:nvGrpSpPr>
              <p:grpSpPr>
                <a:xfrm>
                  <a:off x="1155932" y="2629020"/>
                  <a:ext cx="769122" cy="217927"/>
                  <a:chOff x="1155932" y="2629020"/>
                  <a:chExt cx="769122" cy="217927"/>
                </a:xfrm>
              </p:grpSpPr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75C4B9C1-452C-42D1-9F8F-73AF57DF0D17}"/>
                      </a:ext>
                    </a:extLst>
                  </p:cNvPr>
                  <p:cNvSpPr txBox="1"/>
                  <p:nvPr/>
                </p:nvSpPr>
                <p:spPr>
                  <a:xfrm>
                    <a:off x="1155932" y="2631632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Ctrl</a:t>
                    </a:r>
                    <a:endParaRPr lang="en-US" sz="799" baseline="30000" dirty="0"/>
                  </a:p>
                </p:txBody>
              </p:sp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D4F1284C-2B94-4692-BE6E-C88A4A825C37}"/>
                      </a:ext>
                    </a:extLst>
                  </p:cNvPr>
                  <p:cNvSpPr txBox="1"/>
                  <p:nvPr/>
                </p:nvSpPr>
                <p:spPr>
                  <a:xfrm>
                    <a:off x="1406706" y="2629020"/>
                    <a:ext cx="518348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OT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</p:grpSp>
            <p:graphicFrame>
              <p:nvGraphicFramePr>
                <p:cNvPr id="48" name="Object 47">
                  <a:extLst>
                    <a:ext uri="{FF2B5EF4-FFF2-40B4-BE49-F238E27FC236}">
                      <a16:creationId xmlns:a16="http://schemas.microsoft.com/office/drawing/2014/main" id="{7859910F-3C36-4E52-B830-C2C68DED678F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533472799"/>
                    </p:ext>
                  </p:extLst>
                </p:nvPr>
              </p:nvGraphicFramePr>
              <p:xfrm>
                <a:off x="968375" y="1352550"/>
                <a:ext cx="957263" cy="13684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2" imgW="1593240" imgH="2280856" progId="Prism9.Document">
                        <p:embed/>
                      </p:oleObj>
                    </mc:Choice>
                    <mc:Fallback>
                      <p:oleObj name="Prism 9" r:id="rId2" imgW="1593240" imgH="2280856" progId="Prism9.Document">
                        <p:embed/>
                        <p:pic>
                          <p:nvPicPr>
                            <p:cNvPr id="48" name="Object 47">
                              <a:extLst>
                                <a:ext uri="{FF2B5EF4-FFF2-40B4-BE49-F238E27FC236}">
                                  <a16:creationId xmlns:a16="http://schemas.microsoft.com/office/drawing/2014/main" id="{7859910F-3C36-4E52-B830-C2C68DED678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68375" y="1352550"/>
                              <a:ext cx="957263" cy="13684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77" name="Group 76">
                <a:extLst>
                  <a:ext uri="{FF2B5EF4-FFF2-40B4-BE49-F238E27FC236}">
                    <a16:creationId xmlns:a16="http://schemas.microsoft.com/office/drawing/2014/main" id="{F486E1B6-8F9A-3901-F06D-1B9841D17FE8}"/>
                  </a:ext>
                </a:extLst>
              </p:cNvPr>
              <p:cNvGrpSpPr/>
              <p:nvPr/>
            </p:nvGrpSpPr>
            <p:grpSpPr>
              <a:xfrm>
                <a:off x="1724163" y="1200711"/>
                <a:ext cx="1229569" cy="1678344"/>
                <a:chOff x="2048619" y="1171215"/>
                <a:chExt cx="1229569" cy="1678344"/>
              </a:xfrm>
            </p:grpSpPr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484C50C6-4FBC-4027-8CAB-BB6F23946234}"/>
                    </a:ext>
                  </a:extLst>
                </p:cNvPr>
                <p:cNvSpPr txBox="1"/>
                <p:nvPr/>
              </p:nvSpPr>
              <p:spPr>
                <a:xfrm>
                  <a:off x="2558210" y="1171215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BV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EE8ED419-2998-4E08-8B69-7D36392089C8}"/>
                    </a:ext>
                  </a:extLst>
                </p:cNvPr>
                <p:cNvSpPr txBox="1"/>
                <p:nvPr/>
              </p:nvSpPr>
              <p:spPr>
                <a:xfrm rot="16200000">
                  <a:off x="1922825" y="1809431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3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FC5C4170-B109-4C78-9E16-13402C7C1788}"/>
                    </a:ext>
                  </a:extLst>
                </p:cNvPr>
                <p:cNvSpPr txBox="1"/>
                <p:nvPr/>
              </p:nvSpPr>
              <p:spPr>
                <a:xfrm>
                  <a:off x="2459385" y="2634244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146ADFAF-2B5D-49D4-B87F-2F275BE6CBA7}"/>
                    </a:ext>
                  </a:extLst>
                </p:cNvPr>
                <p:cNvSpPr txBox="1"/>
                <p:nvPr/>
              </p:nvSpPr>
              <p:spPr>
                <a:xfrm>
                  <a:off x="2752069" y="2631632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graphicFrame>
              <p:nvGraphicFramePr>
                <p:cNvPr id="49" name="Object 48">
                  <a:extLst>
                    <a:ext uri="{FF2B5EF4-FFF2-40B4-BE49-F238E27FC236}">
                      <a16:creationId xmlns:a16="http://schemas.microsoft.com/office/drawing/2014/main" id="{891FBD70-1E53-4538-A500-61A70B4B9C7F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062904163"/>
                    </p:ext>
                  </p:extLst>
                </p:nvPr>
              </p:nvGraphicFramePr>
              <p:xfrm>
                <a:off x="2205038" y="1352550"/>
                <a:ext cx="1073150" cy="13684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4" imgW="1785193" imgH="2280856" progId="Prism9.Document">
                        <p:embed/>
                      </p:oleObj>
                    </mc:Choice>
                    <mc:Fallback>
                      <p:oleObj name="Prism 9" r:id="rId4" imgW="1785193" imgH="2280856" progId="Prism9.Document">
                        <p:embed/>
                        <p:pic>
                          <p:nvPicPr>
                            <p:cNvPr id="49" name="Object 48">
                              <a:extLst>
                                <a:ext uri="{FF2B5EF4-FFF2-40B4-BE49-F238E27FC236}">
                                  <a16:creationId xmlns:a16="http://schemas.microsoft.com/office/drawing/2014/main" id="{891FBD70-1E53-4538-A500-61A70B4B9C7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205038" y="1352550"/>
                              <a:ext cx="1073150" cy="13684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697626DB-69E8-B85D-60C9-724BD7184BDA}"/>
                  </a:ext>
                </a:extLst>
              </p:cNvPr>
              <p:cNvGrpSpPr/>
              <p:nvPr/>
            </p:nvGrpSpPr>
            <p:grpSpPr>
              <a:xfrm>
                <a:off x="3927215" y="1206247"/>
                <a:ext cx="1195774" cy="1650686"/>
                <a:chOff x="3285663" y="1198873"/>
                <a:chExt cx="1195774" cy="1650686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A80BA3C6-3878-4240-B8FD-905E2DBF55ED}"/>
                    </a:ext>
                  </a:extLst>
                </p:cNvPr>
                <p:cNvSpPr txBox="1"/>
                <p:nvPr/>
              </p:nvSpPr>
              <p:spPr>
                <a:xfrm>
                  <a:off x="3827201" y="1198873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TbN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CD74D8C3-A3B0-4021-8DE0-9D5B6D4AC4D1}"/>
                    </a:ext>
                  </a:extLst>
                </p:cNvPr>
                <p:cNvSpPr txBox="1"/>
                <p:nvPr/>
              </p:nvSpPr>
              <p:spPr>
                <a:xfrm>
                  <a:off x="3693265" y="2634244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A467F1DD-5378-4D57-9685-480EAC92D812}"/>
                    </a:ext>
                  </a:extLst>
                </p:cNvPr>
                <p:cNvSpPr txBox="1"/>
                <p:nvPr/>
              </p:nvSpPr>
              <p:spPr>
                <a:xfrm>
                  <a:off x="3963089" y="2631632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2F7D844C-DC47-49D2-8D7C-4E29EB23CD6B}"/>
                    </a:ext>
                  </a:extLst>
                </p:cNvPr>
                <p:cNvSpPr txBox="1"/>
                <p:nvPr/>
              </p:nvSpPr>
              <p:spPr>
                <a:xfrm rot="16200000">
                  <a:off x="3159869" y="1807159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1/mm</a:t>
                  </a:r>
                  <a:endParaRPr lang="en-US" sz="799" baseline="30000" dirty="0"/>
                </a:p>
              </p:txBody>
            </p:sp>
            <p:graphicFrame>
              <p:nvGraphicFramePr>
                <p:cNvPr id="50" name="Object 49">
                  <a:extLst>
                    <a:ext uri="{FF2B5EF4-FFF2-40B4-BE49-F238E27FC236}">
                      <a16:creationId xmlns:a16="http://schemas.microsoft.com/office/drawing/2014/main" id="{318870C7-D99E-409B-AF26-1DD0861FF2B1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988987055"/>
                    </p:ext>
                  </p:extLst>
                </p:nvPr>
              </p:nvGraphicFramePr>
              <p:xfrm>
                <a:off x="3457577" y="1373656"/>
                <a:ext cx="1020763" cy="13684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6" imgW="1699841" imgH="2280856" progId="Prism8.Document">
                        <p:embed/>
                      </p:oleObj>
                    </mc:Choice>
                    <mc:Fallback>
                      <p:oleObj name="Prism 8" r:id="rId6" imgW="1699841" imgH="2280856" progId="Prism8.Document">
                        <p:embed/>
                        <p:pic>
                          <p:nvPicPr>
                            <p:cNvPr id="50" name="Object 49">
                              <a:extLst>
                                <a:ext uri="{FF2B5EF4-FFF2-40B4-BE49-F238E27FC236}">
                                  <a16:creationId xmlns:a16="http://schemas.microsoft.com/office/drawing/2014/main" id="{318870C7-D99E-409B-AF26-1DD0861FF2B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457577" y="1373656"/>
                              <a:ext cx="1020763" cy="13684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1623F95F-2EBC-863E-96C9-9DE53AC2B356}"/>
                  </a:ext>
                </a:extLst>
              </p:cNvPr>
              <p:cNvGrpSpPr/>
              <p:nvPr/>
            </p:nvGrpSpPr>
            <p:grpSpPr>
              <a:xfrm>
                <a:off x="5038941" y="1206247"/>
                <a:ext cx="1237064" cy="1645462"/>
                <a:chOff x="4559621" y="1198873"/>
                <a:chExt cx="1237064" cy="1645462"/>
              </a:xfrm>
            </p:grpSpPr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19CE12B4-16A6-46DE-B15D-DF6087E0A1BC}"/>
                    </a:ext>
                  </a:extLst>
                </p:cNvPr>
                <p:cNvSpPr txBox="1"/>
                <p:nvPr/>
              </p:nvSpPr>
              <p:spPr>
                <a:xfrm>
                  <a:off x="5111604" y="1198873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TbTh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6B523C4F-D436-42AE-A229-5B54497E7EB3}"/>
                    </a:ext>
                  </a:extLst>
                </p:cNvPr>
                <p:cNvSpPr txBox="1"/>
                <p:nvPr/>
              </p:nvSpPr>
              <p:spPr>
                <a:xfrm>
                  <a:off x="5016133" y="2629020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DB10B95A-31B9-4AFC-B548-4F058D58DAB1}"/>
                    </a:ext>
                  </a:extLst>
                </p:cNvPr>
                <p:cNvSpPr txBox="1"/>
                <p:nvPr/>
              </p:nvSpPr>
              <p:spPr>
                <a:xfrm>
                  <a:off x="5278337" y="2626408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F40351B6-2428-4817-9A56-3CDBE90D91BF}"/>
                    </a:ext>
                  </a:extLst>
                </p:cNvPr>
                <p:cNvSpPr txBox="1"/>
                <p:nvPr/>
              </p:nvSpPr>
              <p:spPr>
                <a:xfrm rot="16200000">
                  <a:off x="4433827" y="1764469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endParaRPr lang="en-US" sz="799" baseline="30000" dirty="0"/>
                </a:p>
              </p:txBody>
            </p:sp>
            <p:graphicFrame>
              <p:nvGraphicFramePr>
                <p:cNvPr id="51" name="Object 50">
                  <a:extLst>
                    <a:ext uri="{FF2B5EF4-FFF2-40B4-BE49-F238E27FC236}">
                      <a16:creationId xmlns:a16="http://schemas.microsoft.com/office/drawing/2014/main" id="{A45F118F-BB26-488C-AB14-9E7D9F94668D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357780814"/>
                    </p:ext>
                  </p:extLst>
                </p:nvPr>
              </p:nvGraphicFramePr>
              <p:xfrm>
                <a:off x="4711700" y="1373188"/>
                <a:ext cx="1071563" cy="13684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8" imgW="1785193" imgH="2280856" progId="Prism9.Document">
                        <p:embed/>
                      </p:oleObj>
                    </mc:Choice>
                    <mc:Fallback>
                      <p:oleObj name="Prism 9" r:id="rId8" imgW="1785193" imgH="2280856" progId="Prism9.Document">
                        <p:embed/>
                        <p:pic>
                          <p:nvPicPr>
                            <p:cNvPr id="51" name="Object 50">
                              <a:extLst>
                                <a:ext uri="{FF2B5EF4-FFF2-40B4-BE49-F238E27FC236}">
                                  <a16:creationId xmlns:a16="http://schemas.microsoft.com/office/drawing/2014/main" id="{A45F118F-BB26-488C-AB14-9E7D9F94668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711700" y="1373188"/>
                              <a:ext cx="1071563" cy="13684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88" name="Group 87">
                <a:extLst>
                  <a:ext uri="{FF2B5EF4-FFF2-40B4-BE49-F238E27FC236}">
                    <a16:creationId xmlns:a16="http://schemas.microsoft.com/office/drawing/2014/main" id="{D0F12740-D9C7-2983-0C25-709CC6A4A5D6}"/>
                  </a:ext>
                </a:extLst>
              </p:cNvPr>
              <p:cNvGrpSpPr/>
              <p:nvPr/>
            </p:nvGrpSpPr>
            <p:grpSpPr>
              <a:xfrm>
                <a:off x="394641" y="2938004"/>
                <a:ext cx="1161109" cy="1662945"/>
                <a:chOff x="578991" y="2938004"/>
                <a:chExt cx="1161109" cy="1662945"/>
              </a:xfrm>
            </p:grpSpPr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8FA37E01-446D-4AFA-AF85-3B4F4FC68C0C}"/>
                    </a:ext>
                  </a:extLst>
                </p:cNvPr>
                <p:cNvSpPr txBox="1"/>
                <p:nvPr/>
              </p:nvSpPr>
              <p:spPr>
                <a:xfrm rot="16200000">
                  <a:off x="453197" y="3571787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2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049A9A38-6366-4065-9B07-A5E33628C7EE}"/>
                    </a:ext>
                  </a:extLst>
                </p:cNvPr>
                <p:cNvSpPr txBox="1"/>
                <p:nvPr/>
              </p:nvSpPr>
              <p:spPr>
                <a:xfrm>
                  <a:off x="1036369" y="2938004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TAr</a:t>
                  </a:r>
                </a:p>
              </p:txBody>
            </p:sp>
            <p:grpSp>
              <p:nvGrpSpPr>
                <p:cNvPr id="83" name="Group 82">
                  <a:extLst>
                    <a:ext uri="{FF2B5EF4-FFF2-40B4-BE49-F238E27FC236}">
                      <a16:creationId xmlns:a16="http://schemas.microsoft.com/office/drawing/2014/main" id="{BDB6FD9B-662A-B8D7-736F-3C44F259D622}"/>
                    </a:ext>
                  </a:extLst>
                </p:cNvPr>
                <p:cNvGrpSpPr/>
                <p:nvPr/>
              </p:nvGrpSpPr>
              <p:grpSpPr>
                <a:xfrm>
                  <a:off x="932574" y="4383022"/>
                  <a:ext cx="750072" cy="217927"/>
                  <a:chOff x="932574" y="4383022"/>
                  <a:chExt cx="750072" cy="217927"/>
                </a:xfrm>
              </p:grpSpPr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88DD0AD7-B333-40EC-9B6B-D21FAC7B8951}"/>
                      </a:ext>
                    </a:extLst>
                  </p:cNvPr>
                  <p:cNvSpPr txBox="1"/>
                  <p:nvPr/>
                </p:nvSpPr>
                <p:spPr>
                  <a:xfrm>
                    <a:off x="932574" y="4385634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Ctrl</a:t>
                    </a:r>
                    <a:endParaRPr lang="en-US" sz="799" baseline="30000" dirty="0"/>
                  </a:p>
                </p:txBody>
              </p:sp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E268ADBB-D2F4-4EF0-BF26-69137E308A1D}"/>
                      </a:ext>
                    </a:extLst>
                  </p:cNvPr>
                  <p:cNvSpPr txBox="1"/>
                  <p:nvPr/>
                </p:nvSpPr>
                <p:spPr>
                  <a:xfrm>
                    <a:off x="1164298" y="4383022"/>
                    <a:ext cx="518348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OT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</p:grpSp>
            <p:graphicFrame>
              <p:nvGraphicFramePr>
                <p:cNvPr id="52" name="Object 51">
                  <a:extLst>
                    <a:ext uri="{FF2B5EF4-FFF2-40B4-BE49-F238E27FC236}">
                      <a16:creationId xmlns:a16="http://schemas.microsoft.com/office/drawing/2014/main" id="{AEA1FDFE-D51C-4A01-8C68-D86A5132E38B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816863605"/>
                    </p:ext>
                  </p:extLst>
                </p:nvPr>
              </p:nvGraphicFramePr>
              <p:xfrm>
                <a:off x="716163" y="3105150"/>
                <a:ext cx="1023937" cy="13684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0" imgW="1709204" imgH="2280856" progId="Prism9.Document">
                        <p:embed/>
                      </p:oleObj>
                    </mc:Choice>
                    <mc:Fallback>
                      <p:oleObj name="Prism 9" r:id="rId10" imgW="1709204" imgH="2280856" progId="Prism9.Document">
                        <p:embed/>
                        <p:pic>
                          <p:nvPicPr>
                            <p:cNvPr id="52" name="Object 51">
                              <a:extLst>
                                <a:ext uri="{FF2B5EF4-FFF2-40B4-BE49-F238E27FC236}">
                                  <a16:creationId xmlns:a16="http://schemas.microsoft.com/office/drawing/2014/main" id="{AEA1FDFE-D51C-4A01-8C68-D86A5132E38B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16163" y="3105150"/>
                              <a:ext cx="1023937" cy="13684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90" name="Group 89">
                <a:extLst>
                  <a:ext uri="{FF2B5EF4-FFF2-40B4-BE49-F238E27FC236}">
                    <a16:creationId xmlns:a16="http://schemas.microsoft.com/office/drawing/2014/main" id="{2DF3B90D-F041-91DF-5D23-C9AE2E833E22}"/>
                  </a:ext>
                </a:extLst>
              </p:cNvPr>
              <p:cNvGrpSpPr/>
              <p:nvPr/>
            </p:nvGrpSpPr>
            <p:grpSpPr>
              <a:xfrm>
                <a:off x="4504328" y="2938004"/>
                <a:ext cx="1148650" cy="1662945"/>
                <a:chOff x="1790624" y="2938004"/>
                <a:chExt cx="1148650" cy="1662945"/>
              </a:xfrm>
            </p:grpSpPr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EB09BD41-6B36-49A7-BD6D-9C9567DFEA1C}"/>
                    </a:ext>
                  </a:extLst>
                </p:cNvPr>
                <p:cNvSpPr txBox="1"/>
                <p:nvPr/>
              </p:nvSpPr>
              <p:spPr>
                <a:xfrm>
                  <a:off x="2159696" y="4385634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5172D704-AA88-4500-90EC-4B8E1CB39F08}"/>
                    </a:ext>
                  </a:extLst>
                </p:cNvPr>
                <p:cNvSpPr txBox="1"/>
                <p:nvPr/>
              </p:nvSpPr>
              <p:spPr>
                <a:xfrm>
                  <a:off x="2391420" y="4383022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1D8B1BF2-DDF3-4E7F-A1D9-02A32B4F8570}"/>
                    </a:ext>
                  </a:extLst>
                </p:cNvPr>
                <p:cNvSpPr txBox="1"/>
                <p:nvPr/>
              </p:nvSpPr>
              <p:spPr>
                <a:xfrm>
                  <a:off x="2259497" y="2938004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MAr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CEBBD82B-6A69-4099-BC02-0D1617055CB7}"/>
                    </a:ext>
                  </a:extLst>
                </p:cNvPr>
                <p:cNvSpPr txBox="1"/>
                <p:nvPr/>
              </p:nvSpPr>
              <p:spPr>
                <a:xfrm rot="16200000">
                  <a:off x="1664830" y="3571787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2</a:t>
                  </a:r>
                </a:p>
              </p:txBody>
            </p:sp>
            <p:graphicFrame>
              <p:nvGraphicFramePr>
                <p:cNvPr id="53" name="Object 52">
                  <a:extLst>
                    <a:ext uri="{FF2B5EF4-FFF2-40B4-BE49-F238E27FC236}">
                      <a16:creationId xmlns:a16="http://schemas.microsoft.com/office/drawing/2014/main" id="{3FD5689E-9023-4A88-893C-9844AD9D5D2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697104909"/>
                    </p:ext>
                  </p:extLst>
                </p:nvPr>
              </p:nvGraphicFramePr>
              <p:xfrm>
                <a:off x="1919369" y="3125895"/>
                <a:ext cx="1019905" cy="1368514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12" imgW="1699841" imgH="2280856" progId="Prism8.Document">
                        <p:embed/>
                      </p:oleObj>
                    </mc:Choice>
                    <mc:Fallback>
                      <p:oleObj name="Prism 8" r:id="rId12" imgW="1699841" imgH="2280856" progId="Prism8.Document">
                        <p:embed/>
                        <p:pic>
                          <p:nvPicPr>
                            <p:cNvPr id="53" name="Object 52">
                              <a:extLst>
                                <a:ext uri="{FF2B5EF4-FFF2-40B4-BE49-F238E27FC236}">
                                  <a16:creationId xmlns:a16="http://schemas.microsoft.com/office/drawing/2014/main" id="{3FD5689E-9023-4A88-893C-9844AD9D5D2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919369" y="3125895"/>
                              <a:ext cx="1019905" cy="1368514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91" name="Group 90">
                <a:extLst>
                  <a:ext uri="{FF2B5EF4-FFF2-40B4-BE49-F238E27FC236}">
                    <a16:creationId xmlns:a16="http://schemas.microsoft.com/office/drawing/2014/main" id="{51B42B44-3F3A-EEB3-200C-D9FBBC96CF21}"/>
                  </a:ext>
                </a:extLst>
              </p:cNvPr>
              <p:cNvGrpSpPr/>
              <p:nvPr/>
            </p:nvGrpSpPr>
            <p:grpSpPr>
              <a:xfrm>
                <a:off x="3388304" y="2920058"/>
                <a:ext cx="1194598" cy="1677179"/>
                <a:chOff x="2916357" y="2920058"/>
                <a:chExt cx="1194598" cy="1677179"/>
              </a:xfrm>
            </p:grpSpPr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CF745E84-3917-4C46-9323-F13C7E0FC002}"/>
                    </a:ext>
                  </a:extLst>
                </p:cNvPr>
                <p:cNvSpPr txBox="1"/>
                <p:nvPr/>
              </p:nvSpPr>
              <p:spPr>
                <a:xfrm>
                  <a:off x="3319985" y="4381922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WT</a:t>
                  </a:r>
                  <a:endParaRPr lang="en-US" sz="799" baseline="30000" dirty="0"/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F4D7A8DB-F866-42B4-927A-8E6011103BCA}"/>
                    </a:ext>
                  </a:extLst>
                </p:cNvPr>
                <p:cNvSpPr txBox="1"/>
                <p:nvPr/>
              </p:nvSpPr>
              <p:spPr>
                <a:xfrm>
                  <a:off x="3551709" y="4379310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A36565CD-09E1-42C9-B1A2-D55A6E9E3312}"/>
                    </a:ext>
                  </a:extLst>
                </p:cNvPr>
                <p:cNvSpPr txBox="1"/>
                <p:nvPr/>
              </p:nvSpPr>
              <p:spPr>
                <a:xfrm>
                  <a:off x="3414294" y="2920058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CtTh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DAB89196-8366-414D-9AF2-52A0AA9A197C}"/>
                    </a:ext>
                  </a:extLst>
                </p:cNvPr>
                <p:cNvSpPr txBox="1"/>
                <p:nvPr/>
              </p:nvSpPr>
              <p:spPr>
                <a:xfrm rot="16200000">
                  <a:off x="2790563" y="3571787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endParaRPr lang="en-US" sz="799" baseline="30000" dirty="0"/>
                </a:p>
              </p:txBody>
            </p:sp>
            <p:graphicFrame>
              <p:nvGraphicFramePr>
                <p:cNvPr id="54" name="Object 53">
                  <a:extLst>
                    <a:ext uri="{FF2B5EF4-FFF2-40B4-BE49-F238E27FC236}">
                      <a16:creationId xmlns:a16="http://schemas.microsoft.com/office/drawing/2014/main" id="{2C3DFBAA-497B-4C6E-ADB3-057E255D106D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800165756"/>
                    </p:ext>
                  </p:extLst>
                </p:nvPr>
              </p:nvGraphicFramePr>
              <p:xfrm>
                <a:off x="3047186" y="3125895"/>
                <a:ext cx="1063769" cy="1368514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14" imgW="1772948" imgH="2280856" progId="Prism8.Document">
                        <p:embed/>
                      </p:oleObj>
                    </mc:Choice>
                    <mc:Fallback>
                      <p:oleObj name="Prism 8" r:id="rId14" imgW="1772948" imgH="2280856" progId="Prism8.Document">
                        <p:embed/>
                        <p:pic>
                          <p:nvPicPr>
                            <p:cNvPr id="54" name="Object 53">
                              <a:extLst>
                                <a:ext uri="{FF2B5EF4-FFF2-40B4-BE49-F238E27FC236}">
                                  <a16:creationId xmlns:a16="http://schemas.microsoft.com/office/drawing/2014/main" id="{2C3DFBAA-497B-4C6E-ADB3-057E255D106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047186" y="3125895"/>
                              <a:ext cx="1063769" cy="1368514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92" name="Group 91">
                <a:extLst>
                  <a:ext uri="{FF2B5EF4-FFF2-40B4-BE49-F238E27FC236}">
                    <a16:creationId xmlns:a16="http://schemas.microsoft.com/office/drawing/2014/main" id="{B23A04AF-FCA0-6E59-3DB6-C83B83A7957B}"/>
                  </a:ext>
                </a:extLst>
              </p:cNvPr>
              <p:cNvGrpSpPr/>
              <p:nvPr/>
            </p:nvGrpSpPr>
            <p:grpSpPr>
              <a:xfrm>
                <a:off x="1462108" y="2934465"/>
                <a:ext cx="1163617" cy="1668986"/>
                <a:chOff x="4131564" y="2934465"/>
                <a:chExt cx="1163617" cy="1668986"/>
              </a:xfrm>
            </p:grpSpPr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58B9ACF4-F517-4928-927A-EF04F0A2AFF1}"/>
                    </a:ext>
                  </a:extLst>
                </p:cNvPr>
                <p:cNvSpPr txBox="1"/>
                <p:nvPr/>
              </p:nvSpPr>
              <p:spPr>
                <a:xfrm>
                  <a:off x="4514735" y="4388136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17EA7AB3-2C50-41C4-A382-715AF7F59531}"/>
                    </a:ext>
                  </a:extLst>
                </p:cNvPr>
                <p:cNvSpPr txBox="1"/>
                <p:nvPr/>
              </p:nvSpPr>
              <p:spPr>
                <a:xfrm>
                  <a:off x="4746459" y="4385524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4FDD209A-2103-4ACB-8E2B-473ED7F9A1D7}"/>
                    </a:ext>
                  </a:extLst>
                </p:cNvPr>
                <p:cNvSpPr txBox="1"/>
                <p:nvPr/>
              </p:nvSpPr>
              <p:spPr>
                <a:xfrm>
                  <a:off x="4619541" y="2934465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BAr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BDD3433F-36D4-4522-9CDC-3768635852B6}"/>
                    </a:ext>
                  </a:extLst>
                </p:cNvPr>
                <p:cNvSpPr txBox="1"/>
                <p:nvPr/>
              </p:nvSpPr>
              <p:spPr>
                <a:xfrm rot="16200000">
                  <a:off x="4005770" y="3571787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2</a:t>
                  </a:r>
                </a:p>
              </p:txBody>
            </p:sp>
            <p:graphicFrame>
              <p:nvGraphicFramePr>
                <p:cNvPr id="55" name="Object 54">
                  <a:extLst>
                    <a:ext uri="{FF2B5EF4-FFF2-40B4-BE49-F238E27FC236}">
                      <a16:creationId xmlns:a16="http://schemas.microsoft.com/office/drawing/2014/main" id="{6AB52FFC-EE46-4666-B5E3-4BB28EAE0A2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21340861"/>
                    </p:ext>
                  </p:extLst>
                </p:nvPr>
              </p:nvGraphicFramePr>
              <p:xfrm>
                <a:off x="4269656" y="3105150"/>
                <a:ext cx="1025525" cy="13684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6" imgW="1709204" imgH="2280856" progId="Prism9.Document">
                        <p:embed/>
                      </p:oleObj>
                    </mc:Choice>
                    <mc:Fallback>
                      <p:oleObj name="Prism 9" r:id="rId16" imgW="1709204" imgH="2280856" progId="Prism9.Document">
                        <p:embed/>
                        <p:pic>
                          <p:nvPicPr>
                            <p:cNvPr id="55" name="Object 54">
                              <a:extLst>
                                <a:ext uri="{FF2B5EF4-FFF2-40B4-BE49-F238E27FC236}">
                                  <a16:creationId xmlns:a16="http://schemas.microsoft.com/office/drawing/2014/main" id="{6AB52FFC-EE46-4666-B5E3-4BB28EAE0A2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269656" y="3105150"/>
                              <a:ext cx="1025525" cy="13684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93" name="Group 92">
                <a:extLst>
                  <a:ext uri="{FF2B5EF4-FFF2-40B4-BE49-F238E27FC236}">
                    <a16:creationId xmlns:a16="http://schemas.microsoft.com/office/drawing/2014/main" id="{C1244BA5-922A-8E77-CA4C-C67C449B039F}"/>
                  </a:ext>
                </a:extLst>
              </p:cNvPr>
              <p:cNvGrpSpPr/>
              <p:nvPr/>
            </p:nvGrpSpPr>
            <p:grpSpPr>
              <a:xfrm>
                <a:off x="5554987" y="2934465"/>
                <a:ext cx="1178547" cy="1661345"/>
                <a:chOff x="5252645" y="2934465"/>
                <a:chExt cx="1178547" cy="1661345"/>
              </a:xfrm>
            </p:grpSpPr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B775BAD1-B39E-4F9D-B7D2-E83B9E0304A3}"/>
                    </a:ext>
                  </a:extLst>
                </p:cNvPr>
                <p:cNvSpPr txBox="1"/>
                <p:nvPr/>
              </p:nvSpPr>
              <p:spPr>
                <a:xfrm>
                  <a:off x="5804576" y="2934465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BMD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29D15D55-C04F-41D3-85CB-475FA3EA9990}"/>
                    </a:ext>
                  </a:extLst>
                </p:cNvPr>
                <p:cNvSpPr txBox="1"/>
                <p:nvPr/>
              </p:nvSpPr>
              <p:spPr>
                <a:xfrm>
                  <a:off x="5664125" y="4380495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0A0956C7-6A52-49FF-A4E1-9037D28D97CA}"/>
                    </a:ext>
                  </a:extLst>
                </p:cNvPr>
                <p:cNvSpPr txBox="1"/>
                <p:nvPr/>
              </p:nvSpPr>
              <p:spPr>
                <a:xfrm>
                  <a:off x="5895849" y="4377883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C40AC011-3F60-483C-9983-53258A2E293A}"/>
                    </a:ext>
                  </a:extLst>
                </p:cNvPr>
                <p:cNvSpPr txBox="1"/>
                <p:nvPr/>
              </p:nvSpPr>
              <p:spPr>
                <a:xfrm rot="16200000">
                  <a:off x="5025755" y="3605565"/>
                  <a:ext cx="669096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g HA/ccm</a:t>
                  </a:r>
                  <a:endParaRPr lang="en-US" sz="799" baseline="30000" dirty="0"/>
                </a:p>
              </p:txBody>
            </p:sp>
            <p:graphicFrame>
              <p:nvGraphicFramePr>
                <p:cNvPr id="56" name="Object 55">
                  <a:extLst>
                    <a:ext uri="{FF2B5EF4-FFF2-40B4-BE49-F238E27FC236}">
                      <a16:creationId xmlns:a16="http://schemas.microsoft.com/office/drawing/2014/main" id="{62C905E3-AF3B-49A6-B5A1-7E59EB2E6A7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390137423"/>
                    </p:ext>
                  </p:extLst>
                </p:nvPr>
              </p:nvGraphicFramePr>
              <p:xfrm>
                <a:off x="5389248" y="3104665"/>
                <a:ext cx="1041944" cy="1368514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18" imgW="1736574" imgH="2280856" progId="Prism8.Document">
                        <p:embed/>
                      </p:oleObj>
                    </mc:Choice>
                    <mc:Fallback>
                      <p:oleObj name="Prism 8" r:id="rId18" imgW="1736574" imgH="2280856" progId="Prism8.Document">
                        <p:embed/>
                        <p:pic>
                          <p:nvPicPr>
                            <p:cNvPr id="56" name="Object 55">
                              <a:extLst>
                                <a:ext uri="{FF2B5EF4-FFF2-40B4-BE49-F238E27FC236}">
                                  <a16:creationId xmlns:a16="http://schemas.microsoft.com/office/drawing/2014/main" id="{62C905E3-AF3B-49A6-B5A1-7E59EB2E6A7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389248" y="3104665"/>
                              <a:ext cx="1041944" cy="1368514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aphicFrame>
            <p:nvGraphicFramePr>
              <p:cNvPr id="58" name="Object 57">
                <a:extLst>
                  <a:ext uri="{FF2B5EF4-FFF2-40B4-BE49-F238E27FC236}">
                    <a16:creationId xmlns:a16="http://schemas.microsoft.com/office/drawing/2014/main" id="{EE5FE0F4-1915-4CF4-A7A4-72CFC3A7D30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011531198"/>
                  </p:ext>
                </p:extLst>
              </p:nvPr>
            </p:nvGraphicFramePr>
            <p:xfrm>
              <a:off x="4157018" y="5032532"/>
              <a:ext cx="1036637" cy="13731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0" imgW="1727211" imgH="2289859" progId="Prism8.Document">
                      <p:embed/>
                    </p:oleObj>
                  </mc:Choice>
                  <mc:Fallback>
                    <p:oleObj name="Prism 8" r:id="rId20" imgW="1727211" imgH="2289859" progId="Prism8.Document">
                      <p:embed/>
                      <p:pic>
                        <p:nvPicPr>
                          <p:cNvPr id="58" name="Object 57">
                            <a:extLst>
                              <a:ext uri="{FF2B5EF4-FFF2-40B4-BE49-F238E27FC236}">
                                <a16:creationId xmlns:a16="http://schemas.microsoft.com/office/drawing/2014/main" id="{EE5FE0F4-1915-4CF4-A7A4-72CFC3A7D30A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1"/>
                          <a:stretch>
                            <a:fillRect/>
                          </a:stretch>
                        </p:blipFill>
                        <p:spPr>
                          <a:xfrm>
                            <a:off x="4157018" y="5032532"/>
                            <a:ext cx="1036637" cy="13731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9" name="Object 58">
                <a:extLst>
                  <a:ext uri="{FF2B5EF4-FFF2-40B4-BE49-F238E27FC236}">
                    <a16:creationId xmlns:a16="http://schemas.microsoft.com/office/drawing/2014/main" id="{BDC345D6-C96A-4C58-8DD6-DE40A55379B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69022980"/>
                  </p:ext>
                </p:extLst>
              </p:nvPr>
            </p:nvGraphicFramePr>
            <p:xfrm>
              <a:off x="2731443" y="5011892"/>
              <a:ext cx="1385887" cy="16573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2" imgW="2312792" imgH="2762742" progId="Prism8.Document">
                      <p:embed/>
                    </p:oleObj>
                  </mc:Choice>
                  <mc:Fallback>
                    <p:oleObj name="Prism 8" r:id="rId22" imgW="2312792" imgH="2762742" progId="Prism8.Document">
                      <p:embed/>
                      <p:pic>
                        <p:nvPicPr>
                          <p:cNvPr id="59" name="Object 58">
                            <a:extLst>
                              <a:ext uri="{FF2B5EF4-FFF2-40B4-BE49-F238E27FC236}">
                                <a16:creationId xmlns:a16="http://schemas.microsoft.com/office/drawing/2014/main" id="{BDC345D6-C96A-4C58-8DD6-DE40A55379B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3"/>
                          <a:stretch>
                            <a:fillRect/>
                          </a:stretch>
                        </p:blipFill>
                        <p:spPr>
                          <a:xfrm>
                            <a:off x="2731443" y="5011892"/>
                            <a:ext cx="1385887" cy="16573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0" name="Object 59">
                <a:extLst>
                  <a:ext uri="{FF2B5EF4-FFF2-40B4-BE49-F238E27FC236}">
                    <a16:creationId xmlns:a16="http://schemas.microsoft.com/office/drawing/2014/main" id="{3B5A70AE-99A7-46C6-AF56-8277D3D217F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58666620"/>
                  </p:ext>
                </p:extLst>
              </p:nvPr>
            </p:nvGraphicFramePr>
            <p:xfrm>
              <a:off x="1336677" y="5012204"/>
              <a:ext cx="1387475" cy="16573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4" imgW="2312792" imgH="2762742" progId="Prism8.Document">
                      <p:embed/>
                    </p:oleObj>
                  </mc:Choice>
                  <mc:Fallback>
                    <p:oleObj name="Prism 8" r:id="rId24" imgW="2312792" imgH="2762742" progId="Prism8.Document">
                      <p:embed/>
                      <p:pic>
                        <p:nvPicPr>
                          <p:cNvPr id="60" name="Object 59">
                            <a:extLst>
                              <a:ext uri="{FF2B5EF4-FFF2-40B4-BE49-F238E27FC236}">
                                <a16:creationId xmlns:a16="http://schemas.microsoft.com/office/drawing/2014/main" id="{3B5A70AE-99A7-46C6-AF56-8277D3D217F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5"/>
                          <a:stretch>
                            <a:fillRect/>
                          </a:stretch>
                        </p:blipFill>
                        <p:spPr>
                          <a:xfrm>
                            <a:off x="1336677" y="5012204"/>
                            <a:ext cx="1387475" cy="16573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A6451957-5E28-4AA7-8A09-A618C7ED18BD}"/>
                  </a:ext>
                </a:extLst>
              </p:cNvPr>
              <p:cNvSpPr txBox="1"/>
              <p:nvPr/>
            </p:nvSpPr>
            <p:spPr>
              <a:xfrm>
                <a:off x="1367655" y="4810932"/>
                <a:ext cx="13559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80F938B9-E386-48B4-B7F5-6BBC97748AAF}"/>
                  </a:ext>
                </a:extLst>
              </p:cNvPr>
              <p:cNvSpPr txBox="1"/>
              <p:nvPr/>
            </p:nvSpPr>
            <p:spPr>
              <a:xfrm>
                <a:off x="1665115" y="4836357"/>
                <a:ext cx="12247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FV Proximal tibia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4ECCC361-7536-4E65-AFB6-38B5F4248199}"/>
                  </a:ext>
                </a:extLst>
              </p:cNvPr>
              <p:cNvSpPr txBox="1"/>
              <p:nvPr/>
            </p:nvSpPr>
            <p:spPr>
              <a:xfrm rot="16200000">
                <a:off x="1218098" y="5504004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mm</a:t>
                </a:r>
                <a:r>
                  <a:rPr lang="en-US" sz="799" baseline="30000" dirty="0"/>
                  <a:t>3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D5BC1F1-23F1-4869-9147-DCDA54AC2049}"/>
                  </a:ext>
                </a:extLst>
              </p:cNvPr>
              <p:cNvSpPr txBox="1"/>
              <p:nvPr/>
            </p:nvSpPr>
            <p:spPr>
              <a:xfrm>
                <a:off x="1753866" y="6298452"/>
                <a:ext cx="38308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WT</a:t>
                </a:r>
                <a:endParaRPr lang="en-US" sz="799" baseline="30000" dirty="0"/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B02D6176-A94A-4FFB-9214-C5F7BED1DDEA}"/>
                  </a:ext>
                </a:extLst>
              </p:cNvPr>
              <p:cNvSpPr txBox="1"/>
              <p:nvPr/>
            </p:nvSpPr>
            <p:spPr>
              <a:xfrm>
                <a:off x="1985590" y="6295840"/>
                <a:ext cx="518348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⍺OT</a:t>
                </a:r>
                <a:r>
                  <a:rPr lang="en-US" sz="799" baseline="30000" dirty="0"/>
                  <a:t>KO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0AB7C6AD-6D4C-43C9-9DF4-3E3F73A273E2}"/>
                  </a:ext>
                </a:extLst>
              </p:cNvPr>
              <p:cNvSpPr txBox="1"/>
              <p:nvPr/>
            </p:nvSpPr>
            <p:spPr>
              <a:xfrm>
                <a:off x="2997736" y="4831930"/>
                <a:ext cx="12247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FV Distal tibia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34D621D3-87B1-49C4-B667-0C37061D91F7}"/>
                  </a:ext>
                </a:extLst>
              </p:cNvPr>
              <p:cNvSpPr txBox="1"/>
              <p:nvPr/>
            </p:nvSpPr>
            <p:spPr>
              <a:xfrm rot="16200000">
                <a:off x="2584172" y="5499577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mm</a:t>
                </a:r>
                <a:r>
                  <a:rPr lang="en-US" sz="799" baseline="30000" dirty="0"/>
                  <a:t>3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8382B957-1B81-49FE-B7EF-31AB77831E73}"/>
                  </a:ext>
                </a:extLst>
              </p:cNvPr>
              <p:cNvSpPr txBox="1"/>
              <p:nvPr/>
            </p:nvSpPr>
            <p:spPr>
              <a:xfrm>
                <a:off x="3086487" y="6294025"/>
                <a:ext cx="38308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WT</a:t>
                </a:r>
                <a:endParaRPr lang="en-US" sz="799" baseline="30000" dirty="0"/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1B9C6B53-D3A2-424A-BCAC-2E5AAB63C09E}"/>
                  </a:ext>
                </a:extLst>
              </p:cNvPr>
              <p:cNvSpPr txBox="1"/>
              <p:nvPr/>
            </p:nvSpPr>
            <p:spPr>
              <a:xfrm>
                <a:off x="3318211" y="6291413"/>
                <a:ext cx="518348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⍺OT</a:t>
                </a:r>
                <a:r>
                  <a:rPr lang="en-US" sz="799" baseline="30000" dirty="0"/>
                  <a:t>KO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CBA51EF9-AFD9-4060-A327-6A19D1041E0C}"/>
                  </a:ext>
                </a:extLst>
              </p:cNvPr>
              <p:cNvSpPr txBox="1"/>
              <p:nvPr/>
            </p:nvSpPr>
            <p:spPr>
              <a:xfrm>
                <a:off x="4338642" y="4831469"/>
                <a:ext cx="12247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FV Entire tibia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00B301FF-FB25-4A1C-B830-3B8E6C0E5239}"/>
                  </a:ext>
                </a:extLst>
              </p:cNvPr>
              <p:cNvSpPr txBox="1"/>
              <p:nvPr/>
            </p:nvSpPr>
            <p:spPr>
              <a:xfrm rot="16200000">
                <a:off x="3891625" y="5499116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mm</a:t>
                </a:r>
                <a:r>
                  <a:rPr lang="en-US" sz="799" baseline="30000" dirty="0"/>
                  <a:t>3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608DEE7F-A9A0-41EE-A878-5D7CF2905D29}"/>
                  </a:ext>
                </a:extLst>
              </p:cNvPr>
              <p:cNvSpPr txBox="1"/>
              <p:nvPr/>
            </p:nvSpPr>
            <p:spPr>
              <a:xfrm>
                <a:off x="4427393" y="6293564"/>
                <a:ext cx="38308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WT</a:t>
                </a:r>
                <a:endParaRPr lang="en-US" sz="799" baseline="30000" dirty="0"/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7EE49295-EF51-41A8-9434-C6538E11C05F}"/>
                  </a:ext>
                </a:extLst>
              </p:cNvPr>
              <p:cNvSpPr txBox="1"/>
              <p:nvPr/>
            </p:nvSpPr>
            <p:spPr>
              <a:xfrm>
                <a:off x="4659117" y="6290952"/>
                <a:ext cx="518348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⍺OT</a:t>
                </a:r>
                <a:r>
                  <a:rPr lang="en-US" sz="799" baseline="30000" dirty="0"/>
                  <a:t>KO</a:t>
                </a:r>
              </a:p>
            </p:txBody>
          </p:sp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A6321835-9C3D-6A6C-608B-DA98C9A2DDEC}"/>
                  </a:ext>
                </a:extLst>
              </p:cNvPr>
              <p:cNvGrpSpPr/>
              <p:nvPr/>
            </p:nvGrpSpPr>
            <p:grpSpPr>
              <a:xfrm>
                <a:off x="2955733" y="1201485"/>
                <a:ext cx="1115297" cy="1681739"/>
                <a:chOff x="2955733" y="1179363"/>
                <a:chExt cx="1115297" cy="1681739"/>
              </a:xfrm>
            </p:grpSpPr>
            <p:graphicFrame>
              <p:nvGraphicFramePr>
                <p:cNvPr id="42" name="Object 41">
                  <a:extLst>
                    <a:ext uri="{FF2B5EF4-FFF2-40B4-BE49-F238E27FC236}">
                      <a16:creationId xmlns:a16="http://schemas.microsoft.com/office/drawing/2014/main" id="{808BC3E8-BB42-9A71-84E4-221A21407AB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190835026"/>
                    </p:ext>
                  </p:extLst>
                </p:nvPr>
              </p:nvGraphicFramePr>
              <p:xfrm>
                <a:off x="2955733" y="1357705"/>
                <a:ext cx="1087198" cy="1371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26" imgW="1814364" imgH="2289859" progId="Prism9.Document">
                        <p:embed/>
                      </p:oleObj>
                    </mc:Choice>
                    <mc:Fallback>
                      <p:oleObj name="Prism 9" r:id="rId26" imgW="1814364" imgH="2289859" progId="Prism9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55733" y="1357705"/>
                              <a:ext cx="1087198" cy="1371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45" name="Group 44">
                  <a:extLst>
                    <a:ext uri="{FF2B5EF4-FFF2-40B4-BE49-F238E27FC236}">
                      <a16:creationId xmlns:a16="http://schemas.microsoft.com/office/drawing/2014/main" id="{D3C2C27D-3F0B-6968-9FEB-60D6C0FF5951}"/>
                    </a:ext>
                  </a:extLst>
                </p:cNvPr>
                <p:cNvGrpSpPr/>
                <p:nvPr/>
              </p:nvGrpSpPr>
              <p:grpSpPr>
                <a:xfrm>
                  <a:off x="3301908" y="2643175"/>
                  <a:ext cx="769122" cy="217927"/>
                  <a:chOff x="1155932" y="2629020"/>
                  <a:chExt cx="769122" cy="217927"/>
                </a:xfrm>
              </p:grpSpPr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7FD794B9-6E50-8AC4-C80B-0AF5C6966AFA}"/>
                      </a:ext>
                    </a:extLst>
                  </p:cNvPr>
                  <p:cNvSpPr txBox="1"/>
                  <p:nvPr/>
                </p:nvSpPr>
                <p:spPr>
                  <a:xfrm>
                    <a:off x="1155932" y="2631632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Ctrl</a:t>
                    </a:r>
                    <a:endParaRPr lang="en-US" sz="799" baseline="30000" dirty="0"/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6B00BE40-4AE5-2F46-D4E7-D78A3C872E0F}"/>
                      </a:ext>
                    </a:extLst>
                  </p:cNvPr>
                  <p:cNvSpPr txBox="1"/>
                  <p:nvPr/>
                </p:nvSpPr>
                <p:spPr>
                  <a:xfrm>
                    <a:off x="1406706" y="2629020"/>
                    <a:ext cx="518348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OT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</p:grp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5FD4D70D-4FD5-FA21-AA1E-1B767286E3D0}"/>
                    </a:ext>
                  </a:extLst>
                </p:cNvPr>
                <p:cNvSpPr txBox="1"/>
                <p:nvPr/>
              </p:nvSpPr>
              <p:spPr>
                <a:xfrm>
                  <a:off x="3379858" y="1179363"/>
                  <a:ext cx="59671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BV/TV</a:t>
                  </a:r>
                </a:p>
              </p:txBody>
            </p:sp>
          </p:grpSp>
          <p:grpSp>
            <p:nvGrpSpPr>
              <p:cNvPr id="96" name="Group 95">
                <a:extLst>
                  <a:ext uri="{FF2B5EF4-FFF2-40B4-BE49-F238E27FC236}">
                    <a16:creationId xmlns:a16="http://schemas.microsoft.com/office/drawing/2014/main" id="{C3D81AFD-8A27-45B3-144C-D1450ED2485B}"/>
                  </a:ext>
                </a:extLst>
              </p:cNvPr>
              <p:cNvGrpSpPr/>
              <p:nvPr/>
            </p:nvGrpSpPr>
            <p:grpSpPr>
              <a:xfrm>
                <a:off x="2526927" y="2924850"/>
                <a:ext cx="1069982" cy="1655560"/>
                <a:chOff x="2526927" y="2924850"/>
                <a:chExt cx="1069982" cy="1655560"/>
              </a:xfrm>
            </p:grpSpPr>
            <p:grpSp>
              <p:nvGrpSpPr>
                <p:cNvPr id="84" name="Group 83">
                  <a:extLst>
                    <a:ext uri="{FF2B5EF4-FFF2-40B4-BE49-F238E27FC236}">
                      <a16:creationId xmlns:a16="http://schemas.microsoft.com/office/drawing/2014/main" id="{E30D716F-BE40-6BDC-01BE-8342EF721518}"/>
                    </a:ext>
                  </a:extLst>
                </p:cNvPr>
                <p:cNvGrpSpPr/>
                <p:nvPr/>
              </p:nvGrpSpPr>
              <p:grpSpPr>
                <a:xfrm>
                  <a:off x="2846837" y="4362483"/>
                  <a:ext cx="750072" cy="217927"/>
                  <a:chOff x="932574" y="4383022"/>
                  <a:chExt cx="750072" cy="217927"/>
                </a:xfrm>
              </p:grpSpPr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990500F0-B537-CA8D-55F0-6FAABB9FE5F5}"/>
                      </a:ext>
                    </a:extLst>
                  </p:cNvPr>
                  <p:cNvSpPr txBox="1"/>
                  <p:nvPr/>
                </p:nvSpPr>
                <p:spPr>
                  <a:xfrm>
                    <a:off x="932574" y="4385634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Ctrl</a:t>
                    </a:r>
                    <a:endParaRPr lang="en-US" sz="799" baseline="30000" dirty="0"/>
                  </a:p>
                </p:txBody>
              </p: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00ED51CC-3EC5-340F-FEDC-5095C208B5E0}"/>
                      </a:ext>
                    </a:extLst>
                  </p:cNvPr>
                  <p:cNvSpPr txBox="1"/>
                  <p:nvPr/>
                </p:nvSpPr>
                <p:spPr>
                  <a:xfrm>
                    <a:off x="1164298" y="4383022"/>
                    <a:ext cx="518348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OT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</p:grpSp>
            <p:graphicFrame>
              <p:nvGraphicFramePr>
                <p:cNvPr id="94" name="Object 93">
                  <a:extLst>
                    <a:ext uri="{FF2B5EF4-FFF2-40B4-BE49-F238E27FC236}">
                      <a16:creationId xmlns:a16="http://schemas.microsoft.com/office/drawing/2014/main" id="{8C96CB40-23CD-8951-8725-2AAA4E062EA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398308885"/>
                    </p:ext>
                  </p:extLst>
                </p:nvPr>
              </p:nvGraphicFramePr>
              <p:xfrm>
                <a:off x="2526927" y="3117801"/>
                <a:ext cx="1035834" cy="1371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28" imgW="1729012" imgH="2289859" progId="Prism9.Document">
                        <p:embed/>
                      </p:oleObj>
                    </mc:Choice>
                    <mc:Fallback>
                      <p:oleObj name="Prism 9" r:id="rId28" imgW="1729012" imgH="2289859" progId="Prism9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526927" y="3117801"/>
                              <a:ext cx="1035834" cy="1371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3C2D3F45-FADD-6C20-F6A6-8D71F73F810F}"/>
                    </a:ext>
                  </a:extLst>
                </p:cNvPr>
                <p:cNvSpPr txBox="1"/>
                <p:nvPr/>
              </p:nvSpPr>
              <p:spPr>
                <a:xfrm>
                  <a:off x="2896946" y="2924850"/>
                  <a:ext cx="62218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Bar/</a:t>
                  </a:r>
                  <a:r>
                    <a:rPr lang="en-US" sz="1000" dirty="0" err="1"/>
                    <a:t>TAr</a:t>
                  </a:r>
                  <a:endParaRPr lang="en-US" sz="1000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7401219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Group 81">
            <a:extLst>
              <a:ext uri="{FF2B5EF4-FFF2-40B4-BE49-F238E27FC236}">
                <a16:creationId xmlns:a16="http://schemas.microsoft.com/office/drawing/2014/main" id="{7C9C1F90-4F7F-A18F-9871-ABFF0BB02C18}"/>
              </a:ext>
            </a:extLst>
          </p:cNvPr>
          <p:cNvGrpSpPr/>
          <p:nvPr/>
        </p:nvGrpSpPr>
        <p:grpSpPr>
          <a:xfrm>
            <a:off x="5457108" y="2856784"/>
            <a:ext cx="1209371" cy="1594795"/>
            <a:chOff x="4881922" y="2849410"/>
            <a:chExt cx="1209371" cy="1594795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BF728388-7358-42FC-8D88-A8B8B368C74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04504782"/>
                </p:ext>
              </p:extLst>
            </p:nvPr>
          </p:nvGraphicFramePr>
          <p:xfrm>
            <a:off x="5009400" y="2959770"/>
            <a:ext cx="1057275" cy="1374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1763945" imgH="2289859" progId="Prism8.Document">
                    <p:embed/>
                  </p:oleObj>
                </mc:Choice>
                <mc:Fallback>
                  <p:oleObj name="Prism 8" r:id="rId2" imgW="1763945" imgH="2289859" progId="Prism8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BF728388-7358-42FC-8D88-A8B8B368C74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5009400" y="2959770"/>
                          <a:ext cx="1057275" cy="1374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E549BD3-AA7A-4F71-B2B4-569CADA137B1}"/>
                </a:ext>
              </a:extLst>
            </p:cNvPr>
            <p:cNvSpPr txBox="1"/>
            <p:nvPr/>
          </p:nvSpPr>
          <p:spPr>
            <a:xfrm>
              <a:off x="5624390" y="2849410"/>
              <a:ext cx="466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BMD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4CEF96F-8A23-4478-8F9C-98B078390F6E}"/>
                </a:ext>
              </a:extLst>
            </p:cNvPr>
            <p:cNvSpPr txBox="1"/>
            <p:nvPr/>
          </p:nvSpPr>
          <p:spPr>
            <a:xfrm rot="16200000">
              <a:off x="4655032" y="3587345"/>
              <a:ext cx="669096" cy="215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9" dirty="0"/>
                <a:t>mg HA/ccm</a:t>
              </a:r>
              <a:endParaRPr lang="en-US" sz="799" baseline="30000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9AA73A5-C9D2-4BB0-A0FF-B7A3546399DD}"/>
                </a:ext>
              </a:extLst>
            </p:cNvPr>
            <p:cNvSpPr txBox="1"/>
            <p:nvPr/>
          </p:nvSpPr>
          <p:spPr>
            <a:xfrm>
              <a:off x="5307630" y="4223140"/>
              <a:ext cx="383082" cy="215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9" dirty="0"/>
                <a:t>WT</a:t>
              </a:r>
              <a:endParaRPr lang="en-US" sz="799" baseline="30000" dirty="0"/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D9D8E35-63E6-4CC8-8A64-F0DE16B72579}"/>
                </a:ext>
              </a:extLst>
            </p:cNvPr>
            <p:cNvSpPr txBox="1"/>
            <p:nvPr/>
          </p:nvSpPr>
          <p:spPr>
            <a:xfrm>
              <a:off x="5646570" y="4228890"/>
              <a:ext cx="356112" cy="215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9" dirty="0"/>
                <a:t>⍺</a:t>
              </a:r>
              <a:r>
                <a:rPr lang="en-US" sz="799" baseline="30000" dirty="0"/>
                <a:t>KO</a:t>
              </a:r>
            </a:p>
          </p:txBody>
        </p:sp>
      </p:grpSp>
      <p:grpSp>
        <p:nvGrpSpPr>
          <p:cNvPr id="98" name="Group 97">
            <a:extLst>
              <a:ext uri="{FF2B5EF4-FFF2-40B4-BE49-F238E27FC236}">
                <a16:creationId xmlns:a16="http://schemas.microsoft.com/office/drawing/2014/main" id="{DB06CC3C-2599-0C15-E6CD-E56A249AC798}"/>
              </a:ext>
            </a:extLst>
          </p:cNvPr>
          <p:cNvGrpSpPr/>
          <p:nvPr/>
        </p:nvGrpSpPr>
        <p:grpSpPr>
          <a:xfrm>
            <a:off x="158264" y="803041"/>
            <a:ext cx="6383710" cy="7691806"/>
            <a:chOff x="158264" y="803041"/>
            <a:chExt cx="6383710" cy="7691806"/>
          </a:xfrm>
        </p:grpSpPr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16FBEDAD-7251-B044-9102-C1A334BFB576}"/>
                </a:ext>
              </a:extLst>
            </p:cNvPr>
            <p:cNvSpPr txBox="1"/>
            <p:nvPr/>
          </p:nvSpPr>
          <p:spPr>
            <a:xfrm>
              <a:off x="397164" y="6925187"/>
              <a:ext cx="6144810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2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obal deficiency in PP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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sulted in the bone phenotype characterized by altered trabecular and cortical bone structure in 5 months old female mice.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 mCT measurements of trabecular bone in proximal tibia: total volume (TV), bone volume (BV), bone mass (BV/TV), trabecular number (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bN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and trabecular thickness (TbTh). B. mCT measurements of cortical bone in midshaft tibia: total cross-sectional area (T.Ar), bone area (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.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bone mass (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.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.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cortical thickness (Ct.Th.), marrow area (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.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and bone mineral density (BMD). WT n=4,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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</a:t>
              </a:r>
              <a:r>
                <a:rPr lang="en-US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=5 per group C. Fat volume (FV) in proximal or distal or entire tibia. n=4 per group * p&lt;0.05</a:t>
              </a:r>
            </a:p>
          </p:txBody>
        </p: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5FEA1112-897B-32C9-6484-4FB6B64D39D4}"/>
                </a:ext>
              </a:extLst>
            </p:cNvPr>
            <p:cNvGrpSpPr/>
            <p:nvPr/>
          </p:nvGrpSpPr>
          <p:grpSpPr>
            <a:xfrm>
              <a:off x="158264" y="803041"/>
              <a:ext cx="6264035" cy="5713439"/>
              <a:chOff x="158264" y="803041"/>
              <a:chExt cx="6264035" cy="5713439"/>
            </a:xfrm>
          </p:grpSpPr>
          <p:graphicFrame>
            <p:nvGraphicFramePr>
              <p:cNvPr id="75" name="Object 74">
                <a:extLst>
                  <a:ext uri="{FF2B5EF4-FFF2-40B4-BE49-F238E27FC236}">
                    <a16:creationId xmlns:a16="http://schemas.microsoft.com/office/drawing/2014/main" id="{ACA66AFE-4792-400A-A6BA-8C5A820459C5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365676714"/>
                  </p:ext>
                </p:extLst>
              </p:nvPr>
            </p:nvGraphicFramePr>
            <p:xfrm>
              <a:off x="3713153" y="5012702"/>
              <a:ext cx="1035050" cy="1374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4" imgW="1727211" imgH="2289859" progId="Prism8.Document">
                      <p:embed/>
                    </p:oleObj>
                  </mc:Choice>
                  <mc:Fallback>
                    <p:oleObj name="Prism 8" r:id="rId4" imgW="1727211" imgH="2289859" progId="Prism8.Document">
                      <p:embed/>
                      <p:pic>
                        <p:nvPicPr>
                          <p:cNvPr id="75" name="Object 74">
                            <a:extLst>
                              <a:ext uri="{FF2B5EF4-FFF2-40B4-BE49-F238E27FC236}">
                                <a16:creationId xmlns:a16="http://schemas.microsoft.com/office/drawing/2014/main" id="{ACA66AFE-4792-400A-A6BA-8C5A820459C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713153" y="5012702"/>
                            <a:ext cx="1035050" cy="13747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74" name="Object 73">
                <a:extLst>
                  <a:ext uri="{FF2B5EF4-FFF2-40B4-BE49-F238E27FC236}">
                    <a16:creationId xmlns:a16="http://schemas.microsoft.com/office/drawing/2014/main" id="{50235231-7E8F-4C51-8CA1-51C64C6AAAB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816555122"/>
                  </p:ext>
                </p:extLst>
              </p:nvPr>
            </p:nvGraphicFramePr>
            <p:xfrm>
              <a:off x="2527374" y="5027791"/>
              <a:ext cx="1035050" cy="1374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6" imgW="1727211" imgH="2289859" progId="Prism8.Document">
                      <p:embed/>
                    </p:oleObj>
                  </mc:Choice>
                  <mc:Fallback>
                    <p:oleObj name="Prism 8" r:id="rId6" imgW="1727211" imgH="2289859" progId="Prism8.Document">
                      <p:embed/>
                      <p:pic>
                        <p:nvPicPr>
                          <p:cNvPr id="74" name="Object 73">
                            <a:extLst>
                              <a:ext uri="{FF2B5EF4-FFF2-40B4-BE49-F238E27FC236}">
                                <a16:creationId xmlns:a16="http://schemas.microsoft.com/office/drawing/2014/main" id="{50235231-7E8F-4C51-8CA1-51C64C6AAAB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2527374" y="5027791"/>
                            <a:ext cx="1035050" cy="13747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8FFD5D8-3503-4861-A3ED-C534503C6C38}"/>
                  </a:ext>
                </a:extLst>
              </p:cNvPr>
              <p:cNvSpPr txBox="1"/>
              <p:nvPr/>
            </p:nvSpPr>
            <p:spPr>
              <a:xfrm>
                <a:off x="337428" y="2645601"/>
                <a:ext cx="13559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B</a:t>
                </a:r>
              </a:p>
            </p:txBody>
          </p:sp>
          <p:grpSp>
            <p:nvGrpSpPr>
              <p:cNvPr id="78" name="Group 77">
                <a:extLst>
                  <a:ext uri="{FF2B5EF4-FFF2-40B4-BE49-F238E27FC236}">
                    <a16:creationId xmlns:a16="http://schemas.microsoft.com/office/drawing/2014/main" id="{4726CEF0-A7F1-26A0-D95B-A8885637DCDC}"/>
                  </a:ext>
                </a:extLst>
              </p:cNvPr>
              <p:cNvGrpSpPr/>
              <p:nvPr/>
            </p:nvGrpSpPr>
            <p:grpSpPr>
              <a:xfrm>
                <a:off x="746410" y="1141827"/>
                <a:ext cx="1214971" cy="1567483"/>
                <a:chOff x="964135" y="1324716"/>
                <a:chExt cx="1214971" cy="1567483"/>
              </a:xfrm>
            </p:grpSpPr>
            <p:graphicFrame>
              <p:nvGraphicFramePr>
                <p:cNvPr id="43" name="Object 42">
                  <a:extLst>
                    <a:ext uri="{FF2B5EF4-FFF2-40B4-BE49-F238E27FC236}">
                      <a16:creationId xmlns:a16="http://schemas.microsoft.com/office/drawing/2014/main" id="{323F5E6D-DFA8-428D-9607-87F5B331000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915699024"/>
                    </p:ext>
                  </p:extLst>
                </p:nvPr>
              </p:nvGraphicFramePr>
              <p:xfrm>
                <a:off x="1092200" y="1404940"/>
                <a:ext cx="1036638" cy="13747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8" imgW="1727211" imgH="2289859" progId="Prism9.Document">
                        <p:embed/>
                      </p:oleObj>
                    </mc:Choice>
                    <mc:Fallback>
                      <p:oleObj name="Prism 9" r:id="rId8" imgW="1727211" imgH="2289859" progId="Prism9.Document">
                        <p:embed/>
                        <p:pic>
                          <p:nvPicPr>
                            <p:cNvPr id="43" name="Object 42">
                              <a:extLst>
                                <a:ext uri="{FF2B5EF4-FFF2-40B4-BE49-F238E27FC236}">
                                  <a16:creationId xmlns:a16="http://schemas.microsoft.com/office/drawing/2014/main" id="{323F5E6D-DFA8-428D-9607-87F5B331000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92200" y="1404940"/>
                              <a:ext cx="1036638" cy="13747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D8E7C031-0561-4795-9628-BEDC55900312}"/>
                    </a:ext>
                  </a:extLst>
                </p:cNvPr>
                <p:cNvSpPr txBox="1"/>
                <p:nvPr/>
              </p:nvSpPr>
              <p:spPr>
                <a:xfrm>
                  <a:off x="1734912" y="1564291"/>
                  <a:ext cx="44419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38C21CBD-13EE-4863-A9A8-7799F04B5425}"/>
                    </a:ext>
                  </a:extLst>
                </p:cNvPr>
                <p:cNvSpPr txBox="1"/>
                <p:nvPr/>
              </p:nvSpPr>
              <p:spPr>
                <a:xfrm>
                  <a:off x="1487540" y="1324716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TV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799405B3-7E88-49F7-97E2-3338A3538137}"/>
                    </a:ext>
                  </a:extLst>
                </p:cNvPr>
                <p:cNvSpPr txBox="1"/>
                <p:nvPr/>
              </p:nvSpPr>
              <p:spPr>
                <a:xfrm rot="16200000">
                  <a:off x="838341" y="1925518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3</a:t>
                  </a:r>
                </a:p>
              </p:txBody>
            </p:sp>
            <p:grpSp>
              <p:nvGrpSpPr>
                <p:cNvPr id="58" name="Group 57">
                  <a:extLst>
                    <a:ext uri="{FF2B5EF4-FFF2-40B4-BE49-F238E27FC236}">
                      <a16:creationId xmlns:a16="http://schemas.microsoft.com/office/drawing/2014/main" id="{06058A68-5915-4DD2-9F08-49DFB0D17CA4}"/>
                    </a:ext>
                  </a:extLst>
                </p:cNvPr>
                <p:cNvGrpSpPr/>
                <p:nvPr/>
              </p:nvGrpSpPr>
              <p:grpSpPr>
                <a:xfrm>
                  <a:off x="1363057" y="2674272"/>
                  <a:ext cx="688196" cy="217927"/>
                  <a:chOff x="1363057" y="2674272"/>
                  <a:chExt cx="688196" cy="217927"/>
                </a:xfrm>
              </p:grpSpPr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83CAD2EC-D93A-4E92-937B-41FE694FD8D1}"/>
                      </a:ext>
                    </a:extLst>
                  </p:cNvPr>
                  <p:cNvSpPr txBox="1"/>
                  <p:nvPr/>
                </p:nvSpPr>
                <p:spPr>
                  <a:xfrm>
                    <a:off x="1363057" y="2676884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B795574D-3270-4C57-8593-B96D38216EE4}"/>
                      </a:ext>
                    </a:extLst>
                  </p:cNvPr>
                  <p:cNvSpPr txBox="1"/>
                  <p:nvPr/>
                </p:nvSpPr>
                <p:spPr>
                  <a:xfrm>
                    <a:off x="1695141" y="2674272"/>
                    <a:ext cx="35611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</p:grpSp>
          </p:grpSp>
          <p:grpSp>
            <p:nvGrpSpPr>
              <p:cNvPr id="90" name="Group 89">
                <a:extLst>
                  <a:ext uri="{FF2B5EF4-FFF2-40B4-BE49-F238E27FC236}">
                    <a16:creationId xmlns:a16="http://schemas.microsoft.com/office/drawing/2014/main" id="{3C3607B2-0016-A11F-4052-23BB41899F8F}"/>
                  </a:ext>
                </a:extLst>
              </p:cNvPr>
              <p:cNvGrpSpPr/>
              <p:nvPr/>
            </p:nvGrpSpPr>
            <p:grpSpPr>
              <a:xfrm>
                <a:off x="158264" y="2861260"/>
                <a:ext cx="1167760" cy="1591563"/>
                <a:chOff x="600715" y="2861260"/>
                <a:chExt cx="1167760" cy="1591563"/>
              </a:xfrm>
            </p:grpSpPr>
            <p:graphicFrame>
              <p:nvGraphicFramePr>
                <p:cNvPr id="7" name="Object 6">
                  <a:extLst>
                    <a:ext uri="{FF2B5EF4-FFF2-40B4-BE49-F238E27FC236}">
                      <a16:creationId xmlns:a16="http://schemas.microsoft.com/office/drawing/2014/main" id="{379BEBA9-7489-4A45-8FB6-4B7E368358B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634789698"/>
                    </p:ext>
                  </p:extLst>
                </p:nvPr>
              </p:nvGraphicFramePr>
              <p:xfrm>
                <a:off x="730250" y="2971800"/>
                <a:ext cx="1038225" cy="13747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0" imgW="1729012" imgH="2289859" progId="Prism9.Document">
                        <p:embed/>
                      </p:oleObj>
                    </mc:Choice>
                    <mc:Fallback>
                      <p:oleObj name="Prism 9" r:id="rId10" imgW="1729012" imgH="2289859" progId="Prism9.Document">
                        <p:embed/>
                        <p:pic>
                          <p:nvPicPr>
                            <p:cNvPr id="7" name="Object 6">
                              <a:extLst>
                                <a:ext uri="{FF2B5EF4-FFF2-40B4-BE49-F238E27FC236}">
                                  <a16:creationId xmlns:a16="http://schemas.microsoft.com/office/drawing/2014/main" id="{379BEBA9-7489-4A45-8FB6-4B7E368358B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30250" y="2971800"/>
                              <a:ext cx="1038225" cy="13747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1513C364-33F3-458B-95B8-3C6D1441E92E}"/>
                    </a:ext>
                  </a:extLst>
                </p:cNvPr>
                <p:cNvSpPr txBox="1"/>
                <p:nvPr/>
              </p:nvSpPr>
              <p:spPr>
                <a:xfrm>
                  <a:off x="1375663" y="3069729"/>
                  <a:ext cx="18268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2E9617A8-BBFF-4B00-9499-B338A7A53936}"/>
                    </a:ext>
                  </a:extLst>
                </p:cNvPr>
                <p:cNvSpPr txBox="1"/>
                <p:nvPr/>
              </p:nvSpPr>
              <p:spPr>
                <a:xfrm>
                  <a:off x="1104274" y="2861260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T.Ar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C764AD77-D3DD-41C5-BF8B-016B6C6EE072}"/>
                    </a:ext>
                  </a:extLst>
                </p:cNvPr>
                <p:cNvSpPr txBox="1"/>
                <p:nvPr/>
              </p:nvSpPr>
              <p:spPr>
                <a:xfrm rot="16200000">
                  <a:off x="474921" y="3447312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2</a:t>
                  </a:r>
                </a:p>
              </p:txBody>
            </p:sp>
            <p:grpSp>
              <p:nvGrpSpPr>
                <p:cNvPr id="86" name="Group 85">
                  <a:extLst>
                    <a:ext uri="{FF2B5EF4-FFF2-40B4-BE49-F238E27FC236}">
                      <a16:creationId xmlns:a16="http://schemas.microsoft.com/office/drawing/2014/main" id="{11868174-81E7-1FCE-75F0-4EA90EFBC985}"/>
                    </a:ext>
                  </a:extLst>
                </p:cNvPr>
                <p:cNvGrpSpPr/>
                <p:nvPr/>
              </p:nvGrpSpPr>
              <p:grpSpPr>
                <a:xfrm>
                  <a:off x="972995" y="4231758"/>
                  <a:ext cx="695052" cy="221065"/>
                  <a:chOff x="972995" y="4231758"/>
                  <a:chExt cx="695052" cy="221065"/>
                </a:xfrm>
              </p:grpSpPr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id="{6775707C-55A8-4290-8D13-7DA8DE2B81D2}"/>
                      </a:ext>
                    </a:extLst>
                  </p:cNvPr>
                  <p:cNvSpPr txBox="1"/>
                  <p:nvPr/>
                </p:nvSpPr>
                <p:spPr>
                  <a:xfrm>
                    <a:off x="972995" y="4231758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B1CC1DFE-0491-4213-A99F-852589EB34C4}"/>
                      </a:ext>
                    </a:extLst>
                  </p:cNvPr>
                  <p:cNvSpPr txBox="1"/>
                  <p:nvPr/>
                </p:nvSpPr>
                <p:spPr>
                  <a:xfrm>
                    <a:off x="1311935" y="4237508"/>
                    <a:ext cx="35611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</p:grpSp>
          </p:grpSp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id="{970FFC30-C8BB-1F8F-1691-D9BD8960693F}"/>
                  </a:ext>
                </a:extLst>
              </p:cNvPr>
              <p:cNvGrpSpPr/>
              <p:nvPr/>
            </p:nvGrpSpPr>
            <p:grpSpPr>
              <a:xfrm>
                <a:off x="1927895" y="1133270"/>
                <a:ext cx="1202418" cy="1567482"/>
                <a:chOff x="2145620" y="1316159"/>
                <a:chExt cx="1202418" cy="1567482"/>
              </a:xfrm>
            </p:grpSpPr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C22E2BE2-B1F6-4689-A216-20FCC04B79B7}"/>
                    </a:ext>
                  </a:extLst>
                </p:cNvPr>
                <p:cNvSpPr txBox="1"/>
                <p:nvPr/>
              </p:nvSpPr>
              <p:spPr>
                <a:xfrm>
                  <a:off x="2716269" y="1316159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BV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97B081E0-D3EC-4470-B850-DF967E6901C9}"/>
                    </a:ext>
                  </a:extLst>
                </p:cNvPr>
                <p:cNvSpPr txBox="1"/>
                <p:nvPr/>
              </p:nvSpPr>
              <p:spPr>
                <a:xfrm rot="16200000">
                  <a:off x="2019826" y="1902211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3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A73F97BD-8C66-405F-BD4E-D12E30C567CF}"/>
                    </a:ext>
                  </a:extLst>
                </p:cNvPr>
                <p:cNvSpPr txBox="1"/>
                <p:nvPr/>
              </p:nvSpPr>
              <p:spPr>
                <a:xfrm>
                  <a:off x="2567882" y="2668326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WT</a:t>
                  </a:r>
                  <a:endParaRPr lang="en-US" sz="799" baseline="30000" dirty="0"/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D0BC5D0F-2931-410D-853A-FA74487DA1E9}"/>
                    </a:ext>
                  </a:extLst>
                </p:cNvPr>
                <p:cNvSpPr txBox="1"/>
                <p:nvPr/>
              </p:nvSpPr>
              <p:spPr>
                <a:xfrm>
                  <a:off x="2899966" y="2665714"/>
                  <a:ext cx="35611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</a:t>
                  </a:r>
                  <a:r>
                    <a:rPr lang="en-US" sz="799" baseline="30000" dirty="0"/>
                    <a:t>KO</a:t>
                  </a:r>
                </a:p>
              </p:txBody>
            </p:sp>
            <p:graphicFrame>
              <p:nvGraphicFramePr>
                <p:cNvPr id="44" name="Object 43">
                  <a:extLst>
                    <a:ext uri="{FF2B5EF4-FFF2-40B4-BE49-F238E27FC236}">
                      <a16:creationId xmlns:a16="http://schemas.microsoft.com/office/drawing/2014/main" id="{D3CD8045-B97B-47E2-9278-2F06F3B545BC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424427484"/>
                    </p:ext>
                  </p:extLst>
                </p:nvPr>
              </p:nvGraphicFramePr>
              <p:xfrm>
                <a:off x="2262188" y="1417640"/>
                <a:ext cx="1085850" cy="13747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12" imgW="1809682" imgH="2289859" progId="Prism9.Document">
                        <p:embed/>
                      </p:oleObj>
                    </mc:Choice>
                    <mc:Fallback>
                      <p:oleObj name="Prism 9" r:id="rId12" imgW="1809682" imgH="2289859" progId="Prism9.Document">
                        <p:embed/>
                        <p:pic>
                          <p:nvPicPr>
                            <p:cNvPr id="44" name="Object 43">
                              <a:extLst>
                                <a:ext uri="{FF2B5EF4-FFF2-40B4-BE49-F238E27FC236}">
                                  <a16:creationId xmlns:a16="http://schemas.microsoft.com/office/drawing/2014/main" id="{D3CD8045-B97B-47E2-9278-2F06F3B545B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262188" y="1417640"/>
                              <a:ext cx="1085850" cy="13747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BC115666-B800-4113-34EF-E4AC083CA97B}"/>
                  </a:ext>
                </a:extLst>
              </p:cNvPr>
              <p:cNvGrpSpPr/>
              <p:nvPr/>
            </p:nvGrpSpPr>
            <p:grpSpPr>
              <a:xfrm>
                <a:off x="4180010" y="1143229"/>
                <a:ext cx="1081200" cy="1567483"/>
                <a:chOff x="3309146" y="1308700"/>
                <a:chExt cx="1081200" cy="1567483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269B6952-A4F5-4550-94B9-A78A53071EFC}"/>
                    </a:ext>
                  </a:extLst>
                </p:cNvPr>
                <p:cNvSpPr txBox="1"/>
                <p:nvPr/>
              </p:nvSpPr>
              <p:spPr>
                <a:xfrm>
                  <a:off x="4003302" y="1576740"/>
                  <a:ext cx="18268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45B552C2-0824-4367-A304-7E3B074DFFEF}"/>
                    </a:ext>
                  </a:extLst>
                </p:cNvPr>
                <p:cNvSpPr txBox="1"/>
                <p:nvPr/>
              </p:nvSpPr>
              <p:spPr>
                <a:xfrm>
                  <a:off x="3767927" y="1308700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TbN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531368C3-DABE-4F93-84F1-DE659071268D}"/>
                    </a:ext>
                  </a:extLst>
                </p:cNvPr>
                <p:cNvSpPr txBox="1"/>
                <p:nvPr/>
              </p:nvSpPr>
              <p:spPr>
                <a:xfrm rot="16200000">
                  <a:off x="3183352" y="1946805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1/mm</a:t>
                  </a:r>
                  <a:endParaRPr lang="en-US" sz="799" baseline="30000" dirty="0"/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D5F74F11-0394-49B9-B70A-F447E5E90713}"/>
                    </a:ext>
                  </a:extLst>
                </p:cNvPr>
                <p:cNvSpPr txBox="1"/>
                <p:nvPr/>
              </p:nvSpPr>
              <p:spPr>
                <a:xfrm>
                  <a:off x="3679300" y="2660868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WT</a:t>
                  </a:r>
                  <a:endParaRPr lang="en-US" sz="799" baseline="30000" dirty="0"/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D64DC275-4919-4656-AF22-DBAC3D83CB97}"/>
                    </a:ext>
                  </a:extLst>
                </p:cNvPr>
                <p:cNvSpPr txBox="1"/>
                <p:nvPr/>
              </p:nvSpPr>
              <p:spPr>
                <a:xfrm>
                  <a:off x="4011383" y="2658256"/>
                  <a:ext cx="35611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</a:t>
                  </a:r>
                  <a:r>
                    <a:rPr lang="en-US" sz="799" baseline="30000" dirty="0"/>
                    <a:t>KO</a:t>
                  </a:r>
                </a:p>
              </p:txBody>
            </p:sp>
            <p:graphicFrame>
              <p:nvGraphicFramePr>
                <p:cNvPr id="45" name="Object 44">
                  <a:extLst>
                    <a:ext uri="{FF2B5EF4-FFF2-40B4-BE49-F238E27FC236}">
                      <a16:creationId xmlns:a16="http://schemas.microsoft.com/office/drawing/2014/main" id="{90FC12E2-3DA8-493C-8A68-97A62EB2021B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659808944"/>
                    </p:ext>
                  </p:extLst>
                </p:nvPr>
              </p:nvGraphicFramePr>
              <p:xfrm>
                <a:off x="3431496" y="1407154"/>
                <a:ext cx="958850" cy="13747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14" imgW="1599363" imgH="2289859" progId="Prism8.Document">
                        <p:embed/>
                      </p:oleObj>
                    </mc:Choice>
                    <mc:Fallback>
                      <p:oleObj name="Prism 8" r:id="rId14" imgW="1599363" imgH="2289859" progId="Prism8.Document">
                        <p:embed/>
                        <p:pic>
                          <p:nvPicPr>
                            <p:cNvPr id="45" name="Object 44">
                              <a:extLst>
                                <a:ext uri="{FF2B5EF4-FFF2-40B4-BE49-F238E27FC236}">
                                  <a16:creationId xmlns:a16="http://schemas.microsoft.com/office/drawing/2014/main" id="{90FC12E2-3DA8-493C-8A68-97A62EB2021B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431496" y="1407154"/>
                              <a:ext cx="958850" cy="13747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4D9E1202-5F85-B3E1-4B42-DA2FE088FFEC}"/>
                  </a:ext>
                </a:extLst>
              </p:cNvPr>
              <p:cNvGrpSpPr/>
              <p:nvPr/>
            </p:nvGrpSpPr>
            <p:grpSpPr>
              <a:xfrm>
                <a:off x="5216374" y="1139748"/>
                <a:ext cx="1205925" cy="1567482"/>
                <a:chOff x="4345510" y="1305219"/>
                <a:chExt cx="1205925" cy="1567482"/>
              </a:xfrm>
            </p:grpSpPr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7658F64A-B52C-492A-855D-82346E4CE4EE}"/>
                    </a:ext>
                  </a:extLst>
                </p:cNvPr>
                <p:cNvSpPr txBox="1"/>
                <p:nvPr/>
              </p:nvSpPr>
              <p:spPr>
                <a:xfrm>
                  <a:off x="4923011" y="1305219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TbTh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9CFBAF4A-F4F0-4885-A840-EBFA23E23578}"/>
                    </a:ext>
                  </a:extLst>
                </p:cNvPr>
                <p:cNvSpPr txBox="1"/>
                <p:nvPr/>
              </p:nvSpPr>
              <p:spPr>
                <a:xfrm rot="16200000">
                  <a:off x="4219716" y="1906338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endParaRPr lang="en-US" sz="799" baseline="30000" dirty="0"/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154F4357-974B-4B32-A1A6-F389048C48C2}"/>
                    </a:ext>
                  </a:extLst>
                </p:cNvPr>
                <p:cNvSpPr txBox="1"/>
                <p:nvPr/>
              </p:nvSpPr>
              <p:spPr>
                <a:xfrm>
                  <a:off x="4774625" y="2657386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WT</a:t>
                  </a:r>
                  <a:endParaRPr lang="en-US" sz="799" baseline="30000" dirty="0"/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499821F4-4CC6-4044-831B-8F3E9CCCBACD}"/>
                    </a:ext>
                  </a:extLst>
                </p:cNvPr>
                <p:cNvSpPr txBox="1"/>
                <p:nvPr/>
              </p:nvSpPr>
              <p:spPr>
                <a:xfrm>
                  <a:off x="5106708" y="2654774"/>
                  <a:ext cx="35611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</a:t>
                  </a:r>
                  <a:r>
                    <a:rPr lang="en-US" sz="799" baseline="30000" dirty="0"/>
                    <a:t>KO</a:t>
                  </a:r>
                </a:p>
              </p:txBody>
            </p:sp>
            <p:graphicFrame>
              <p:nvGraphicFramePr>
                <p:cNvPr id="46" name="Object 45">
                  <a:extLst>
                    <a:ext uri="{FF2B5EF4-FFF2-40B4-BE49-F238E27FC236}">
                      <a16:creationId xmlns:a16="http://schemas.microsoft.com/office/drawing/2014/main" id="{CEEB42A3-340C-4FAE-AAC0-429C1B2B682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28155830"/>
                    </p:ext>
                  </p:extLst>
                </p:nvPr>
              </p:nvGraphicFramePr>
              <p:xfrm>
                <a:off x="4465585" y="1399637"/>
                <a:ext cx="1085850" cy="13747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16" imgW="1809682" imgH="2289859" progId="Prism8.Document">
                        <p:embed/>
                      </p:oleObj>
                    </mc:Choice>
                    <mc:Fallback>
                      <p:oleObj name="Prism 8" r:id="rId16" imgW="1809682" imgH="2289859" progId="Prism8.Document">
                        <p:embed/>
                        <p:pic>
                          <p:nvPicPr>
                            <p:cNvPr id="46" name="Object 45">
                              <a:extLst>
                                <a:ext uri="{FF2B5EF4-FFF2-40B4-BE49-F238E27FC236}">
                                  <a16:creationId xmlns:a16="http://schemas.microsoft.com/office/drawing/2014/main" id="{CEEB42A3-340C-4FAE-AAC0-429C1B2B682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465585" y="1399637"/>
                              <a:ext cx="1085850" cy="13747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014A2B7B-3682-E951-B943-B263A9C2E1A2}"/>
                  </a:ext>
                </a:extLst>
              </p:cNvPr>
              <p:cNvGrpSpPr/>
              <p:nvPr/>
            </p:nvGrpSpPr>
            <p:grpSpPr>
              <a:xfrm>
                <a:off x="4447314" y="2851008"/>
                <a:ext cx="1160404" cy="1591953"/>
                <a:chOff x="1733609" y="2858382"/>
                <a:chExt cx="1160404" cy="1591953"/>
              </a:xfrm>
            </p:grpSpPr>
            <p:graphicFrame>
              <p:nvGraphicFramePr>
                <p:cNvPr id="6" name="Object 5">
                  <a:extLst>
                    <a:ext uri="{FF2B5EF4-FFF2-40B4-BE49-F238E27FC236}">
                      <a16:creationId xmlns:a16="http://schemas.microsoft.com/office/drawing/2014/main" id="{1942D6E5-52B6-4782-A2F2-16ABB60CE65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83441054"/>
                    </p:ext>
                  </p:extLst>
                </p:nvPr>
              </p:nvGraphicFramePr>
              <p:xfrm>
                <a:off x="1858963" y="2976565"/>
                <a:ext cx="1035050" cy="13747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18" imgW="1727211" imgH="2289859" progId="Prism8.Document">
                        <p:embed/>
                      </p:oleObj>
                    </mc:Choice>
                    <mc:Fallback>
                      <p:oleObj name="Prism 8" r:id="rId18" imgW="1727211" imgH="2289859" progId="Prism8.Document">
                        <p:embed/>
                        <p:pic>
                          <p:nvPicPr>
                            <p:cNvPr id="6" name="Object 5">
                              <a:extLst>
                                <a:ext uri="{FF2B5EF4-FFF2-40B4-BE49-F238E27FC236}">
                                  <a16:creationId xmlns:a16="http://schemas.microsoft.com/office/drawing/2014/main" id="{1942D6E5-52B6-4782-A2F2-16ABB60CE65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858963" y="2976565"/>
                              <a:ext cx="1035050" cy="13747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2B705AA9-33EB-4A9C-B781-0A08FE16ECE1}"/>
                    </a:ext>
                  </a:extLst>
                </p:cNvPr>
                <p:cNvSpPr txBox="1"/>
                <p:nvPr/>
              </p:nvSpPr>
              <p:spPr>
                <a:xfrm>
                  <a:off x="2505749" y="3066980"/>
                  <a:ext cx="35260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FADC0239-4D85-4421-B7EB-409CE5567A88}"/>
                    </a:ext>
                  </a:extLst>
                </p:cNvPr>
                <p:cNvSpPr txBox="1"/>
                <p:nvPr/>
              </p:nvSpPr>
              <p:spPr>
                <a:xfrm>
                  <a:off x="2213705" y="2858382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M.Ar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7055E6F3-7FAB-49E9-9804-221638E41E0A}"/>
                    </a:ext>
                  </a:extLst>
                </p:cNvPr>
                <p:cNvSpPr txBox="1"/>
                <p:nvPr/>
              </p:nvSpPr>
              <p:spPr>
                <a:xfrm rot="16200000">
                  <a:off x="1607815" y="3444435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2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A7927560-4697-4C47-A9CA-60C554BA1B87}"/>
                    </a:ext>
                  </a:extLst>
                </p:cNvPr>
                <p:cNvSpPr txBox="1"/>
                <p:nvPr/>
              </p:nvSpPr>
              <p:spPr>
                <a:xfrm>
                  <a:off x="2154272" y="4229270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WT</a:t>
                  </a:r>
                  <a:endParaRPr lang="en-US" sz="799" baseline="30000" dirty="0"/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8DDFF061-546E-48E5-80D8-ACFD3A13B576}"/>
                    </a:ext>
                  </a:extLst>
                </p:cNvPr>
                <p:cNvSpPr txBox="1"/>
                <p:nvPr/>
              </p:nvSpPr>
              <p:spPr>
                <a:xfrm>
                  <a:off x="2493212" y="4235020"/>
                  <a:ext cx="35611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</a:t>
                  </a:r>
                  <a:r>
                    <a:rPr lang="en-US" sz="799" baseline="30000" dirty="0"/>
                    <a:t>KO</a:t>
                  </a:r>
                </a:p>
              </p:txBody>
            </p:sp>
          </p:grpSp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71B9F5F6-446E-A673-6C1E-699B87A156E1}"/>
                  </a:ext>
                </a:extLst>
              </p:cNvPr>
              <p:cNvGrpSpPr/>
              <p:nvPr/>
            </p:nvGrpSpPr>
            <p:grpSpPr>
              <a:xfrm>
                <a:off x="3350970" y="2862879"/>
                <a:ext cx="1216201" cy="1594324"/>
                <a:chOff x="2820030" y="2855505"/>
                <a:chExt cx="1216201" cy="1594324"/>
              </a:xfrm>
            </p:grpSpPr>
            <p:graphicFrame>
              <p:nvGraphicFramePr>
                <p:cNvPr id="5" name="Object 4">
                  <a:extLst>
                    <a:ext uri="{FF2B5EF4-FFF2-40B4-BE49-F238E27FC236}">
                      <a16:creationId xmlns:a16="http://schemas.microsoft.com/office/drawing/2014/main" id="{D70968ED-6610-4EF3-9575-8354F088BD4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351030009"/>
                    </p:ext>
                  </p:extLst>
                </p:nvPr>
              </p:nvGraphicFramePr>
              <p:xfrm>
                <a:off x="2951969" y="2961554"/>
                <a:ext cx="1084262" cy="13747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20" imgW="1809682" imgH="2289859" progId="Prism8.Document">
                        <p:embed/>
                      </p:oleObj>
                    </mc:Choice>
                    <mc:Fallback>
                      <p:oleObj name="Prism 8" r:id="rId20" imgW="1809682" imgH="2289859" progId="Prism8.Document">
                        <p:embed/>
                        <p:pic>
                          <p:nvPicPr>
                            <p:cNvPr id="5" name="Object 4">
                              <a:extLst>
                                <a:ext uri="{FF2B5EF4-FFF2-40B4-BE49-F238E27FC236}">
                                  <a16:creationId xmlns:a16="http://schemas.microsoft.com/office/drawing/2014/main" id="{D70968ED-6610-4EF3-9575-8354F088BD4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951969" y="2961554"/>
                              <a:ext cx="1084262" cy="13747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00850E03-2E14-4CA9-97DC-A97C2AEEEF06}"/>
                    </a:ext>
                  </a:extLst>
                </p:cNvPr>
                <p:cNvSpPr txBox="1"/>
                <p:nvPr/>
              </p:nvSpPr>
              <p:spPr>
                <a:xfrm>
                  <a:off x="3371851" y="2855505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Ct.Th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15BC0EC3-FC47-44F5-AB9C-FD9425D12273}"/>
                    </a:ext>
                  </a:extLst>
                </p:cNvPr>
                <p:cNvSpPr txBox="1"/>
                <p:nvPr/>
              </p:nvSpPr>
              <p:spPr>
                <a:xfrm rot="16200000">
                  <a:off x="2694236" y="3441559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endParaRPr lang="en-US" sz="799" baseline="30000" dirty="0"/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027D1C58-E2FA-4542-A1BE-13C5A056C90A}"/>
                    </a:ext>
                  </a:extLst>
                </p:cNvPr>
                <p:cNvSpPr txBox="1"/>
                <p:nvPr/>
              </p:nvSpPr>
              <p:spPr>
                <a:xfrm>
                  <a:off x="3294070" y="4228764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WT</a:t>
                  </a:r>
                  <a:endParaRPr lang="en-US" sz="799" baseline="30000" dirty="0"/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0A043208-7829-43D6-8D45-FB9A36E81C1E}"/>
                    </a:ext>
                  </a:extLst>
                </p:cNvPr>
                <p:cNvSpPr txBox="1"/>
                <p:nvPr/>
              </p:nvSpPr>
              <p:spPr>
                <a:xfrm>
                  <a:off x="3633010" y="4234514"/>
                  <a:ext cx="35611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</a:t>
                  </a:r>
                  <a:r>
                    <a:rPr lang="en-US" sz="799" baseline="30000" dirty="0"/>
                    <a:t>KO</a:t>
                  </a:r>
                </a:p>
              </p:txBody>
            </p:sp>
          </p:grpSp>
          <p:grpSp>
            <p:nvGrpSpPr>
              <p:cNvPr id="83" name="Group 82">
                <a:extLst>
                  <a:ext uri="{FF2B5EF4-FFF2-40B4-BE49-F238E27FC236}">
                    <a16:creationId xmlns:a16="http://schemas.microsoft.com/office/drawing/2014/main" id="{AAEF7102-BB50-1FB7-E653-E4899FEC50D6}"/>
                  </a:ext>
                </a:extLst>
              </p:cNvPr>
              <p:cNvGrpSpPr/>
              <p:nvPr/>
            </p:nvGrpSpPr>
            <p:grpSpPr>
              <a:xfrm>
                <a:off x="1269095" y="2855506"/>
                <a:ext cx="1158039" cy="1593206"/>
                <a:chOff x="3864811" y="2855506"/>
                <a:chExt cx="1158039" cy="1593206"/>
              </a:xfrm>
            </p:grpSpPr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45FC4F8D-8A49-4F3D-B9CB-7BFCD4FF476A}"/>
                    </a:ext>
                  </a:extLst>
                </p:cNvPr>
                <p:cNvSpPr txBox="1"/>
                <p:nvPr/>
              </p:nvSpPr>
              <p:spPr>
                <a:xfrm>
                  <a:off x="4436863" y="2855506"/>
                  <a:ext cx="46690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B.Ar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4BB8CBBA-06A0-4AF5-8A8F-2A32B5308765}"/>
                    </a:ext>
                  </a:extLst>
                </p:cNvPr>
                <p:cNvSpPr txBox="1"/>
                <p:nvPr/>
              </p:nvSpPr>
              <p:spPr>
                <a:xfrm rot="16200000">
                  <a:off x="3739017" y="3441559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mm</a:t>
                  </a:r>
                  <a:r>
                    <a:rPr lang="en-US" sz="799" baseline="30000" dirty="0"/>
                    <a:t>2</a:t>
                  </a:r>
                </a:p>
              </p:txBody>
            </p:sp>
            <p:graphicFrame>
              <p:nvGraphicFramePr>
                <p:cNvPr id="47" name="Object 46">
                  <a:extLst>
                    <a:ext uri="{FF2B5EF4-FFF2-40B4-BE49-F238E27FC236}">
                      <a16:creationId xmlns:a16="http://schemas.microsoft.com/office/drawing/2014/main" id="{B5ED6CB9-BC19-41F5-98AC-ADEFC5F64651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654422718"/>
                    </p:ext>
                  </p:extLst>
                </p:nvPr>
              </p:nvGraphicFramePr>
              <p:xfrm>
                <a:off x="3986213" y="2967038"/>
                <a:ext cx="1036637" cy="13747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22" imgW="1729012" imgH="2289859" progId="Prism9.Document">
                        <p:embed/>
                      </p:oleObj>
                    </mc:Choice>
                    <mc:Fallback>
                      <p:oleObj name="Prism 9" r:id="rId22" imgW="1729012" imgH="2289859" progId="Prism9.Document">
                        <p:embed/>
                        <p:pic>
                          <p:nvPicPr>
                            <p:cNvPr id="47" name="Object 46">
                              <a:extLst>
                                <a:ext uri="{FF2B5EF4-FFF2-40B4-BE49-F238E27FC236}">
                                  <a16:creationId xmlns:a16="http://schemas.microsoft.com/office/drawing/2014/main" id="{B5ED6CB9-BC19-41F5-98AC-ADEFC5F6465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986213" y="2967038"/>
                              <a:ext cx="1036637" cy="13747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0C3D5BB9-0B4E-450D-9D0B-52EFDEB0F08A}"/>
                    </a:ext>
                  </a:extLst>
                </p:cNvPr>
                <p:cNvSpPr txBox="1"/>
                <p:nvPr/>
              </p:nvSpPr>
              <p:spPr>
                <a:xfrm>
                  <a:off x="4275907" y="4227647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WT</a:t>
                  </a:r>
                  <a:endParaRPr lang="en-US" sz="799" baseline="30000" dirty="0"/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A8438DE0-7233-4F2B-9811-0179E233B73E}"/>
                    </a:ext>
                  </a:extLst>
                </p:cNvPr>
                <p:cNvSpPr txBox="1"/>
                <p:nvPr/>
              </p:nvSpPr>
              <p:spPr>
                <a:xfrm>
                  <a:off x="4614847" y="4233397"/>
                  <a:ext cx="35611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</a:t>
                  </a:r>
                  <a:r>
                    <a:rPr lang="en-US" sz="799" baseline="30000" dirty="0"/>
                    <a:t>KO</a:t>
                  </a:r>
                </a:p>
              </p:txBody>
            </p:sp>
          </p:grpSp>
          <p:graphicFrame>
            <p:nvGraphicFramePr>
              <p:cNvPr id="57" name="Object 56">
                <a:extLst>
                  <a:ext uri="{FF2B5EF4-FFF2-40B4-BE49-F238E27FC236}">
                    <a16:creationId xmlns:a16="http://schemas.microsoft.com/office/drawing/2014/main" id="{6167AC1D-7A36-416A-8762-1565AAF087EC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910178475"/>
                  </p:ext>
                </p:extLst>
              </p:nvPr>
            </p:nvGraphicFramePr>
            <p:xfrm>
              <a:off x="1230340" y="5012703"/>
              <a:ext cx="1084262" cy="1374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4" imgW="1809682" imgH="2289859" progId="Prism8.Document">
                      <p:embed/>
                    </p:oleObj>
                  </mc:Choice>
                  <mc:Fallback>
                    <p:oleObj name="Prism 8" r:id="rId24" imgW="1809682" imgH="2289859" progId="Prism8.Document">
                      <p:embed/>
                      <p:pic>
                        <p:nvPicPr>
                          <p:cNvPr id="57" name="Object 56">
                            <a:extLst>
                              <a:ext uri="{FF2B5EF4-FFF2-40B4-BE49-F238E27FC236}">
                                <a16:creationId xmlns:a16="http://schemas.microsoft.com/office/drawing/2014/main" id="{6167AC1D-7A36-416A-8762-1565AAF087E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5"/>
                          <a:stretch>
                            <a:fillRect/>
                          </a:stretch>
                        </p:blipFill>
                        <p:spPr>
                          <a:xfrm>
                            <a:off x="1230340" y="5012703"/>
                            <a:ext cx="1084262" cy="13747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D49B851B-3152-4C5F-95FB-BD16DACFB946}"/>
                  </a:ext>
                </a:extLst>
              </p:cNvPr>
              <p:cNvSpPr txBox="1"/>
              <p:nvPr/>
            </p:nvSpPr>
            <p:spPr>
              <a:xfrm>
                <a:off x="1144515" y="4695263"/>
                <a:ext cx="13559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05AF16BC-9BBC-4478-9A4B-E5D8C93F7668}"/>
                  </a:ext>
                </a:extLst>
              </p:cNvPr>
              <p:cNvSpPr txBox="1"/>
              <p:nvPr/>
            </p:nvSpPr>
            <p:spPr>
              <a:xfrm>
                <a:off x="1478377" y="4708789"/>
                <a:ext cx="12247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FV Proximal tibia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F4C725D4-1C3F-44E3-8C27-F4ECA0248DB1}"/>
                  </a:ext>
                </a:extLst>
              </p:cNvPr>
              <p:cNvSpPr txBox="1"/>
              <p:nvPr/>
            </p:nvSpPr>
            <p:spPr>
              <a:xfrm rot="16200000">
                <a:off x="957773" y="5530243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>
                    <a:latin typeface="Symbol" panose="05050102010706020507" pitchFamily="18" charset="2"/>
                  </a:rPr>
                  <a:t>m</a:t>
                </a:r>
                <a:r>
                  <a:rPr lang="en-US" sz="799" dirty="0"/>
                  <a:t>m</a:t>
                </a:r>
                <a:r>
                  <a:rPr lang="en-US" sz="799" baseline="30000" dirty="0"/>
                  <a:t>3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4BB894F9-4D96-47BD-BD1C-F521F6050027}"/>
                  </a:ext>
                </a:extLst>
              </p:cNvPr>
              <p:cNvSpPr txBox="1"/>
              <p:nvPr/>
            </p:nvSpPr>
            <p:spPr>
              <a:xfrm>
                <a:off x="2689454" y="4712534"/>
                <a:ext cx="12247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FV Distal tibia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F3471794-8D5A-412C-A7CA-634E3FF8C613}"/>
                  </a:ext>
                </a:extLst>
              </p:cNvPr>
              <p:cNvSpPr txBox="1"/>
              <p:nvPr/>
            </p:nvSpPr>
            <p:spPr>
              <a:xfrm rot="16200000">
                <a:off x="2295931" y="5556134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>
                    <a:latin typeface="Symbol" panose="05050102010706020507" pitchFamily="18" charset="2"/>
                  </a:rPr>
                  <a:t>m</a:t>
                </a:r>
                <a:r>
                  <a:rPr lang="en-US" sz="799" dirty="0"/>
                  <a:t>m</a:t>
                </a:r>
                <a:r>
                  <a:rPr lang="en-US" sz="799" baseline="30000" dirty="0"/>
                  <a:t>3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6D394855-403E-4512-9C5C-004CB7CA2B5D}"/>
                  </a:ext>
                </a:extLst>
              </p:cNvPr>
              <p:cNvSpPr txBox="1"/>
              <p:nvPr/>
            </p:nvSpPr>
            <p:spPr>
              <a:xfrm>
                <a:off x="3831762" y="4716347"/>
                <a:ext cx="12247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FV Entire tibia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99FEE7A7-8F6B-41F3-BF3B-753677AF6BC6}"/>
                  </a:ext>
                </a:extLst>
              </p:cNvPr>
              <p:cNvSpPr txBox="1"/>
              <p:nvPr/>
            </p:nvSpPr>
            <p:spPr>
              <a:xfrm rot="16200000">
                <a:off x="3459663" y="5523163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>
                    <a:latin typeface="Symbol" panose="05050102010706020507" pitchFamily="18" charset="2"/>
                  </a:rPr>
                  <a:t>m</a:t>
                </a:r>
                <a:r>
                  <a:rPr lang="en-US" sz="799" dirty="0"/>
                  <a:t>m</a:t>
                </a:r>
                <a:r>
                  <a:rPr lang="en-US" sz="799" baseline="30000" dirty="0"/>
                  <a:t>3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93348ECD-17BC-4F59-8138-401CCA001E40}"/>
                  </a:ext>
                </a:extLst>
              </p:cNvPr>
              <p:cNvSpPr txBox="1"/>
              <p:nvPr/>
            </p:nvSpPr>
            <p:spPr>
              <a:xfrm>
                <a:off x="1576749" y="6276326"/>
                <a:ext cx="38308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WT</a:t>
                </a:r>
                <a:endParaRPr lang="en-US" sz="799" baseline="30000" dirty="0"/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B1143BAE-DC34-42F6-961E-6CFC41F03D9E}"/>
                  </a:ext>
                </a:extLst>
              </p:cNvPr>
              <p:cNvSpPr txBox="1"/>
              <p:nvPr/>
            </p:nvSpPr>
            <p:spPr>
              <a:xfrm>
                <a:off x="1908833" y="6273714"/>
                <a:ext cx="35611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⍺</a:t>
                </a:r>
                <a:r>
                  <a:rPr lang="en-US" sz="799" baseline="30000" dirty="0"/>
                  <a:t>KO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11AEB80C-DFC8-4539-B7DE-BD9B5939A8C1}"/>
                  </a:ext>
                </a:extLst>
              </p:cNvPr>
              <p:cNvSpPr txBox="1"/>
              <p:nvPr/>
            </p:nvSpPr>
            <p:spPr>
              <a:xfrm>
                <a:off x="2826990" y="6298000"/>
                <a:ext cx="38308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WT</a:t>
                </a:r>
                <a:endParaRPr lang="en-US" sz="799" baseline="30000" dirty="0"/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F7F70C94-90E9-4463-9433-D47F6CC52A0C}"/>
                  </a:ext>
                </a:extLst>
              </p:cNvPr>
              <p:cNvSpPr txBox="1"/>
              <p:nvPr/>
            </p:nvSpPr>
            <p:spPr>
              <a:xfrm>
                <a:off x="3164151" y="6301165"/>
                <a:ext cx="35611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⍺</a:t>
                </a:r>
                <a:r>
                  <a:rPr lang="en-US" sz="799" baseline="30000" dirty="0"/>
                  <a:t>KO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47AF71B7-3F3E-4BA5-87B1-177AFC4A638A}"/>
                  </a:ext>
                </a:extLst>
              </p:cNvPr>
              <p:cNvSpPr txBox="1"/>
              <p:nvPr/>
            </p:nvSpPr>
            <p:spPr>
              <a:xfrm>
                <a:off x="4013511" y="6301165"/>
                <a:ext cx="38308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WT</a:t>
                </a:r>
                <a:endParaRPr lang="en-US" sz="799" baseline="30000" dirty="0"/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1082F410-C514-473E-BD9A-CA573F19830F}"/>
                  </a:ext>
                </a:extLst>
              </p:cNvPr>
              <p:cNvSpPr txBox="1"/>
              <p:nvPr/>
            </p:nvSpPr>
            <p:spPr>
              <a:xfrm>
                <a:off x="4345594" y="6298553"/>
                <a:ext cx="35611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⍺</a:t>
                </a:r>
                <a:r>
                  <a:rPr lang="en-US" sz="799" baseline="30000" dirty="0"/>
                  <a:t>KO</a:t>
                </a:r>
              </a:p>
            </p:txBody>
          </p:sp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A6EAACFC-D318-00D4-AE78-FBE58F560992}"/>
                  </a:ext>
                </a:extLst>
              </p:cNvPr>
              <p:cNvGrpSpPr/>
              <p:nvPr/>
            </p:nvGrpSpPr>
            <p:grpSpPr>
              <a:xfrm>
                <a:off x="3134217" y="1147883"/>
                <a:ext cx="1087198" cy="1565956"/>
                <a:chOff x="3134217" y="1313354"/>
                <a:chExt cx="1087198" cy="1565956"/>
              </a:xfrm>
            </p:grpSpPr>
            <p:graphicFrame>
              <p:nvGraphicFramePr>
                <p:cNvPr id="2" name="Object 1">
                  <a:extLst>
                    <a:ext uri="{FF2B5EF4-FFF2-40B4-BE49-F238E27FC236}">
                      <a16:creationId xmlns:a16="http://schemas.microsoft.com/office/drawing/2014/main" id="{A9BF579C-37F8-769D-6603-8864BFA0BE2D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138994562"/>
                    </p:ext>
                  </p:extLst>
                </p:nvPr>
              </p:nvGraphicFramePr>
              <p:xfrm>
                <a:off x="3134217" y="1406026"/>
                <a:ext cx="1087198" cy="1371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26" imgW="1814364" imgH="2289859" progId="Prism9.Document">
                        <p:embed/>
                      </p:oleObj>
                    </mc:Choice>
                    <mc:Fallback>
                      <p:oleObj name="Prism 9" r:id="rId26" imgW="1814364" imgH="2289859" progId="Prism9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134217" y="1406026"/>
                              <a:ext cx="1087198" cy="1371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59" name="Group 58">
                  <a:extLst>
                    <a:ext uri="{FF2B5EF4-FFF2-40B4-BE49-F238E27FC236}">
                      <a16:creationId xmlns:a16="http://schemas.microsoft.com/office/drawing/2014/main" id="{1D13CFBB-7204-7987-3803-4BF3F5C6CAFB}"/>
                    </a:ext>
                  </a:extLst>
                </p:cNvPr>
                <p:cNvGrpSpPr/>
                <p:nvPr/>
              </p:nvGrpSpPr>
              <p:grpSpPr>
                <a:xfrm>
                  <a:off x="3484043" y="2661383"/>
                  <a:ext cx="688196" cy="217927"/>
                  <a:chOff x="1363057" y="2674272"/>
                  <a:chExt cx="688196" cy="217927"/>
                </a:xfrm>
              </p:grpSpPr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86D26490-F644-8D2C-9089-4104D2D5B737}"/>
                      </a:ext>
                    </a:extLst>
                  </p:cNvPr>
                  <p:cNvSpPr txBox="1"/>
                  <p:nvPr/>
                </p:nvSpPr>
                <p:spPr>
                  <a:xfrm>
                    <a:off x="1363057" y="2676884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77" name="TextBox 76">
                    <a:extLst>
                      <a:ext uri="{FF2B5EF4-FFF2-40B4-BE49-F238E27FC236}">
                        <a16:creationId xmlns:a16="http://schemas.microsoft.com/office/drawing/2014/main" id="{1A90CB1C-7D68-E245-DD65-13D9150AEF27}"/>
                      </a:ext>
                    </a:extLst>
                  </p:cNvPr>
                  <p:cNvSpPr txBox="1"/>
                  <p:nvPr/>
                </p:nvSpPr>
                <p:spPr>
                  <a:xfrm>
                    <a:off x="1695141" y="2674272"/>
                    <a:ext cx="35611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</p:grp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62222726-BF41-3AE2-AD52-039C8708A6EF}"/>
                    </a:ext>
                  </a:extLst>
                </p:cNvPr>
                <p:cNvSpPr txBox="1"/>
                <p:nvPr/>
              </p:nvSpPr>
              <p:spPr>
                <a:xfrm>
                  <a:off x="3538058" y="1313354"/>
                  <a:ext cx="60278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BV/TV</a:t>
                  </a:r>
                </a:p>
              </p:txBody>
            </p:sp>
          </p:grp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DC1831BB-A992-ED65-47D7-BFD6FA5955BC}"/>
                  </a:ext>
                </a:extLst>
              </p:cNvPr>
              <p:cNvSpPr txBox="1"/>
              <p:nvPr/>
            </p:nvSpPr>
            <p:spPr>
              <a:xfrm>
                <a:off x="330166" y="803041"/>
                <a:ext cx="13559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A</a:t>
                </a:r>
              </a:p>
            </p:txBody>
          </p:sp>
          <p:grpSp>
            <p:nvGrpSpPr>
              <p:cNvPr id="96" name="Group 95">
                <a:extLst>
                  <a:ext uri="{FF2B5EF4-FFF2-40B4-BE49-F238E27FC236}">
                    <a16:creationId xmlns:a16="http://schemas.microsoft.com/office/drawing/2014/main" id="{AC1BFF32-8E29-4105-238E-E980110726C7}"/>
                  </a:ext>
                </a:extLst>
              </p:cNvPr>
              <p:cNvGrpSpPr/>
              <p:nvPr/>
            </p:nvGrpSpPr>
            <p:grpSpPr>
              <a:xfrm>
                <a:off x="2459033" y="2867917"/>
                <a:ext cx="1035834" cy="1582661"/>
                <a:chOff x="2459033" y="2867917"/>
                <a:chExt cx="1035834" cy="1582661"/>
              </a:xfrm>
            </p:grpSpPr>
            <p:grpSp>
              <p:nvGrpSpPr>
                <p:cNvPr id="87" name="Group 86">
                  <a:extLst>
                    <a:ext uri="{FF2B5EF4-FFF2-40B4-BE49-F238E27FC236}">
                      <a16:creationId xmlns:a16="http://schemas.microsoft.com/office/drawing/2014/main" id="{F4C20144-4432-C7BF-3966-F867C1D8216A}"/>
                    </a:ext>
                  </a:extLst>
                </p:cNvPr>
                <p:cNvGrpSpPr/>
                <p:nvPr/>
              </p:nvGrpSpPr>
              <p:grpSpPr>
                <a:xfrm>
                  <a:off x="2755325" y="4229513"/>
                  <a:ext cx="695052" cy="221065"/>
                  <a:chOff x="972995" y="4231758"/>
                  <a:chExt cx="695052" cy="221065"/>
                </a:xfrm>
              </p:grpSpPr>
              <p:sp>
                <p:nvSpPr>
                  <p:cNvPr id="88" name="TextBox 87">
                    <a:extLst>
                      <a:ext uri="{FF2B5EF4-FFF2-40B4-BE49-F238E27FC236}">
                        <a16:creationId xmlns:a16="http://schemas.microsoft.com/office/drawing/2014/main" id="{E7D6E171-B349-A8D6-3B44-3D66A33B6446}"/>
                      </a:ext>
                    </a:extLst>
                  </p:cNvPr>
                  <p:cNvSpPr txBox="1"/>
                  <p:nvPr/>
                </p:nvSpPr>
                <p:spPr>
                  <a:xfrm>
                    <a:off x="972995" y="4231758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89" name="TextBox 88">
                    <a:extLst>
                      <a:ext uri="{FF2B5EF4-FFF2-40B4-BE49-F238E27FC236}">
                        <a16:creationId xmlns:a16="http://schemas.microsoft.com/office/drawing/2014/main" id="{6EE925F3-4D43-0620-28EC-9A7A0391AE85}"/>
                      </a:ext>
                    </a:extLst>
                  </p:cNvPr>
                  <p:cNvSpPr txBox="1"/>
                  <p:nvPr/>
                </p:nvSpPr>
                <p:spPr>
                  <a:xfrm>
                    <a:off x="1311935" y="4237508"/>
                    <a:ext cx="35611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</p:grpSp>
            <p:graphicFrame>
              <p:nvGraphicFramePr>
                <p:cNvPr id="92" name="Object 91">
                  <a:extLst>
                    <a:ext uri="{FF2B5EF4-FFF2-40B4-BE49-F238E27FC236}">
                      <a16:creationId xmlns:a16="http://schemas.microsoft.com/office/drawing/2014/main" id="{CAA02892-18BB-B61F-522F-6090B155E57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447810899"/>
                    </p:ext>
                  </p:extLst>
                </p:nvPr>
              </p:nvGraphicFramePr>
              <p:xfrm>
                <a:off x="2459033" y="2969454"/>
                <a:ext cx="1035834" cy="13716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28" imgW="1729012" imgH="2289859" progId="Prism9.Document">
                        <p:embed/>
                      </p:oleObj>
                    </mc:Choice>
                    <mc:Fallback>
                      <p:oleObj name="Prism 9" r:id="rId28" imgW="1729012" imgH="2289859" progId="Prism9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459033" y="2969454"/>
                              <a:ext cx="1035834" cy="13716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2B13A484-F72F-22A8-32E7-B7B5E27198C7}"/>
                    </a:ext>
                  </a:extLst>
                </p:cNvPr>
                <p:cNvSpPr txBox="1"/>
                <p:nvPr/>
              </p:nvSpPr>
              <p:spPr>
                <a:xfrm>
                  <a:off x="2761140" y="2867917"/>
                  <a:ext cx="7337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err="1"/>
                    <a:t>B.Ar</a:t>
                  </a:r>
                  <a:r>
                    <a:rPr lang="en-US" sz="1000" dirty="0"/>
                    <a:t>/</a:t>
                  </a:r>
                  <a:r>
                    <a:rPr lang="en-US" sz="1000" dirty="0" err="1"/>
                    <a:t>T.Ar</a:t>
                  </a:r>
                  <a:endParaRPr lang="en-US" sz="1000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215296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Group 93">
            <a:extLst>
              <a:ext uri="{FF2B5EF4-FFF2-40B4-BE49-F238E27FC236}">
                <a16:creationId xmlns:a16="http://schemas.microsoft.com/office/drawing/2014/main" id="{A22174F6-8FD1-1510-F6FD-8342F779CD66}"/>
              </a:ext>
            </a:extLst>
          </p:cNvPr>
          <p:cNvGrpSpPr/>
          <p:nvPr/>
        </p:nvGrpSpPr>
        <p:grpSpPr>
          <a:xfrm>
            <a:off x="394420" y="285499"/>
            <a:ext cx="6252863" cy="8427261"/>
            <a:chOff x="394420" y="285499"/>
            <a:chExt cx="6252863" cy="8427261"/>
          </a:xfrm>
        </p:grpSpPr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96DADC81-02C1-5D40-AA73-1EEF2CB13EFD}"/>
                </a:ext>
              </a:extLst>
            </p:cNvPr>
            <p:cNvSpPr txBox="1"/>
            <p:nvPr/>
          </p:nvSpPr>
          <p:spPr>
            <a:xfrm>
              <a:off x="394420" y="7881763"/>
              <a:ext cx="614481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3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obal and osteocyte specific deletion of PPA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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sulted in increased locomotion in 5-6 months old males (A) but female (B) mice.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aging, males were still more active (C), while females activity decreases (D). n=4 per group * p&lt;0.05, ** p&lt;0.01, *** p&lt;0.001  </a:t>
              </a:r>
            </a:p>
          </p:txBody>
        </p: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7E3A003B-8BA0-2188-00F6-F1ABA7FA7F13}"/>
                </a:ext>
              </a:extLst>
            </p:cNvPr>
            <p:cNvGrpSpPr/>
            <p:nvPr/>
          </p:nvGrpSpPr>
          <p:grpSpPr>
            <a:xfrm>
              <a:off x="440970" y="285499"/>
              <a:ext cx="6206313" cy="7361293"/>
              <a:chOff x="632364" y="285499"/>
              <a:chExt cx="6206313" cy="7361293"/>
            </a:xfrm>
          </p:grpSpPr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E9AF7734-C44E-4FFF-9BC1-B1C87EBA66A9}"/>
                  </a:ext>
                </a:extLst>
              </p:cNvPr>
              <p:cNvSpPr txBox="1"/>
              <p:nvPr/>
            </p:nvSpPr>
            <p:spPr>
              <a:xfrm>
                <a:off x="632364" y="285499"/>
                <a:ext cx="1355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104" name="Group 103">
                <a:extLst>
                  <a:ext uri="{FF2B5EF4-FFF2-40B4-BE49-F238E27FC236}">
                    <a16:creationId xmlns:a16="http://schemas.microsoft.com/office/drawing/2014/main" id="{A271001A-CA83-9242-4F67-87DDD93BB80E}"/>
                  </a:ext>
                </a:extLst>
              </p:cNvPr>
              <p:cNvGrpSpPr/>
              <p:nvPr/>
            </p:nvGrpSpPr>
            <p:grpSpPr>
              <a:xfrm>
                <a:off x="700161" y="507337"/>
                <a:ext cx="5503886" cy="2254137"/>
                <a:chOff x="700161" y="926437"/>
                <a:chExt cx="5503886" cy="2254137"/>
              </a:xfrm>
            </p:grpSpPr>
            <p:graphicFrame>
              <p:nvGraphicFramePr>
                <p:cNvPr id="191" name="Object 190">
                  <a:extLst>
                    <a:ext uri="{FF2B5EF4-FFF2-40B4-BE49-F238E27FC236}">
                      <a16:creationId xmlns:a16="http://schemas.microsoft.com/office/drawing/2014/main" id="{8898112A-962E-46E6-B6D0-B2B81ADFACC1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322873867"/>
                    </p:ext>
                  </p:extLst>
                </p:nvPr>
              </p:nvGraphicFramePr>
              <p:xfrm>
                <a:off x="4672909" y="1490168"/>
                <a:ext cx="1017588" cy="138906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2" imgW="2542918" imgH="3476207" progId="Prism8.Document">
                        <p:embed/>
                      </p:oleObj>
                    </mc:Choice>
                    <mc:Fallback>
                      <p:oleObj name="Prism 8" r:id="rId2" imgW="2542918" imgH="3476207" progId="Prism8.Document">
                        <p:embed/>
                        <p:pic>
                          <p:nvPicPr>
                            <p:cNvPr id="191" name="Object 190">
                              <a:extLst>
                                <a:ext uri="{FF2B5EF4-FFF2-40B4-BE49-F238E27FC236}">
                                  <a16:creationId xmlns:a16="http://schemas.microsoft.com/office/drawing/2014/main" id="{8898112A-962E-46E6-B6D0-B2B81ADFACC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672909" y="1490168"/>
                              <a:ext cx="1017588" cy="1389062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90" name="Object 189">
                  <a:extLst>
                    <a:ext uri="{FF2B5EF4-FFF2-40B4-BE49-F238E27FC236}">
                      <a16:creationId xmlns:a16="http://schemas.microsoft.com/office/drawing/2014/main" id="{340EA72B-6C65-4102-91C5-0FC7B652AFB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42474780"/>
                    </p:ext>
                  </p:extLst>
                </p:nvPr>
              </p:nvGraphicFramePr>
              <p:xfrm>
                <a:off x="2042513" y="1486990"/>
                <a:ext cx="1016000" cy="138906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4" imgW="2542918" imgH="3476207" progId="Prism8.Document">
                        <p:embed/>
                      </p:oleObj>
                    </mc:Choice>
                    <mc:Fallback>
                      <p:oleObj name="Prism 8" r:id="rId4" imgW="2542918" imgH="3476207" progId="Prism8.Document">
                        <p:embed/>
                        <p:pic>
                          <p:nvPicPr>
                            <p:cNvPr id="190" name="Object 189">
                              <a:extLst>
                                <a:ext uri="{FF2B5EF4-FFF2-40B4-BE49-F238E27FC236}">
                                  <a16:creationId xmlns:a16="http://schemas.microsoft.com/office/drawing/2014/main" id="{340EA72B-6C65-4102-91C5-0FC7B652AFB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042513" y="1486990"/>
                              <a:ext cx="1016000" cy="1389062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888FF9C2-0015-43FC-8759-12C4CE14006C}"/>
                    </a:ext>
                  </a:extLst>
                </p:cNvPr>
                <p:cNvSpPr txBox="1"/>
                <p:nvPr/>
              </p:nvSpPr>
              <p:spPr>
                <a:xfrm>
                  <a:off x="2012403" y="926437"/>
                  <a:ext cx="317165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comotion of 5-6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old 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  <a:sym typeface="Symbol" pitchFamily="2" charset="2"/>
                    </a:rPr>
                    <a:t></a:t>
                  </a:r>
                  <a:r>
                    <a:rPr lang="en-US" sz="10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and 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  <a:sym typeface="Symbol" pitchFamily="2" charset="2"/>
                    </a:rPr>
                    <a:t>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T</a:t>
                  </a:r>
                  <a:r>
                    <a:rPr lang="en-US" sz="10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ales</a:t>
                  </a:r>
                </a:p>
              </p:txBody>
            </p:sp>
            <p:grpSp>
              <p:nvGrpSpPr>
                <p:cNvPr id="47" name="Group 46">
                  <a:extLst>
                    <a:ext uri="{FF2B5EF4-FFF2-40B4-BE49-F238E27FC236}">
                      <a16:creationId xmlns:a16="http://schemas.microsoft.com/office/drawing/2014/main" id="{BCBA9FA4-E476-4517-81ED-116E99E0D01A}"/>
                    </a:ext>
                  </a:extLst>
                </p:cNvPr>
                <p:cNvGrpSpPr/>
                <p:nvPr/>
              </p:nvGrpSpPr>
              <p:grpSpPr>
                <a:xfrm>
                  <a:off x="700161" y="1327942"/>
                  <a:ext cx="1731053" cy="1785453"/>
                  <a:chOff x="2626504" y="4044511"/>
                  <a:chExt cx="1731053" cy="1785453"/>
                </a:xfrm>
              </p:grpSpPr>
              <p:graphicFrame>
                <p:nvGraphicFramePr>
                  <p:cNvPr id="48" name="Object 47">
                    <a:extLst>
                      <a:ext uri="{FF2B5EF4-FFF2-40B4-BE49-F238E27FC236}">
                        <a16:creationId xmlns:a16="http://schemas.microsoft.com/office/drawing/2014/main" id="{A7BE86EE-E346-4A2E-91E1-E3C1BF6CA627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2763854" y="4213089"/>
                  <a:ext cx="1116013" cy="1389062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8" r:id="rId6" imgW="2794653" imgH="3476207" progId="Prism8.Document">
                          <p:embed/>
                        </p:oleObj>
                      </mc:Choice>
                      <mc:Fallback>
                        <p:oleObj name="Prism 8" r:id="rId6" imgW="2794653" imgH="3476207" progId="Prism8.Document">
                          <p:embed/>
                          <p:pic>
                            <p:nvPicPr>
                              <p:cNvPr id="48" name="Object 47">
                                <a:extLst>
                                  <a:ext uri="{FF2B5EF4-FFF2-40B4-BE49-F238E27FC236}">
                                    <a16:creationId xmlns:a16="http://schemas.microsoft.com/office/drawing/2014/main" id="{A7BE86EE-E346-4A2E-91E1-E3C1BF6CA627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7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763854" y="4213089"/>
                                <a:ext cx="1116013" cy="1389062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49" name="TextBox 48">
                    <a:extLst>
                      <a:ext uri="{FF2B5EF4-FFF2-40B4-BE49-F238E27FC236}">
                        <a16:creationId xmlns:a16="http://schemas.microsoft.com/office/drawing/2014/main" id="{734C7649-5DDD-42A9-874E-BAE82534D7C1}"/>
                      </a:ext>
                    </a:extLst>
                  </p:cNvPr>
                  <p:cNvSpPr txBox="1"/>
                  <p:nvPr/>
                </p:nvSpPr>
                <p:spPr>
                  <a:xfrm>
                    <a:off x="3018920" y="5604475"/>
                    <a:ext cx="96717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cs typeface="Arial" panose="020B0604020202020204" pitchFamily="34" charset="0"/>
                      </a:rPr>
                      <a:t>Day</a:t>
                    </a:r>
                    <a:endParaRPr lang="en-US" sz="799" dirty="0"/>
                  </a:p>
                </p:txBody>
              </p:sp>
              <p:cxnSp>
                <p:nvCxnSpPr>
                  <p:cNvPr id="50" name="Straight Connector 49">
                    <a:extLst>
                      <a:ext uri="{FF2B5EF4-FFF2-40B4-BE49-F238E27FC236}">
                        <a16:creationId xmlns:a16="http://schemas.microsoft.com/office/drawing/2014/main" id="{24C5A173-2023-4D6B-AC5F-226CCD7D33A6}"/>
                      </a:ext>
                    </a:extLst>
                  </p:cNvPr>
                  <p:cNvCxnSpPr/>
                  <p:nvPr/>
                </p:nvCxnSpPr>
                <p:spPr>
                  <a:xfrm>
                    <a:off x="3051711" y="5629523"/>
                    <a:ext cx="29456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Straight Connector 50">
                    <a:extLst>
                      <a:ext uri="{FF2B5EF4-FFF2-40B4-BE49-F238E27FC236}">
                        <a16:creationId xmlns:a16="http://schemas.microsoft.com/office/drawing/2014/main" id="{3DA423C2-94AB-41C0-81CC-8251AFFAE121}"/>
                      </a:ext>
                    </a:extLst>
                  </p:cNvPr>
                  <p:cNvCxnSpPr/>
                  <p:nvPr/>
                </p:nvCxnSpPr>
                <p:spPr>
                  <a:xfrm>
                    <a:off x="3423134" y="5629523"/>
                    <a:ext cx="29456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EBC93EF1-20EA-4DAF-B4CD-7D197E0B8756}"/>
                      </a:ext>
                    </a:extLst>
                  </p:cNvPr>
                  <p:cNvSpPr txBox="1"/>
                  <p:nvPr/>
                </p:nvSpPr>
                <p:spPr>
                  <a:xfrm>
                    <a:off x="2765391" y="4044511"/>
                    <a:ext cx="127503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X Activity</a:t>
                    </a: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F2EF6C5E-088C-4FBD-875C-493B89A41DBE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29915" y="4634562"/>
                    <a:ext cx="120849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X Activity (Events/hr)</a:t>
                    </a:r>
                    <a:endParaRPr lang="en-US" sz="799" baseline="30000" dirty="0"/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048ECC9A-82DB-445D-BDDD-9C62BD82420D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2954227" y="5402924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6D053F72-3F07-489F-8FA2-ADF86377CE28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3310964" y="5402907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CBC9529A-42E5-45B9-AA65-D5C0E729FAFE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3480377" y="5394781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53AEB260-BDCA-4BCB-81D4-913998A41607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3126405" y="5391904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36A3A6C6-51E5-4C79-9C67-452C3AA2A6B4}"/>
                      </a:ext>
                    </a:extLst>
                  </p:cNvPr>
                  <p:cNvSpPr txBox="1"/>
                  <p:nvPr/>
                </p:nvSpPr>
                <p:spPr>
                  <a:xfrm>
                    <a:off x="3390384" y="5614649"/>
                    <a:ext cx="96717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cs typeface="Arial" panose="020B0604020202020204" pitchFamily="34" charset="0"/>
                      </a:rPr>
                      <a:t>Night</a:t>
                    </a:r>
                    <a:endParaRPr lang="en-US" sz="799" dirty="0"/>
                  </a:p>
                </p:txBody>
              </p:sp>
            </p:grpSp>
            <p:grpSp>
              <p:nvGrpSpPr>
                <p:cNvPr id="74" name="Group 73">
                  <a:extLst>
                    <a:ext uri="{FF2B5EF4-FFF2-40B4-BE49-F238E27FC236}">
                      <a16:creationId xmlns:a16="http://schemas.microsoft.com/office/drawing/2014/main" id="{D3F88130-C065-4D81-BD18-EF7ED51AC7A7}"/>
                    </a:ext>
                  </a:extLst>
                </p:cNvPr>
                <p:cNvGrpSpPr/>
                <p:nvPr/>
              </p:nvGrpSpPr>
              <p:grpSpPr>
                <a:xfrm>
                  <a:off x="3311956" y="1337612"/>
                  <a:ext cx="1692080" cy="1773072"/>
                  <a:chOff x="3866040" y="3029658"/>
                  <a:chExt cx="1692080" cy="1773072"/>
                </a:xfrm>
              </p:grpSpPr>
              <p:graphicFrame>
                <p:nvGraphicFramePr>
                  <p:cNvPr id="75" name="Object 74">
                    <a:extLst>
                      <a:ext uri="{FF2B5EF4-FFF2-40B4-BE49-F238E27FC236}">
                        <a16:creationId xmlns:a16="http://schemas.microsoft.com/office/drawing/2014/main" id="{C9889ED9-2651-4B9D-80D5-3E9297E802D4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3998268" y="3185389"/>
                  <a:ext cx="1074738" cy="1389062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8" r:id="rId8" imgW="2684812" imgH="3476207" progId="Prism8.Document">
                          <p:embed/>
                        </p:oleObj>
                      </mc:Choice>
                      <mc:Fallback>
                        <p:oleObj name="Prism 8" r:id="rId8" imgW="2684812" imgH="3476207" progId="Prism8.Document">
                          <p:embed/>
                          <p:pic>
                            <p:nvPicPr>
                              <p:cNvPr id="75" name="Object 74">
                                <a:extLst>
                                  <a:ext uri="{FF2B5EF4-FFF2-40B4-BE49-F238E27FC236}">
                                    <a16:creationId xmlns:a16="http://schemas.microsoft.com/office/drawing/2014/main" id="{C9889ED9-2651-4B9D-80D5-3E9297E802D4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9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3998268" y="3185389"/>
                                <a:ext cx="1074738" cy="1389062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sp>
                <p:nvSpPr>
                  <p:cNvPr id="76" name="TextBox 75">
                    <a:extLst>
                      <a:ext uri="{FF2B5EF4-FFF2-40B4-BE49-F238E27FC236}">
                        <a16:creationId xmlns:a16="http://schemas.microsoft.com/office/drawing/2014/main" id="{D830D3FF-977A-4130-A7E2-1C300ABE0C21}"/>
                      </a:ext>
                    </a:extLst>
                  </p:cNvPr>
                  <p:cNvSpPr txBox="1"/>
                  <p:nvPr/>
                </p:nvSpPr>
                <p:spPr>
                  <a:xfrm>
                    <a:off x="4232809" y="4576389"/>
                    <a:ext cx="96717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cs typeface="Arial" panose="020B0604020202020204" pitchFamily="34" charset="0"/>
                      </a:rPr>
                      <a:t>Day</a:t>
                    </a:r>
                    <a:endParaRPr lang="en-US" sz="799" dirty="0"/>
                  </a:p>
                </p:txBody>
              </p:sp>
              <p:cxnSp>
                <p:nvCxnSpPr>
                  <p:cNvPr id="77" name="Straight Connector 76">
                    <a:extLst>
                      <a:ext uri="{FF2B5EF4-FFF2-40B4-BE49-F238E27FC236}">
                        <a16:creationId xmlns:a16="http://schemas.microsoft.com/office/drawing/2014/main" id="{7E362544-D38B-4493-BAE4-6F44B0339786}"/>
                      </a:ext>
                    </a:extLst>
                  </p:cNvPr>
                  <p:cNvCxnSpPr/>
                  <p:nvPr/>
                </p:nvCxnSpPr>
                <p:spPr>
                  <a:xfrm>
                    <a:off x="4265600" y="4601436"/>
                    <a:ext cx="29456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8" name="Straight Connector 77">
                    <a:extLst>
                      <a:ext uri="{FF2B5EF4-FFF2-40B4-BE49-F238E27FC236}">
                        <a16:creationId xmlns:a16="http://schemas.microsoft.com/office/drawing/2014/main" id="{CFE9EB0F-E508-4D91-9AC1-FE9CF42CB638}"/>
                      </a:ext>
                    </a:extLst>
                  </p:cNvPr>
                  <p:cNvCxnSpPr/>
                  <p:nvPr/>
                </p:nvCxnSpPr>
                <p:spPr>
                  <a:xfrm>
                    <a:off x="4637023" y="4601436"/>
                    <a:ext cx="29456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2D10BD01-0A34-4633-831A-47A450E5AA1D}"/>
                      </a:ext>
                    </a:extLst>
                  </p:cNvPr>
                  <p:cNvSpPr txBox="1"/>
                  <p:nvPr/>
                </p:nvSpPr>
                <p:spPr>
                  <a:xfrm>
                    <a:off x="3953113" y="3029658"/>
                    <a:ext cx="127503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Z Activity</a:t>
                    </a:r>
                  </a:p>
                </p:txBody>
              </p:sp>
              <p:sp>
                <p:nvSpPr>
                  <p:cNvPr id="80" name="TextBox 79">
                    <a:extLst>
                      <a:ext uri="{FF2B5EF4-FFF2-40B4-BE49-F238E27FC236}">
                        <a16:creationId xmlns:a16="http://schemas.microsoft.com/office/drawing/2014/main" id="{77CDD8BF-3C8C-4D84-BE08-7A51D623964A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4168116" y="4374837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81" name="TextBox 80">
                    <a:extLst>
                      <a:ext uri="{FF2B5EF4-FFF2-40B4-BE49-F238E27FC236}">
                        <a16:creationId xmlns:a16="http://schemas.microsoft.com/office/drawing/2014/main" id="{497F29FB-D1E2-4BA8-923D-9D4C9EC763D0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4524853" y="4374820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82" name="TextBox 81">
                    <a:extLst>
                      <a:ext uri="{FF2B5EF4-FFF2-40B4-BE49-F238E27FC236}">
                        <a16:creationId xmlns:a16="http://schemas.microsoft.com/office/drawing/2014/main" id="{ACFAEE7A-231F-4BCC-B8D3-4842FB27A562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4694266" y="4366694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20346D0A-F41E-4020-A038-7E2CA783FAB4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4340295" y="4363817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BD87E62D-34D1-4DDE-B98B-5D28D6B173BE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369451" y="3645762"/>
                    <a:ext cx="120849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Z Activity (Events/hr)</a:t>
                    </a:r>
                    <a:endParaRPr lang="en-US" sz="799" baseline="30000" dirty="0"/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7914FF69-DED4-4F88-8C5F-5E6BDD52969E}"/>
                      </a:ext>
                    </a:extLst>
                  </p:cNvPr>
                  <p:cNvSpPr txBox="1"/>
                  <p:nvPr/>
                </p:nvSpPr>
                <p:spPr>
                  <a:xfrm>
                    <a:off x="4590947" y="4587415"/>
                    <a:ext cx="96717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cs typeface="Arial" panose="020B0604020202020204" pitchFamily="34" charset="0"/>
                      </a:rPr>
                      <a:t>Night</a:t>
                    </a:r>
                    <a:endParaRPr lang="en-US" sz="799" dirty="0"/>
                  </a:p>
                </p:txBody>
              </p:sp>
            </p:grpSp>
            <p:grpSp>
              <p:nvGrpSpPr>
                <p:cNvPr id="139" name="Group 138">
                  <a:extLst>
                    <a:ext uri="{FF2B5EF4-FFF2-40B4-BE49-F238E27FC236}">
                      <a16:creationId xmlns:a16="http://schemas.microsoft.com/office/drawing/2014/main" id="{CB84FC21-2227-4958-9F7E-C382E9DEEC6F}"/>
                    </a:ext>
                  </a:extLst>
                </p:cNvPr>
                <p:cNvGrpSpPr/>
                <p:nvPr/>
              </p:nvGrpSpPr>
              <p:grpSpPr>
                <a:xfrm>
                  <a:off x="1886599" y="1334471"/>
                  <a:ext cx="1731053" cy="1826713"/>
                  <a:chOff x="2612073" y="2971569"/>
                  <a:chExt cx="1731053" cy="1826713"/>
                </a:xfrm>
              </p:grpSpPr>
              <p:sp>
                <p:nvSpPr>
                  <p:cNvPr id="140" name="TextBox 139">
                    <a:extLst>
                      <a:ext uri="{FF2B5EF4-FFF2-40B4-BE49-F238E27FC236}">
                        <a16:creationId xmlns:a16="http://schemas.microsoft.com/office/drawing/2014/main" id="{31CA6903-CD70-46DC-9FF9-BECFF3553E59}"/>
                      </a:ext>
                    </a:extLst>
                  </p:cNvPr>
                  <p:cNvSpPr txBox="1"/>
                  <p:nvPr/>
                </p:nvSpPr>
                <p:spPr>
                  <a:xfrm>
                    <a:off x="3004489" y="4572793"/>
                    <a:ext cx="96717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cs typeface="Arial" panose="020B0604020202020204" pitchFamily="34" charset="0"/>
                      </a:rPr>
                      <a:t>Day</a:t>
                    </a:r>
                    <a:endParaRPr lang="en-US" sz="799" dirty="0"/>
                  </a:p>
                </p:txBody>
              </p:sp>
              <p:cxnSp>
                <p:nvCxnSpPr>
                  <p:cNvPr id="141" name="Straight Connector 140">
                    <a:extLst>
                      <a:ext uri="{FF2B5EF4-FFF2-40B4-BE49-F238E27FC236}">
                        <a16:creationId xmlns:a16="http://schemas.microsoft.com/office/drawing/2014/main" id="{2852A931-225D-410C-A043-D099A988E1DD}"/>
                      </a:ext>
                    </a:extLst>
                  </p:cNvPr>
                  <p:cNvCxnSpPr/>
                  <p:nvPr/>
                </p:nvCxnSpPr>
                <p:spPr>
                  <a:xfrm>
                    <a:off x="3037280" y="4597841"/>
                    <a:ext cx="29456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" name="Straight Connector 141">
                    <a:extLst>
                      <a:ext uri="{FF2B5EF4-FFF2-40B4-BE49-F238E27FC236}">
                        <a16:creationId xmlns:a16="http://schemas.microsoft.com/office/drawing/2014/main" id="{86D1E337-7586-4D10-9BDF-FE5654B5EBF9}"/>
                      </a:ext>
                    </a:extLst>
                  </p:cNvPr>
                  <p:cNvCxnSpPr/>
                  <p:nvPr/>
                </p:nvCxnSpPr>
                <p:spPr>
                  <a:xfrm>
                    <a:off x="3408703" y="4597841"/>
                    <a:ext cx="29456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3" name="TextBox 142">
                    <a:extLst>
                      <a:ext uri="{FF2B5EF4-FFF2-40B4-BE49-F238E27FC236}">
                        <a16:creationId xmlns:a16="http://schemas.microsoft.com/office/drawing/2014/main" id="{37F39CE5-BE97-404E-AEC3-88E09B1B0B9F}"/>
                      </a:ext>
                    </a:extLst>
                  </p:cNvPr>
                  <p:cNvSpPr txBox="1"/>
                  <p:nvPr/>
                </p:nvSpPr>
                <p:spPr>
                  <a:xfrm>
                    <a:off x="2737877" y="2971569"/>
                    <a:ext cx="127503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X Activity</a:t>
                    </a:r>
                  </a:p>
                </p:txBody>
              </p:sp>
              <p:sp>
                <p:nvSpPr>
                  <p:cNvPr id="144" name="TextBox 143">
                    <a:extLst>
                      <a:ext uri="{FF2B5EF4-FFF2-40B4-BE49-F238E27FC236}">
                        <a16:creationId xmlns:a16="http://schemas.microsoft.com/office/drawing/2014/main" id="{3BC0EA7B-7147-44E2-B888-9D00016A6A7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15484" y="3602880"/>
                    <a:ext cx="120849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X Activity (Events/hr)</a:t>
                    </a:r>
                    <a:endParaRPr lang="en-US" sz="799" baseline="30000" dirty="0"/>
                  </a:p>
                </p:txBody>
              </p:sp>
              <p:sp>
                <p:nvSpPr>
                  <p:cNvPr id="145" name="TextBox 144">
                    <a:extLst>
                      <a:ext uri="{FF2B5EF4-FFF2-40B4-BE49-F238E27FC236}">
                        <a16:creationId xmlns:a16="http://schemas.microsoft.com/office/drawing/2014/main" id="{572F2CEF-EAB4-4B2A-8A66-090A2960D3CE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2939796" y="4371242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146" name="TextBox 145">
                    <a:extLst>
                      <a:ext uri="{FF2B5EF4-FFF2-40B4-BE49-F238E27FC236}">
                        <a16:creationId xmlns:a16="http://schemas.microsoft.com/office/drawing/2014/main" id="{2F855646-8893-443B-A08B-96927C9A31D8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3296533" y="4371225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147" name="TextBox 146">
                    <a:extLst>
                      <a:ext uri="{FF2B5EF4-FFF2-40B4-BE49-F238E27FC236}">
                        <a16:creationId xmlns:a16="http://schemas.microsoft.com/office/drawing/2014/main" id="{4A90E302-0097-4672-936C-D0FFC66281FD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3415087" y="4321588"/>
                    <a:ext cx="575551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OT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  <p:sp>
                <p:nvSpPr>
                  <p:cNvPr id="148" name="TextBox 147">
                    <a:extLst>
                      <a:ext uri="{FF2B5EF4-FFF2-40B4-BE49-F238E27FC236}">
                        <a16:creationId xmlns:a16="http://schemas.microsoft.com/office/drawing/2014/main" id="{9351FBDD-7287-49DA-976E-865C0AAE7152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3067318" y="4338488"/>
                    <a:ext cx="50629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OT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  <p:sp>
                <p:nvSpPr>
                  <p:cNvPr id="149" name="TextBox 148">
                    <a:extLst>
                      <a:ext uri="{FF2B5EF4-FFF2-40B4-BE49-F238E27FC236}">
                        <a16:creationId xmlns:a16="http://schemas.microsoft.com/office/drawing/2014/main" id="{098B1A9A-6905-4239-A164-332FDAB3084A}"/>
                      </a:ext>
                    </a:extLst>
                  </p:cNvPr>
                  <p:cNvSpPr txBox="1"/>
                  <p:nvPr/>
                </p:nvSpPr>
                <p:spPr>
                  <a:xfrm>
                    <a:off x="3375953" y="4582967"/>
                    <a:ext cx="96717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cs typeface="Arial" panose="020B0604020202020204" pitchFamily="34" charset="0"/>
                      </a:rPr>
                      <a:t>Night</a:t>
                    </a:r>
                    <a:endParaRPr lang="en-US" sz="799" dirty="0"/>
                  </a:p>
                </p:txBody>
              </p:sp>
            </p:grpSp>
            <p:grpSp>
              <p:nvGrpSpPr>
                <p:cNvPr id="151" name="Group 150">
                  <a:extLst>
                    <a:ext uri="{FF2B5EF4-FFF2-40B4-BE49-F238E27FC236}">
                      <a16:creationId xmlns:a16="http://schemas.microsoft.com/office/drawing/2014/main" id="{212A144A-93BE-495A-AE08-AD0C96A53E7B}"/>
                    </a:ext>
                  </a:extLst>
                </p:cNvPr>
                <p:cNvGrpSpPr/>
                <p:nvPr/>
              </p:nvGrpSpPr>
              <p:grpSpPr>
                <a:xfrm>
                  <a:off x="4511967" y="1333538"/>
                  <a:ext cx="1692080" cy="1847036"/>
                  <a:chOff x="3866040" y="2955694"/>
                  <a:chExt cx="1692080" cy="1847036"/>
                </a:xfrm>
              </p:grpSpPr>
              <p:sp>
                <p:nvSpPr>
                  <p:cNvPr id="152" name="TextBox 151">
                    <a:extLst>
                      <a:ext uri="{FF2B5EF4-FFF2-40B4-BE49-F238E27FC236}">
                        <a16:creationId xmlns:a16="http://schemas.microsoft.com/office/drawing/2014/main" id="{FEC49A07-AC77-481F-A9AC-69149421A618}"/>
                      </a:ext>
                    </a:extLst>
                  </p:cNvPr>
                  <p:cNvSpPr txBox="1"/>
                  <p:nvPr/>
                </p:nvSpPr>
                <p:spPr>
                  <a:xfrm>
                    <a:off x="4232809" y="4576389"/>
                    <a:ext cx="96717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cs typeface="Arial" panose="020B0604020202020204" pitchFamily="34" charset="0"/>
                      </a:rPr>
                      <a:t>Day</a:t>
                    </a:r>
                    <a:endParaRPr lang="en-US" sz="799" dirty="0"/>
                  </a:p>
                </p:txBody>
              </p:sp>
              <p:cxnSp>
                <p:nvCxnSpPr>
                  <p:cNvPr id="153" name="Straight Connector 152">
                    <a:extLst>
                      <a:ext uri="{FF2B5EF4-FFF2-40B4-BE49-F238E27FC236}">
                        <a16:creationId xmlns:a16="http://schemas.microsoft.com/office/drawing/2014/main" id="{C7889F89-4011-4171-8E1A-2ECBBF3F5E1E}"/>
                      </a:ext>
                    </a:extLst>
                  </p:cNvPr>
                  <p:cNvCxnSpPr/>
                  <p:nvPr/>
                </p:nvCxnSpPr>
                <p:spPr>
                  <a:xfrm>
                    <a:off x="4265600" y="4601436"/>
                    <a:ext cx="29456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4" name="Straight Connector 153">
                    <a:extLst>
                      <a:ext uri="{FF2B5EF4-FFF2-40B4-BE49-F238E27FC236}">
                        <a16:creationId xmlns:a16="http://schemas.microsoft.com/office/drawing/2014/main" id="{EC1B5B29-911E-4130-A812-785B05EE8591}"/>
                      </a:ext>
                    </a:extLst>
                  </p:cNvPr>
                  <p:cNvCxnSpPr/>
                  <p:nvPr/>
                </p:nvCxnSpPr>
                <p:spPr>
                  <a:xfrm>
                    <a:off x="4637023" y="4601436"/>
                    <a:ext cx="29456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5" name="TextBox 154">
                    <a:extLst>
                      <a:ext uri="{FF2B5EF4-FFF2-40B4-BE49-F238E27FC236}">
                        <a16:creationId xmlns:a16="http://schemas.microsoft.com/office/drawing/2014/main" id="{9FDA8197-DA8D-48D6-961C-72A089FDE525}"/>
                      </a:ext>
                    </a:extLst>
                  </p:cNvPr>
                  <p:cNvSpPr txBox="1"/>
                  <p:nvPr/>
                </p:nvSpPr>
                <p:spPr>
                  <a:xfrm>
                    <a:off x="3966561" y="2955694"/>
                    <a:ext cx="1275037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dirty="0"/>
                      <a:t>Z Activity</a:t>
                    </a:r>
                  </a:p>
                </p:txBody>
              </p:sp>
              <p:sp>
                <p:nvSpPr>
                  <p:cNvPr id="156" name="TextBox 155">
                    <a:extLst>
                      <a:ext uri="{FF2B5EF4-FFF2-40B4-BE49-F238E27FC236}">
                        <a16:creationId xmlns:a16="http://schemas.microsoft.com/office/drawing/2014/main" id="{A0765A19-CA29-427F-8611-DF11AF61B644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4168116" y="4374837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157" name="TextBox 156">
                    <a:extLst>
                      <a:ext uri="{FF2B5EF4-FFF2-40B4-BE49-F238E27FC236}">
                        <a16:creationId xmlns:a16="http://schemas.microsoft.com/office/drawing/2014/main" id="{5C3249DE-9D2A-4648-9D3C-04E378250E24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4524853" y="4374820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158" name="TextBox 157">
                    <a:extLst>
                      <a:ext uri="{FF2B5EF4-FFF2-40B4-BE49-F238E27FC236}">
                        <a16:creationId xmlns:a16="http://schemas.microsoft.com/office/drawing/2014/main" id="{D1B92EC5-9F97-40F6-9BC8-088504E8A353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4648447" y="4341250"/>
                    <a:ext cx="519284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OT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  <p:sp>
                <p:nvSpPr>
                  <p:cNvPr id="159" name="TextBox 158">
                    <a:extLst>
                      <a:ext uri="{FF2B5EF4-FFF2-40B4-BE49-F238E27FC236}">
                        <a16:creationId xmlns:a16="http://schemas.microsoft.com/office/drawing/2014/main" id="{EC182A7B-7749-4206-A159-DD143379E428}"/>
                      </a:ext>
                    </a:extLst>
                  </p:cNvPr>
                  <p:cNvSpPr txBox="1"/>
                  <p:nvPr/>
                </p:nvSpPr>
                <p:spPr>
                  <a:xfrm rot="19510338">
                    <a:off x="4294662" y="4338968"/>
                    <a:ext cx="517201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OT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  <p:sp>
                <p:nvSpPr>
                  <p:cNvPr id="160" name="TextBox 159">
                    <a:extLst>
                      <a:ext uri="{FF2B5EF4-FFF2-40B4-BE49-F238E27FC236}">
                        <a16:creationId xmlns:a16="http://schemas.microsoft.com/office/drawing/2014/main" id="{1F9C86EB-DC64-4D62-B0C9-C7C29B48EC20}"/>
                      </a:ext>
                    </a:extLst>
                  </p:cNvPr>
                  <p:cNvSpPr txBox="1"/>
                  <p:nvPr/>
                </p:nvSpPr>
                <p:spPr>
                  <a:xfrm>
                    <a:off x="4590947" y="4587415"/>
                    <a:ext cx="96717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cs typeface="Arial" panose="020B0604020202020204" pitchFamily="34" charset="0"/>
                      </a:rPr>
                      <a:t>Night</a:t>
                    </a:r>
                    <a:endParaRPr lang="en-US" sz="799" dirty="0"/>
                  </a:p>
                </p:txBody>
              </p:sp>
              <p:sp>
                <p:nvSpPr>
                  <p:cNvPr id="161" name="TextBox 160">
                    <a:extLst>
                      <a:ext uri="{FF2B5EF4-FFF2-40B4-BE49-F238E27FC236}">
                        <a16:creationId xmlns:a16="http://schemas.microsoft.com/office/drawing/2014/main" id="{2B8992BA-DBEB-4C9E-9D4E-9413E5A6038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369451" y="3580451"/>
                    <a:ext cx="1208493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Z Activity (Events/hr)</a:t>
                    </a:r>
                    <a:endParaRPr lang="en-US" sz="799" baseline="30000" dirty="0"/>
                  </a:p>
                </p:txBody>
              </p:sp>
            </p:grpSp>
            <p:sp>
              <p:nvSpPr>
                <p:cNvPr id="215" name="TextBox 214">
                  <a:extLst>
                    <a:ext uri="{FF2B5EF4-FFF2-40B4-BE49-F238E27FC236}">
                      <a16:creationId xmlns:a16="http://schemas.microsoft.com/office/drawing/2014/main" id="{8FDDCB9B-4F80-44C8-8EC6-C7BE66E3F7DA}"/>
                    </a:ext>
                  </a:extLst>
                </p:cNvPr>
                <p:cNvSpPr txBox="1"/>
                <p:nvPr/>
              </p:nvSpPr>
              <p:spPr>
                <a:xfrm>
                  <a:off x="4145328" y="1580690"/>
                  <a:ext cx="3803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</a:t>
                  </a:r>
                </a:p>
              </p:txBody>
            </p:sp>
            <p:sp>
              <p:nvSpPr>
                <p:cNvPr id="216" name="TextBox 215">
                  <a:extLst>
                    <a:ext uri="{FF2B5EF4-FFF2-40B4-BE49-F238E27FC236}">
                      <a16:creationId xmlns:a16="http://schemas.microsoft.com/office/drawing/2014/main" id="{5BEDD304-D403-4C3E-A914-6F64DFC6C8C2}"/>
                    </a:ext>
                  </a:extLst>
                </p:cNvPr>
                <p:cNvSpPr txBox="1"/>
                <p:nvPr/>
              </p:nvSpPr>
              <p:spPr>
                <a:xfrm>
                  <a:off x="1583301" y="1627191"/>
                  <a:ext cx="3803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</a:t>
                  </a:r>
                </a:p>
              </p:txBody>
            </p:sp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5BC37DCB-25B1-4A27-90AA-C29B1E384E5E}"/>
                    </a:ext>
                  </a:extLst>
                </p:cNvPr>
                <p:cNvSpPr txBox="1"/>
                <p:nvPr/>
              </p:nvSpPr>
              <p:spPr>
                <a:xfrm>
                  <a:off x="2419133" y="2215745"/>
                  <a:ext cx="3803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</a:t>
                  </a:r>
                </a:p>
              </p:txBody>
            </p:sp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41C8DB3D-4107-4BEC-BB27-0C34518445F9}"/>
                    </a:ext>
                  </a:extLst>
                </p:cNvPr>
                <p:cNvSpPr txBox="1"/>
                <p:nvPr/>
              </p:nvSpPr>
              <p:spPr>
                <a:xfrm>
                  <a:off x="2733512" y="1552202"/>
                  <a:ext cx="3803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**</a:t>
                  </a:r>
                </a:p>
              </p:txBody>
            </p:sp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33FF6A57-C699-4459-9490-ECD9384D1D59}"/>
                    </a:ext>
                  </a:extLst>
                </p:cNvPr>
                <p:cNvSpPr txBox="1"/>
                <p:nvPr/>
              </p:nvSpPr>
              <p:spPr>
                <a:xfrm>
                  <a:off x="5392692" y="1507082"/>
                  <a:ext cx="3803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*</a:t>
                  </a:r>
                </a:p>
              </p:txBody>
            </p:sp>
          </p:grpSp>
          <p:grpSp>
            <p:nvGrpSpPr>
              <p:cNvPr id="182" name="Group 181">
                <a:extLst>
                  <a:ext uri="{FF2B5EF4-FFF2-40B4-BE49-F238E27FC236}">
                    <a16:creationId xmlns:a16="http://schemas.microsoft.com/office/drawing/2014/main" id="{F4343C4D-A3BC-72E5-4392-DDDC1DFD69A2}"/>
                  </a:ext>
                </a:extLst>
              </p:cNvPr>
              <p:cNvGrpSpPr/>
              <p:nvPr/>
            </p:nvGrpSpPr>
            <p:grpSpPr>
              <a:xfrm>
                <a:off x="632364" y="3059634"/>
                <a:ext cx="5639479" cy="2081744"/>
                <a:chOff x="632364" y="2602434"/>
                <a:chExt cx="5639479" cy="2081744"/>
              </a:xfrm>
            </p:grpSpPr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F70C5801-E0F6-73CA-25F1-5DD09407C1B6}"/>
                    </a:ext>
                  </a:extLst>
                </p:cNvPr>
                <p:cNvSpPr txBox="1"/>
                <p:nvPr/>
              </p:nvSpPr>
              <p:spPr>
                <a:xfrm>
                  <a:off x="632364" y="2602434"/>
                  <a:ext cx="13559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grpSp>
              <p:nvGrpSpPr>
                <p:cNvPr id="105" name="Group 104">
                  <a:extLst>
                    <a:ext uri="{FF2B5EF4-FFF2-40B4-BE49-F238E27FC236}">
                      <a16:creationId xmlns:a16="http://schemas.microsoft.com/office/drawing/2014/main" id="{FDF1EEB6-B4A8-AEF1-9DEA-32D27CBE43CA}"/>
                    </a:ext>
                  </a:extLst>
                </p:cNvPr>
                <p:cNvGrpSpPr/>
                <p:nvPr/>
              </p:nvGrpSpPr>
              <p:grpSpPr>
                <a:xfrm>
                  <a:off x="767957" y="2831546"/>
                  <a:ext cx="5503886" cy="1852632"/>
                  <a:chOff x="805627" y="1831200"/>
                  <a:chExt cx="5503886" cy="1852632"/>
                </a:xfrm>
              </p:grpSpPr>
              <p:graphicFrame>
                <p:nvGraphicFramePr>
                  <p:cNvPr id="106" name="Object 105">
                    <a:extLst>
                      <a:ext uri="{FF2B5EF4-FFF2-40B4-BE49-F238E27FC236}">
                        <a16:creationId xmlns:a16="http://schemas.microsoft.com/office/drawing/2014/main" id="{D6FED1B3-00F8-D6CC-A170-0659A8D66439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354200052"/>
                      </p:ext>
                    </p:extLst>
                  </p:nvPr>
                </p:nvGraphicFramePr>
                <p:xfrm>
                  <a:off x="2147979" y="1990248"/>
                  <a:ext cx="1016000" cy="1389062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8" r:id="rId10" imgW="2542918" imgH="3476207" progId="Prism8.Document">
                          <p:embed/>
                        </p:oleObj>
                      </mc:Choice>
                      <mc:Fallback>
                        <p:oleObj name="Prism 8" r:id="rId10" imgW="2542918" imgH="3476207" progId="Prism8.Document">
                          <p:embed/>
                          <p:pic>
                            <p:nvPicPr>
                              <p:cNvPr id="4" name="Object 3">
                                <a:extLst>
                                  <a:ext uri="{FF2B5EF4-FFF2-40B4-BE49-F238E27FC236}">
                                    <a16:creationId xmlns:a16="http://schemas.microsoft.com/office/drawing/2014/main" id="{EA54A27D-A0B1-2A59-7F17-16F74CBB9587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11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147979" y="1990248"/>
                                <a:ext cx="1016000" cy="1389062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aphicFrame>
                <p:nvGraphicFramePr>
                  <p:cNvPr id="107" name="Object 106">
                    <a:extLst>
                      <a:ext uri="{FF2B5EF4-FFF2-40B4-BE49-F238E27FC236}">
                        <a16:creationId xmlns:a16="http://schemas.microsoft.com/office/drawing/2014/main" id="{162DEB4E-60DF-B82E-D161-EEB9A8877CDF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222432905"/>
                      </p:ext>
                    </p:extLst>
                  </p:nvPr>
                </p:nvGraphicFramePr>
                <p:xfrm>
                  <a:off x="4800320" y="1993423"/>
                  <a:ext cx="973137" cy="1389062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8" r:id="rId12" imgW="2433077" imgH="3476207" progId="Prism8.Document">
                          <p:embed/>
                        </p:oleObj>
                      </mc:Choice>
                      <mc:Fallback>
                        <p:oleObj name="Prism 8" r:id="rId12" imgW="2433077" imgH="3476207" progId="Prism8.Document">
                          <p:embed/>
                          <p:pic>
                            <p:nvPicPr>
                              <p:cNvPr id="5" name="Object 4">
                                <a:extLst>
                                  <a:ext uri="{FF2B5EF4-FFF2-40B4-BE49-F238E27FC236}">
                                    <a16:creationId xmlns:a16="http://schemas.microsoft.com/office/drawing/2014/main" id="{EC90380F-FC22-5004-3AA8-C3D9D731E0D8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1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4800320" y="1993423"/>
                                <a:ext cx="973137" cy="1389062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pSp>
                <p:nvGrpSpPr>
                  <p:cNvPr id="108" name="Group 107">
                    <a:extLst>
                      <a:ext uri="{FF2B5EF4-FFF2-40B4-BE49-F238E27FC236}">
                        <a16:creationId xmlns:a16="http://schemas.microsoft.com/office/drawing/2014/main" id="{90CC3D3A-9AE2-A2E3-3BA5-022C264F8A16}"/>
                      </a:ext>
                    </a:extLst>
                  </p:cNvPr>
                  <p:cNvGrpSpPr/>
                  <p:nvPr/>
                </p:nvGrpSpPr>
                <p:grpSpPr>
                  <a:xfrm>
                    <a:off x="805627" y="1831200"/>
                    <a:ext cx="1731053" cy="1785453"/>
                    <a:chOff x="2626504" y="4044511"/>
                    <a:chExt cx="1731053" cy="1785453"/>
                  </a:xfrm>
                </p:grpSpPr>
                <p:graphicFrame>
                  <p:nvGraphicFramePr>
                    <p:cNvPr id="166" name="Object 165">
                      <a:extLst>
                        <a:ext uri="{FF2B5EF4-FFF2-40B4-BE49-F238E27FC236}">
                          <a16:creationId xmlns:a16="http://schemas.microsoft.com/office/drawing/2014/main" id="{C1780D6F-447A-05BB-D005-B4DCCF4C067C}"/>
                        </a:ext>
                      </a:extLst>
                    </p:cNvPr>
                    <p:cNvGraphicFramePr>
                      <a:graphicFrameLocks noChangeAspect="1"/>
                    </p:cNvGraphicFramePr>
                    <p:nvPr/>
                  </p:nvGraphicFramePr>
                  <p:xfrm>
                    <a:off x="2784492" y="4213086"/>
                    <a:ext cx="1074737" cy="1389062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Prism 8" r:id="rId14" imgW="2689494" imgH="3476207" progId="Prism8.Document">
                            <p:embed/>
                          </p:oleObj>
                        </mc:Choice>
                        <mc:Fallback>
                          <p:oleObj name="Prism 8" r:id="rId14" imgW="2689494" imgH="3476207" progId="Prism8.Document">
                            <p:embed/>
                            <p:pic>
                              <p:nvPicPr>
                                <p:cNvPr id="7" name="Object 6">
                                  <a:extLst>
                                    <a:ext uri="{FF2B5EF4-FFF2-40B4-BE49-F238E27FC236}">
                                      <a16:creationId xmlns:a16="http://schemas.microsoft.com/office/drawing/2014/main" id="{F0DFE7FB-ED12-23FD-C554-124610F8C8DB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15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2784492" y="4213086"/>
                                  <a:ext cx="1074737" cy="1389062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167" name="TextBox 166">
                      <a:extLst>
                        <a:ext uri="{FF2B5EF4-FFF2-40B4-BE49-F238E27FC236}">
                          <a16:creationId xmlns:a16="http://schemas.microsoft.com/office/drawing/2014/main" id="{EFC064CB-6FA1-E953-7609-FFE9D2CDC43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18920" y="5604475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cs typeface="Arial" panose="020B0604020202020204" pitchFamily="34" charset="0"/>
                        </a:rPr>
                        <a:t>Day</a:t>
                      </a:r>
                      <a:endParaRPr lang="en-US" sz="799" dirty="0"/>
                    </a:p>
                  </p:txBody>
                </p:sp>
                <p:cxnSp>
                  <p:nvCxnSpPr>
                    <p:cNvPr id="168" name="Straight Connector 167">
                      <a:extLst>
                        <a:ext uri="{FF2B5EF4-FFF2-40B4-BE49-F238E27FC236}">
                          <a16:creationId xmlns:a16="http://schemas.microsoft.com/office/drawing/2014/main" id="{B50596C8-79EF-E92E-23C7-C6BD684C006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051711" y="5629523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9" name="Straight Connector 168">
                      <a:extLst>
                        <a:ext uri="{FF2B5EF4-FFF2-40B4-BE49-F238E27FC236}">
                          <a16:creationId xmlns:a16="http://schemas.microsoft.com/office/drawing/2014/main" id="{68F1757F-0503-2B45-C01B-51313379402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423134" y="5629523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70" name="TextBox 169">
                      <a:extLst>
                        <a:ext uri="{FF2B5EF4-FFF2-40B4-BE49-F238E27FC236}">
                          <a16:creationId xmlns:a16="http://schemas.microsoft.com/office/drawing/2014/main" id="{2858D166-588C-81E3-8002-6124B079CA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27552" y="4237860"/>
                      <a:ext cx="3803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dirty="0"/>
                        <a:t>*</a:t>
                      </a:r>
                    </a:p>
                  </p:txBody>
                </p:sp>
                <p:sp>
                  <p:nvSpPr>
                    <p:cNvPr id="171" name="TextBox 170">
                      <a:extLst>
                        <a:ext uri="{FF2B5EF4-FFF2-40B4-BE49-F238E27FC236}">
                          <a16:creationId xmlns:a16="http://schemas.microsoft.com/office/drawing/2014/main" id="{F94FAE1E-682D-4B8D-0334-861855C8042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65391" y="4044511"/>
                      <a:ext cx="127503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/>
                        <a:t>X Activity</a:t>
                      </a:r>
                    </a:p>
                  </p:txBody>
                </p:sp>
                <p:sp>
                  <p:nvSpPr>
                    <p:cNvPr id="173" name="TextBox 172">
                      <a:extLst>
                        <a:ext uri="{FF2B5EF4-FFF2-40B4-BE49-F238E27FC236}">
                          <a16:creationId xmlns:a16="http://schemas.microsoft.com/office/drawing/2014/main" id="{3D5C38BC-F604-ECAC-10A2-CABBD0F5C802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2129915" y="4634562"/>
                      <a:ext cx="120849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X Activity (Events/hr)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74" name="TextBox 173">
                      <a:extLst>
                        <a:ext uri="{FF2B5EF4-FFF2-40B4-BE49-F238E27FC236}">
                          <a16:creationId xmlns:a16="http://schemas.microsoft.com/office/drawing/2014/main" id="{10F848D5-5132-3108-B0D2-54DC35E6A0DA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2954227" y="5402924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WT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75" name="TextBox 174">
                      <a:extLst>
                        <a:ext uri="{FF2B5EF4-FFF2-40B4-BE49-F238E27FC236}">
                          <a16:creationId xmlns:a16="http://schemas.microsoft.com/office/drawing/2014/main" id="{5F11F8A7-FDAA-DE99-5876-02CC92E9B2B5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3310964" y="5402907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WT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76" name="TextBox 175">
                      <a:extLst>
                        <a:ext uri="{FF2B5EF4-FFF2-40B4-BE49-F238E27FC236}">
                          <a16:creationId xmlns:a16="http://schemas.microsoft.com/office/drawing/2014/main" id="{A1F978F9-BD69-733A-C734-0A92C1FBABEC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3480377" y="5394781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⍺</a:t>
                      </a:r>
                      <a:r>
                        <a:rPr lang="en-US" sz="799" baseline="30000" dirty="0"/>
                        <a:t>KO</a:t>
                      </a:r>
                    </a:p>
                  </p:txBody>
                </p:sp>
                <p:sp>
                  <p:nvSpPr>
                    <p:cNvPr id="177" name="TextBox 176">
                      <a:extLst>
                        <a:ext uri="{FF2B5EF4-FFF2-40B4-BE49-F238E27FC236}">
                          <a16:creationId xmlns:a16="http://schemas.microsoft.com/office/drawing/2014/main" id="{E3F199D2-1871-475D-5A05-F16EA8490CC4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3126405" y="5391904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⍺</a:t>
                      </a:r>
                      <a:r>
                        <a:rPr lang="en-US" sz="799" baseline="30000" dirty="0"/>
                        <a:t>KO</a:t>
                      </a:r>
                    </a:p>
                  </p:txBody>
                </p:sp>
                <p:sp>
                  <p:nvSpPr>
                    <p:cNvPr id="178" name="TextBox 177">
                      <a:extLst>
                        <a:ext uri="{FF2B5EF4-FFF2-40B4-BE49-F238E27FC236}">
                          <a16:creationId xmlns:a16="http://schemas.microsoft.com/office/drawing/2014/main" id="{C16B0ABB-C5C5-A659-A874-1F5287BB16C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90384" y="5614649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cs typeface="Arial" panose="020B0604020202020204" pitchFamily="34" charset="0"/>
                        </a:rPr>
                        <a:t>Night</a:t>
                      </a:r>
                      <a:endParaRPr lang="en-US" sz="799" dirty="0"/>
                    </a:p>
                  </p:txBody>
                </p:sp>
              </p:grpSp>
              <p:grpSp>
                <p:nvGrpSpPr>
                  <p:cNvPr id="109" name="Group 108">
                    <a:extLst>
                      <a:ext uri="{FF2B5EF4-FFF2-40B4-BE49-F238E27FC236}">
                        <a16:creationId xmlns:a16="http://schemas.microsoft.com/office/drawing/2014/main" id="{38464997-8356-233A-6E3B-5CFD99C9E1B4}"/>
                      </a:ext>
                    </a:extLst>
                  </p:cNvPr>
                  <p:cNvGrpSpPr/>
                  <p:nvPr/>
                </p:nvGrpSpPr>
                <p:grpSpPr>
                  <a:xfrm>
                    <a:off x="3417422" y="1840870"/>
                    <a:ext cx="1692080" cy="1773072"/>
                    <a:chOff x="3866040" y="3029658"/>
                    <a:chExt cx="1692080" cy="1773072"/>
                  </a:xfrm>
                </p:grpSpPr>
                <p:graphicFrame>
                  <p:nvGraphicFramePr>
                    <p:cNvPr id="133" name="Object 132">
                      <a:extLst>
                        <a:ext uri="{FF2B5EF4-FFF2-40B4-BE49-F238E27FC236}">
                          <a16:creationId xmlns:a16="http://schemas.microsoft.com/office/drawing/2014/main" id="{88567675-DBA1-F779-CD60-6636BDA84B7B}"/>
                        </a:ext>
                      </a:extLst>
                    </p:cNvPr>
                    <p:cNvGraphicFramePr>
                      <a:graphicFrameLocks noChangeAspect="1"/>
                    </p:cNvGraphicFramePr>
                    <p:nvPr/>
                  </p:nvGraphicFramePr>
                  <p:xfrm>
                    <a:off x="4018906" y="3185386"/>
                    <a:ext cx="1031875" cy="1389062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Prism 8" r:id="rId16" imgW="2579652" imgH="3476207" progId="Prism8.Document">
                            <p:embed/>
                          </p:oleObj>
                        </mc:Choice>
                        <mc:Fallback>
                          <p:oleObj name="Prism 8" r:id="rId16" imgW="2579652" imgH="3476207" progId="Prism8.Document">
                            <p:embed/>
                            <p:pic>
                              <p:nvPicPr>
                                <p:cNvPr id="20" name="Object 19">
                                  <a:extLst>
                                    <a:ext uri="{FF2B5EF4-FFF2-40B4-BE49-F238E27FC236}">
                                      <a16:creationId xmlns:a16="http://schemas.microsoft.com/office/drawing/2014/main" id="{C3B3C92A-A1FE-6A09-56E7-F680B2262719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17"/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4018906" y="3185386"/>
                                  <a:ext cx="1031875" cy="1389062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sp>
                  <p:nvSpPr>
                    <p:cNvPr id="134" name="TextBox 133">
                      <a:extLst>
                        <a:ext uri="{FF2B5EF4-FFF2-40B4-BE49-F238E27FC236}">
                          <a16:creationId xmlns:a16="http://schemas.microsoft.com/office/drawing/2014/main" id="{0784C732-8439-9808-AE73-411A6C7675B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32809" y="4576389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cs typeface="Arial" panose="020B0604020202020204" pitchFamily="34" charset="0"/>
                        </a:rPr>
                        <a:t>Day</a:t>
                      </a:r>
                      <a:endParaRPr lang="en-US" sz="799" dirty="0"/>
                    </a:p>
                  </p:txBody>
                </p:sp>
                <p:cxnSp>
                  <p:nvCxnSpPr>
                    <p:cNvPr id="135" name="Straight Connector 134">
                      <a:extLst>
                        <a:ext uri="{FF2B5EF4-FFF2-40B4-BE49-F238E27FC236}">
                          <a16:creationId xmlns:a16="http://schemas.microsoft.com/office/drawing/2014/main" id="{F9C06876-3F1E-F911-994A-050D2E6A705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265600" y="4601436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6" name="Straight Connector 135">
                      <a:extLst>
                        <a:ext uri="{FF2B5EF4-FFF2-40B4-BE49-F238E27FC236}">
                          <a16:creationId xmlns:a16="http://schemas.microsoft.com/office/drawing/2014/main" id="{8967B6CE-0485-5EE4-FC7B-65B4A1622D4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637023" y="4601436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37" name="TextBox 136">
                      <a:extLst>
                        <a:ext uri="{FF2B5EF4-FFF2-40B4-BE49-F238E27FC236}">
                          <a16:creationId xmlns:a16="http://schemas.microsoft.com/office/drawing/2014/main" id="{D113C574-1BFB-D837-160A-FCE7AD9EAB1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53113" y="3029658"/>
                      <a:ext cx="127503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/>
                        <a:t>Z Activity</a:t>
                      </a:r>
                    </a:p>
                  </p:txBody>
                </p:sp>
                <p:sp>
                  <p:nvSpPr>
                    <p:cNvPr id="138" name="TextBox 137">
                      <a:extLst>
                        <a:ext uri="{FF2B5EF4-FFF2-40B4-BE49-F238E27FC236}">
                          <a16:creationId xmlns:a16="http://schemas.microsoft.com/office/drawing/2014/main" id="{5E39A260-564F-5393-4238-998B2170A865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168116" y="4374837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WT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50" name="TextBox 149">
                      <a:extLst>
                        <a:ext uri="{FF2B5EF4-FFF2-40B4-BE49-F238E27FC236}">
                          <a16:creationId xmlns:a16="http://schemas.microsoft.com/office/drawing/2014/main" id="{B34BE650-0E41-728B-7A6F-9AC9B6DE2305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524853" y="4374820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WT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62" name="TextBox 161">
                      <a:extLst>
                        <a:ext uri="{FF2B5EF4-FFF2-40B4-BE49-F238E27FC236}">
                          <a16:creationId xmlns:a16="http://schemas.microsoft.com/office/drawing/2014/main" id="{101C3C91-1257-0353-9095-BA8394CE2636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694266" y="4366694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⍺</a:t>
                      </a:r>
                      <a:r>
                        <a:rPr lang="en-US" sz="799" baseline="30000" dirty="0"/>
                        <a:t>KO</a:t>
                      </a:r>
                    </a:p>
                  </p:txBody>
                </p:sp>
                <p:sp>
                  <p:nvSpPr>
                    <p:cNvPr id="163" name="TextBox 162">
                      <a:extLst>
                        <a:ext uri="{FF2B5EF4-FFF2-40B4-BE49-F238E27FC236}">
                          <a16:creationId xmlns:a16="http://schemas.microsoft.com/office/drawing/2014/main" id="{46486C11-F754-2283-9B77-3B92E124ABCF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340295" y="4363817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⍺</a:t>
                      </a:r>
                      <a:r>
                        <a:rPr lang="en-US" sz="799" baseline="30000" dirty="0"/>
                        <a:t>KO</a:t>
                      </a:r>
                    </a:p>
                  </p:txBody>
                </p:sp>
                <p:sp>
                  <p:nvSpPr>
                    <p:cNvPr id="164" name="TextBox 163">
                      <a:extLst>
                        <a:ext uri="{FF2B5EF4-FFF2-40B4-BE49-F238E27FC236}">
                          <a16:creationId xmlns:a16="http://schemas.microsoft.com/office/drawing/2014/main" id="{6C510796-6B9E-B440-1738-93A2685B670C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3369451" y="3645762"/>
                      <a:ext cx="120849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Z Activity (Events/hr)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65" name="TextBox 164">
                      <a:extLst>
                        <a:ext uri="{FF2B5EF4-FFF2-40B4-BE49-F238E27FC236}">
                          <a16:creationId xmlns:a16="http://schemas.microsoft.com/office/drawing/2014/main" id="{AF4AB02A-194B-8325-5B2A-9AE3791FAFB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90947" y="4587415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cs typeface="Arial" panose="020B0604020202020204" pitchFamily="34" charset="0"/>
                        </a:rPr>
                        <a:t>Night</a:t>
                      </a:r>
                      <a:endParaRPr lang="en-US" sz="799" dirty="0"/>
                    </a:p>
                  </p:txBody>
                </p:sp>
              </p:grpSp>
              <p:grpSp>
                <p:nvGrpSpPr>
                  <p:cNvPr id="110" name="Group 109">
                    <a:extLst>
                      <a:ext uri="{FF2B5EF4-FFF2-40B4-BE49-F238E27FC236}">
                        <a16:creationId xmlns:a16="http://schemas.microsoft.com/office/drawing/2014/main" id="{D7C5A110-6FD1-327A-0CE2-43702C2EBB46}"/>
                      </a:ext>
                    </a:extLst>
                  </p:cNvPr>
                  <p:cNvGrpSpPr/>
                  <p:nvPr/>
                </p:nvGrpSpPr>
                <p:grpSpPr>
                  <a:xfrm>
                    <a:off x="1992065" y="1837729"/>
                    <a:ext cx="1731053" cy="1826713"/>
                    <a:chOff x="2612073" y="2971569"/>
                    <a:chExt cx="1731053" cy="1826713"/>
                  </a:xfrm>
                </p:grpSpPr>
                <p:sp>
                  <p:nvSpPr>
                    <p:cNvPr id="122" name="TextBox 121">
                      <a:extLst>
                        <a:ext uri="{FF2B5EF4-FFF2-40B4-BE49-F238E27FC236}">
                          <a16:creationId xmlns:a16="http://schemas.microsoft.com/office/drawing/2014/main" id="{40CCA3BE-7DB9-F56C-9002-D5B093905C6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04489" y="4572793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cs typeface="Arial" panose="020B0604020202020204" pitchFamily="34" charset="0"/>
                        </a:rPr>
                        <a:t>Day</a:t>
                      </a:r>
                      <a:endParaRPr lang="en-US" sz="799" dirty="0"/>
                    </a:p>
                  </p:txBody>
                </p:sp>
                <p:cxnSp>
                  <p:nvCxnSpPr>
                    <p:cNvPr id="123" name="Straight Connector 122">
                      <a:extLst>
                        <a:ext uri="{FF2B5EF4-FFF2-40B4-BE49-F238E27FC236}">
                          <a16:creationId xmlns:a16="http://schemas.microsoft.com/office/drawing/2014/main" id="{E0C513F2-A135-43D9-BF08-F12C294D316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037280" y="4597841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4" name="Straight Connector 123">
                      <a:extLst>
                        <a:ext uri="{FF2B5EF4-FFF2-40B4-BE49-F238E27FC236}">
                          <a16:creationId xmlns:a16="http://schemas.microsoft.com/office/drawing/2014/main" id="{B15D7673-8362-F3F0-1847-0B850B2A790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408703" y="4597841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25" name="TextBox 124">
                      <a:extLst>
                        <a:ext uri="{FF2B5EF4-FFF2-40B4-BE49-F238E27FC236}">
                          <a16:creationId xmlns:a16="http://schemas.microsoft.com/office/drawing/2014/main" id="{D047BFA4-A207-53C7-A446-D3FDA17F26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37877" y="2971569"/>
                      <a:ext cx="127503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/>
                        <a:t>X Activity</a:t>
                      </a:r>
                    </a:p>
                  </p:txBody>
                </p:sp>
                <p:sp>
                  <p:nvSpPr>
                    <p:cNvPr id="126" name="TextBox 125">
                      <a:extLst>
                        <a:ext uri="{FF2B5EF4-FFF2-40B4-BE49-F238E27FC236}">
                          <a16:creationId xmlns:a16="http://schemas.microsoft.com/office/drawing/2014/main" id="{B78591C0-EDF9-AC6E-DE7B-70705E381750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2115484" y="3602880"/>
                      <a:ext cx="120849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X Activity (Events/hr)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27" name="TextBox 126">
                      <a:extLst>
                        <a:ext uri="{FF2B5EF4-FFF2-40B4-BE49-F238E27FC236}">
                          <a16:creationId xmlns:a16="http://schemas.microsoft.com/office/drawing/2014/main" id="{0F7B4098-9D9C-A330-9A12-91B4C5D35480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2939796" y="4371242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WT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28" name="TextBox 127">
                      <a:extLst>
                        <a:ext uri="{FF2B5EF4-FFF2-40B4-BE49-F238E27FC236}">
                          <a16:creationId xmlns:a16="http://schemas.microsoft.com/office/drawing/2014/main" id="{AA70B86B-ADE3-E10F-9694-24AF5B779727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3296533" y="4371225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WT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29" name="TextBox 128">
                      <a:extLst>
                        <a:ext uri="{FF2B5EF4-FFF2-40B4-BE49-F238E27FC236}">
                          <a16:creationId xmlns:a16="http://schemas.microsoft.com/office/drawing/2014/main" id="{0E79B901-2412-22BF-1025-BFCDEC047211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3415087" y="4321588"/>
                      <a:ext cx="575551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⍺OT</a:t>
                      </a:r>
                      <a:r>
                        <a:rPr lang="en-US" sz="799" baseline="30000" dirty="0"/>
                        <a:t>KO</a:t>
                      </a:r>
                    </a:p>
                  </p:txBody>
                </p:sp>
                <p:sp>
                  <p:nvSpPr>
                    <p:cNvPr id="130" name="TextBox 129">
                      <a:extLst>
                        <a:ext uri="{FF2B5EF4-FFF2-40B4-BE49-F238E27FC236}">
                          <a16:creationId xmlns:a16="http://schemas.microsoft.com/office/drawing/2014/main" id="{57645811-FB54-D099-4919-6F474815FB87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3067318" y="4338488"/>
                      <a:ext cx="50629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⍺OT</a:t>
                      </a:r>
                      <a:r>
                        <a:rPr lang="en-US" sz="799" baseline="30000" dirty="0"/>
                        <a:t>KO</a:t>
                      </a:r>
                    </a:p>
                  </p:txBody>
                </p:sp>
                <p:sp>
                  <p:nvSpPr>
                    <p:cNvPr id="131" name="TextBox 130">
                      <a:extLst>
                        <a:ext uri="{FF2B5EF4-FFF2-40B4-BE49-F238E27FC236}">
                          <a16:creationId xmlns:a16="http://schemas.microsoft.com/office/drawing/2014/main" id="{5DCA5988-91DF-773D-7C1D-9F4231C263D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75953" y="4582967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cs typeface="Arial" panose="020B0604020202020204" pitchFamily="34" charset="0"/>
                        </a:rPr>
                        <a:t>Night</a:t>
                      </a:r>
                      <a:endParaRPr lang="en-US" sz="799" dirty="0"/>
                    </a:p>
                  </p:txBody>
                </p:sp>
                <p:sp>
                  <p:nvSpPr>
                    <p:cNvPr id="132" name="TextBox 131">
                      <a:extLst>
                        <a:ext uri="{FF2B5EF4-FFF2-40B4-BE49-F238E27FC236}">
                          <a16:creationId xmlns:a16="http://schemas.microsoft.com/office/drawing/2014/main" id="{5B157775-E4E8-7754-EE55-50616023C1B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46656" y="3737259"/>
                      <a:ext cx="3803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dirty="0"/>
                        <a:t>*</a:t>
                      </a:r>
                    </a:p>
                  </p:txBody>
                </p:sp>
              </p:grpSp>
              <p:grpSp>
                <p:nvGrpSpPr>
                  <p:cNvPr id="111" name="Group 110">
                    <a:extLst>
                      <a:ext uri="{FF2B5EF4-FFF2-40B4-BE49-F238E27FC236}">
                        <a16:creationId xmlns:a16="http://schemas.microsoft.com/office/drawing/2014/main" id="{8A9C1FC1-9C69-F78D-F2B4-BC3C2FF8EB52}"/>
                      </a:ext>
                    </a:extLst>
                  </p:cNvPr>
                  <p:cNvGrpSpPr/>
                  <p:nvPr/>
                </p:nvGrpSpPr>
                <p:grpSpPr>
                  <a:xfrm>
                    <a:off x="4617433" y="1836796"/>
                    <a:ext cx="1692080" cy="1847036"/>
                    <a:chOff x="3866040" y="2955694"/>
                    <a:chExt cx="1692080" cy="1847036"/>
                  </a:xfrm>
                </p:grpSpPr>
                <p:sp>
                  <p:nvSpPr>
                    <p:cNvPr id="112" name="TextBox 111">
                      <a:extLst>
                        <a:ext uri="{FF2B5EF4-FFF2-40B4-BE49-F238E27FC236}">
                          <a16:creationId xmlns:a16="http://schemas.microsoft.com/office/drawing/2014/main" id="{DF34503B-0F6E-22A1-5328-3D7EC88DE69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32809" y="4576389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cs typeface="Arial" panose="020B0604020202020204" pitchFamily="34" charset="0"/>
                        </a:rPr>
                        <a:t>Day</a:t>
                      </a:r>
                      <a:endParaRPr lang="en-US" sz="799" dirty="0"/>
                    </a:p>
                  </p:txBody>
                </p:sp>
                <p:cxnSp>
                  <p:nvCxnSpPr>
                    <p:cNvPr id="113" name="Straight Connector 112">
                      <a:extLst>
                        <a:ext uri="{FF2B5EF4-FFF2-40B4-BE49-F238E27FC236}">
                          <a16:creationId xmlns:a16="http://schemas.microsoft.com/office/drawing/2014/main" id="{A232F087-6571-A7E8-5B64-F7ECFAAFE89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265600" y="4601436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4" name="Straight Connector 113">
                      <a:extLst>
                        <a:ext uri="{FF2B5EF4-FFF2-40B4-BE49-F238E27FC236}">
                          <a16:creationId xmlns:a16="http://schemas.microsoft.com/office/drawing/2014/main" id="{1A60DE27-1F90-C3FD-3658-AD73B357644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637023" y="4601436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5" name="TextBox 114">
                      <a:extLst>
                        <a:ext uri="{FF2B5EF4-FFF2-40B4-BE49-F238E27FC236}">
                          <a16:creationId xmlns:a16="http://schemas.microsoft.com/office/drawing/2014/main" id="{A49FFC24-3522-129E-4295-2C8A9ED3AD3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6561" y="2955694"/>
                      <a:ext cx="127503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/>
                        <a:t>Z Activity</a:t>
                      </a:r>
                    </a:p>
                  </p:txBody>
                </p:sp>
                <p:sp>
                  <p:nvSpPr>
                    <p:cNvPr id="116" name="TextBox 115">
                      <a:extLst>
                        <a:ext uri="{FF2B5EF4-FFF2-40B4-BE49-F238E27FC236}">
                          <a16:creationId xmlns:a16="http://schemas.microsoft.com/office/drawing/2014/main" id="{F18BBB11-8B4D-CF5A-282F-99BBD5D08C7A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168116" y="4374837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WT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17" name="TextBox 116">
                      <a:extLst>
                        <a:ext uri="{FF2B5EF4-FFF2-40B4-BE49-F238E27FC236}">
                          <a16:creationId xmlns:a16="http://schemas.microsoft.com/office/drawing/2014/main" id="{0111DBB7-24DF-0E90-0204-86EC1062BB7F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524853" y="4374820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WT</a:t>
                      </a:r>
                      <a:endParaRPr lang="en-US" sz="799" baseline="30000" dirty="0"/>
                    </a:p>
                  </p:txBody>
                </p:sp>
                <p:sp>
                  <p:nvSpPr>
                    <p:cNvPr id="118" name="TextBox 117">
                      <a:extLst>
                        <a:ext uri="{FF2B5EF4-FFF2-40B4-BE49-F238E27FC236}">
                          <a16:creationId xmlns:a16="http://schemas.microsoft.com/office/drawing/2014/main" id="{C61B67C0-B5F1-2E5E-3100-8D132943A4C8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648447" y="4341250"/>
                      <a:ext cx="519284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⍺OT</a:t>
                      </a:r>
                      <a:r>
                        <a:rPr lang="en-US" sz="799" baseline="30000" dirty="0"/>
                        <a:t>KO</a:t>
                      </a:r>
                    </a:p>
                  </p:txBody>
                </p:sp>
                <p:sp>
                  <p:nvSpPr>
                    <p:cNvPr id="119" name="TextBox 118">
                      <a:extLst>
                        <a:ext uri="{FF2B5EF4-FFF2-40B4-BE49-F238E27FC236}">
                          <a16:creationId xmlns:a16="http://schemas.microsoft.com/office/drawing/2014/main" id="{8BF639A5-79B6-32E6-0EAA-52685507AB35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294662" y="4338968"/>
                      <a:ext cx="517201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⍺OT</a:t>
                      </a:r>
                      <a:r>
                        <a:rPr lang="en-US" sz="799" baseline="30000" dirty="0"/>
                        <a:t>KO</a:t>
                      </a:r>
                    </a:p>
                  </p:txBody>
                </p:sp>
                <p:sp>
                  <p:nvSpPr>
                    <p:cNvPr id="120" name="TextBox 119">
                      <a:extLst>
                        <a:ext uri="{FF2B5EF4-FFF2-40B4-BE49-F238E27FC236}">
                          <a16:creationId xmlns:a16="http://schemas.microsoft.com/office/drawing/2014/main" id="{3459A55E-E224-1BC1-E01C-4B7570B6878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90947" y="4587415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cs typeface="Arial" panose="020B0604020202020204" pitchFamily="34" charset="0"/>
                        </a:rPr>
                        <a:t>Night</a:t>
                      </a:r>
                      <a:endParaRPr lang="en-US" sz="799" dirty="0"/>
                    </a:p>
                  </p:txBody>
                </p:sp>
                <p:sp>
                  <p:nvSpPr>
                    <p:cNvPr id="121" name="TextBox 120">
                      <a:extLst>
                        <a:ext uri="{FF2B5EF4-FFF2-40B4-BE49-F238E27FC236}">
                          <a16:creationId xmlns:a16="http://schemas.microsoft.com/office/drawing/2014/main" id="{C00B99F2-5728-E806-3A6B-11DA843949ED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3369451" y="3580451"/>
                      <a:ext cx="120849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/>
                        <a:t>Z Activity (Events/hr)</a:t>
                      </a:r>
                      <a:endParaRPr lang="en-US" sz="799" baseline="30000" dirty="0"/>
                    </a:p>
                  </p:txBody>
                </p:sp>
              </p:grpSp>
            </p:grpSp>
            <p:sp>
              <p:nvSpPr>
                <p:cNvPr id="179" name="TextBox 178">
                  <a:extLst>
                    <a:ext uri="{FF2B5EF4-FFF2-40B4-BE49-F238E27FC236}">
                      <a16:creationId xmlns:a16="http://schemas.microsoft.com/office/drawing/2014/main" id="{EC6678A6-20D3-2043-3130-48C62C300665}"/>
                    </a:ext>
                  </a:extLst>
                </p:cNvPr>
                <p:cNvSpPr txBox="1"/>
                <p:nvPr/>
              </p:nvSpPr>
              <p:spPr>
                <a:xfrm>
                  <a:off x="2031709" y="2602706"/>
                  <a:ext cx="317165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comotion of 5-6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old 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  <a:sym typeface="Symbol" pitchFamily="2" charset="2"/>
                    </a:rPr>
                    <a:t></a:t>
                  </a:r>
                  <a:r>
                    <a:rPr lang="en-US" sz="10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and 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  <a:sym typeface="Symbol" pitchFamily="2" charset="2"/>
                    </a:rPr>
                    <a:t>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T</a:t>
                  </a:r>
                  <a:r>
                    <a:rPr lang="en-US" sz="10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females</a:t>
                  </a:r>
                </a:p>
              </p:txBody>
            </p:sp>
          </p:grpSp>
          <p:grpSp>
            <p:nvGrpSpPr>
              <p:cNvPr id="181" name="Group 180">
                <a:extLst>
                  <a:ext uri="{FF2B5EF4-FFF2-40B4-BE49-F238E27FC236}">
                    <a16:creationId xmlns:a16="http://schemas.microsoft.com/office/drawing/2014/main" id="{7476D7D2-89E6-39B2-43E0-81CD9EC240A0}"/>
                  </a:ext>
                </a:extLst>
              </p:cNvPr>
              <p:cNvGrpSpPr/>
              <p:nvPr/>
            </p:nvGrpSpPr>
            <p:grpSpPr>
              <a:xfrm>
                <a:off x="632364" y="5279537"/>
                <a:ext cx="6206313" cy="2367255"/>
                <a:chOff x="632364" y="4603262"/>
                <a:chExt cx="6206313" cy="2367255"/>
              </a:xfrm>
            </p:grpSpPr>
            <p:sp>
              <p:nvSpPr>
                <p:cNvPr id="2" name="TextBox 1">
                  <a:extLst>
                    <a:ext uri="{FF2B5EF4-FFF2-40B4-BE49-F238E27FC236}">
                      <a16:creationId xmlns:a16="http://schemas.microsoft.com/office/drawing/2014/main" id="{7E9794C3-99E2-6D45-2071-0C27E005D451}"/>
                    </a:ext>
                  </a:extLst>
                </p:cNvPr>
                <p:cNvSpPr txBox="1"/>
                <p:nvPr/>
              </p:nvSpPr>
              <p:spPr>
                <a:xfrm>
                  <a:off x="922983" y="4729914"/>
                  <a:ext cx="28097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comotion of 15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old 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  <a:sym typeface="Symbol" pitchFamily="2" charset="2"/>
                    </a:rPr>
                    <a:t>OT</a:t>
                  </a:r>
                  <a:r>
                    <a:rPr lang="en-US" sz="10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 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ales</a:t>
                  </a:r>
                </a:p>
              </p:txBody>
            </p:sp>
            <p:grpSp>
              <p:nvGrpSpPr>
                <p:cNvPr id="5" name="Group 4">
                  <a:extLst>
                    <a:ext uri="{FF2B5EF4-FFF2-40B4-BE49-F238E27FC236}">
                      <a16:creationId xmlns:a16="http://schemas.microsoft.com/office/drawing/2014/main" id="{77A088F4-9309-D34B-0436-13F1AF2DE160}"/>
                    </a:ext>
                  </a:extLst>
                </p:cNvPr>
                <p:cNvGrpSpPr/>
                <p:nvPr/>
              </p:nvGrpSpPr>
              <p:grpSpPr>
                <a:xfrm>
                  <a:off x="725792" y="5138092"/>
                  <a:ext cx="1660389" cy="1832425"/>
                  <a:chOff x="805625" y="5065410"/>
                  <a:chExt cx="1660389" cy="1832425"/>
                </a:xfrm>
              </p:grpSpPr>
              <p:grpSp>
                <p:nvGrpSpPr>
                  <p:cNvPr id="6" name="Group 5">
                    <a:extLst>
                      <a:ext uri="{FF2B5EF4-FFF2-40B4-BE49-F238E27FC236}">
                        <a16:creationId xmlns:a16="http://schemas.microsoft.com/office/drawing/2014/main" id="{F7D43DB1-12A1-954C-EE42-4AE286A28C98}"/>
                      </a:ext>
                    </a:extLst>
                  </p:cNvPr>
                  <p:cNvGrpSpPr/>
                  <p:nvPr/>
                </p:nvGrpSpPr>
                <p:grpSpPr>
                  <a:xfrm>
                    <a:off x="805625" y="5065410"/>
                    <a:ext cx="1413924" cy="1557640"/>
                    <a:chOff x="805625" y="5065410"/>
                    <a:chExt cx="1413924" cy="1557640"/>
                  </a:xfrm>
                </p:grpSpPr>
                <p:grpSp>
                  <p:nvGrpSpPr>
                    <p:cNvPr id="17" name="Group 16">
                      <a:extLst>
                        <a:ext uri="{FF2B5EF4-FFF2-40B4-BE49-F238E27FC236}">
                          <a16:creationId xmlns:a16="http://schemas.microsoft.com/office/drawing/2014/main" id="{CD534A9D-49B3-ACC4-598B-3915120C4E5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05625" y="5065410"/>
                      <a:ext cx="1413924" cy="1557640"/>
                      <a:chOff x="2626504" y="4044511"/>
                      <a:chExt cx="1413924" cy="1557640"/>
                    </a:xfrm>
                  </p:grpSpPr>
                  <p:graphicFrame>
                    <p:nvGraphicFrame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31A6E0B1-924D-13A0-EF58-34A4B33C1923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/>
                    </p:nvGraphicFramePr>
                    <p:xfrm>
                      <a:off x="2751154" y="4213089"/>
                      <a:ext cx="1141413" cy="1389062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Prism 8" r:id="rId18" imgW="2858757" imgH="3476207" progId="Prism8.Document">
                              <p:embed/>
                            </p:oleObj>
                          </mc:Choice>
                          <mc:Fallback>
                            <p:oleObj name="Prism 8" r:id="rId18" imgW="2858757" imgH="3476207" progId="Prism8.Document">
                              <p:embed/>
                              <p:pic>
                                <p:nvPicPr>
                                  <p:cNvPr id="49" name="Object 48">
                                    <a:extLst>
                                      <a:ext uri="{FF2B5EF4-FFF2-40B4-BE49-F238E27FC236}">
                                        <a16:creationId xmlns:a16="http://schemas.microsoft.com/office/drawing/2014/main" id="{9A10D610-C1DD-4DD7-AB7C-EB59CAA2C337}"/>
                                      </a:ext>
                                    </a:extLst>
                                  </p:cNvPr>
                                  <p:cNvPicPr/>
                                  <p:nvPr/>
                                </p:nvPicPr>
                                <p:blipFill>
                                  <a:blip r:embed="rId19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2751154" y="4213089"/>
                                    <a:ext cx="1141413" cy="1389062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  <p:sp>
                    <p:nvSpPr>
                      <p:cNvPr id="20" name="TextBox 19">
                        <a:extLst>
                          <a:ext uri="{FF2B5EF4-FFF2-40B4-BE49-F238E27FC236}">
                            <a16:creationId xmlns:a16="http://schemas.microsoft.com/office/drawing/2014/main" id="{1A2B81C4-BC30-E454-B105-B6AD15AA680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765391" y="4044511"/>
                        <a:ext cx="1275037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X Activity</a:t>
                        </a:r>
                      </a:p>
                    </p:txBody>
                  </p:sp>
                  <p:sp>
                    <p:nvSpPr>
                      <p:cNvPr id="21" name="TextBox 20">
                        <a:extLst>
                          <a:ext uri="{FF2B5EF4-FFF2-40B4-BE49-F238E27FC236}">
                            <a16:creationId xmlns:a16="http://schemas.microsoft.com/office/drawing/2014/main" id="{62FF9D24-C78F-2613-68C4-F4BC50CF7EB6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129915" y="4634562"/>
                        <a:ext cx="1208493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X Activity (Events/hr)</a:t>
                        </a:r>
                        <a:endPara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18" name="TextBox 17">
                      <a:extLst>
                        <a:ext uri="{FF2B5EF4-FFF2-40B4-BE49-F238E27FC236}">
                          <a16:creationId xmlns:a16="http://schemas.microsoft.com/office/drawing/2014/main" id="{491AB4F0-D836-1621-8683-A710038EF5E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88767" y="5364661"/>
                      <a:ext cx="3803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p:txBody>
                </p:sp>
              </p:grpSp>
              <p:grpSp>
                <p:nvGrpSpPr>
                  <p:cNvPr id="7" name="Group 6">
                    <a:extLst>
                      <a:ext uri="{FF2B5EF4-FFF2-40B4-BE49-F238E27FC236}">
                        <a16:creationId xmlns:a16="http://schemas.microsoft.com/office/drawing/2014/main" id="{1787FFEC-7CF1-59ED-57DC-87F6A3A18DF3}"/>
                      </a:ext>
                    </a:extLst>
                  </p:cNvPr>
                  <p:cNvGrpSpPr/>
                  <p:nvPr/>
                </p:nvGrpSpPr>
                <p:grpSpPr>
                  <a:xfrm>
                    <a:off x="1048075" y="6424626"/>
                    <a:ext cx="1417939" cy="473209"/>
                    <a:chOff x="2263792" y="4528237"/>
                    <a:chExt cx="1417939" cy="473209"/>
                  </a:xfrm>
                </p:grpSpPr>
                <p:sp>
                  <p:nvSpPr>
                    <p:cNvPr id="8" name="TextBox 7">
                      <a:extLst>
                        <a:ext uri="{FF2B5EF4-FFF2-40B4-BE49-F238E27FC236}">
                          <a16:creationId xmlns:a16="http://schemas.microsoft.com/office/drawing/2014/main" id="{B190CCD8-E6CD-CCCB-C31C-37BD2AC4084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4558" y="4784031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ght</a:t>
                      </a:r>
                    </a:p>
                  </p:txBody>
                </p:sp>
                <p:grpSp>
                  <p:nvGrpSpPr>
                    <p:cNvPr id="9" name="Group 8">
                      <a:extLst>
                        <a:ext uri="{FF2B5EF4-FFF2-40B4-BE49-F238E27FC236}">
                          <a16:creationId xmlns:a16="http://schemas.microsoft.com/office/drawing/2014/main" id="{6D93A718-A2C1-6E34-A79C-3DC9C3978C6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263792" y="4528237"/>
                      <a:ext cx="1079492" cy="473209"/>
                      <a:chOff x="2263792" y="4528237"/>
                      <a:chExt cx="1079492" cy="473209"/>
                    </a:xfrm>
                  </p:grpSpPr>
                  <p:sp>
                    <p:nvSpPr>
                      <p:cNvPr id="10" name="TextBox 9">
                        <a:extLst>
                          <a:ext uri="{FF2B5EF4-FFF2-40B4-BE49-F238E27FC236}">
                            <a16:creationId xmlns:a16="http://schemas.microsoft.com/office/drawing/2014/main" id="{AE0A20A9-C998-BC66-CEEB-C889F1391D44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10338">
                        <a:off x="2263792" y="4557935"/>
                        <a:ext cx="383082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WT</a:t>
                        </a:r>
                        <a:endPara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" name="TextBox 10">
                        <a:extLst>
                          <a:ext uri="{FF2B5EF4-FFF2-40B4-BE49-F238E27FC236}">
                            <a16:creationId xmlns:a16="http://schemas.microsoft.com/office/drawing/2014/main" id="{B7950C41-4575-21C2-95D5-60FB31B09A02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10338">
                        <a:off x="2632845" y="4564076"/>
                        <a:ext cx="383082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WT</a:t>
                        </a:r>
                        <a:endPara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2" name="TextBox 11">
                        <a:extLst>
                          <a:ext uri="{FF2B5EF4-FFF2-40B4-BE49-F238E27FC236}">
                            <a16:creationId xmlns:a16="http://schemas.microsoft.com/office/drawing/2014/main" id="{A8419789-9478-B119-E531-1507898F8664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10338">
                        <a:off x="2740719" y="4569740"/>
                        <a:ext cx="485750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⍺OT</a:t>
                        </a:r>
                        <a:r>
                          <a:rPr lang="en-US" sz="799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O</a:t>
                        </a:r>
                      </a:p>
                    </p:txBody>
                  </p:sp>
                  <p:sp>
                    <p:nvSpPr>
                      <p:cNvPr id="13" name="TextBox 12">
                        <a:extLst>
                          <a:ext uri="{FF2B5EF4-FFF2-40B4-BE49-F238E27FC236}">
                            <a16:creationId xmlns:a16="http://schemas.microsoft.com/office/drawing/2014/main" id="{0AEB50FE-1B00-63E9-8042-DEAEF742595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10338">
                        <a:off x="2382292" y="4528237"/>
                        <a:ext cx="466748" cy="29726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⍺OT</a:t>
                        </a:r>
                        <a:r>
                          <a:rPr lang="en-US" sz="799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O</a:t>
                        </a:r>
                      </a:p>
                    </p:txBody>
                  </p:sp>
                  <p:cxnSp>
                    <p:nvCxnSpPr>
                      <p:cNvPr id="14" name="Straight Connector 13">
                        <a:extLst>
                          <a:ext uri="{FF2B5EF4-FFF2-40B4-BE49-F238E27FC236}">
                            <a16:creationId xmlns:a16="http://schemas.microsoft.com/office/drawing/2014/main" id="{3A497E68-C733-6A5D-6073-84859AA5853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419772" y="4803010"/>
                        <a:ext cx="294568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5" name="TextBox 14">
                        <a:extLst>
                          <a:ext uri="{FF2B5EF4-FFF2-40B4-BE49-F238E27FC236}">
                            <a16:creationId xmlns:a16="http://schemas.microsoft.com/office/drawing/2014/main" id="{4FD4DF68-F587-63AC-8473-5F6E9AFF38B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76111" y="4786131"/>
                        <a:ext cx="967173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ay</a:t>
                        </a:r>
                      </a:p>
                    </p:txBody>
                  </p:sp>
                  <p:cxnSp>
                    <p:nvCxnSpPr>
                      <p:cNvPr id="16" name="Straight Connector 15">
                        <a:extLst>
                          <a:ext uri="{FF2B5EF4-FFF2-40B4-BE49-F238E27FC236}">
                            <a16:creationId xmlns:a16="http://schemas.microsoft.com/office/drawing/2014/main" id="{CE748C05-1913-0DA3-6681-CC9DCBC91D0A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781356" y="4804672"/>
                        <a:ext cx="294568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1BCE7321-1F4A-DA6D-3AAF-142B04ECE349}"/>
                    </a:ext>
                  </a:extLst>
                </p:cNvPr>
                <p:cNvGrpSpPr/>
                <p:nvPr/>
              </p:nvGrpSpPr>
              <p:grpSpPr>
                <a:xfrm>
                  <a:off x="2077359" y="5127268"/>
                  <a:ext cx="1633254" cy="1819157"/>
                  <a:chOff x="3417422" y="5075082"/>
                  <a:chExt cx="1633254" cy="1819157"/>
                </a:xfrm>
              </p:grpSpPr>
              <p:grpSp>
                <p:nvGrpSpPr>
                  <p:cNvPr id="23" name="Group 22">
                    <a:extLst>
                      <a:ext uri="{FF2B5EF4-FFF2-40B4-BE49-F238E27FC236}">
                        <a16:creationId xmlns:a16="http://schemas.microsoft.com/office/drawing/2014/main" id="{CF91F814-B582-063D-226D-CB5AE6BB4E9A}"/>
                      </a:ext>
                    </a:extLst>
                  </p:cNvPr>
                  <p:cNvGrpSpPr/>
                  <p:nvPr/>
                </p:nvGrpSpPr>
                <p:grpSpPr>
                  <a:xfrm>
                    <a:off x="3417422" y="5075082"/>
                    <a:ext cx="1362110" cy="1544793"/>
                    <a:chOff x="3417422" y="5075082"/>
                    <a:chExt cx="1362110" cy="1544793"/>
                  </a:xfrm>
                </p:grpSpPr>
                <p:grpSp>
                  <p:nvGrpSpPr>
                    <p:cNvPr id="34" name="Group 33">
                      <a:extLst>
                        <a:ext uri="{FF2B5EF4-FFF2-40B4-BE49-F238E27FC236}">
                          <a16:creationId xmlns:a16="http://schemas.microsoft.com/office/drawing/2014/main" id="{B4AC3533-545D-DDAC-2A10-55EE8C925B5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417422" y="5075082"/>
                      <a:ext cx="1362110" cy="1544793"/>
                      <a:chOff x="3866040" y="3029658"/>
                      <a:chExt cx="1362110" cy="1544793"/>
                    </a:xfrm>
                  </p:grpSpPr>
                  <p:graphicFrame>
                    <p:nvGraphicFrame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50D4CAC6-01B1-B759-4CD5-26BC76FCE354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/>
                    </p:nvGraphicFramePr>
                    <p:xfrm>
                      <a:off x="3985568" y="3185389"/>
                      <a:ext cx="1100138" cy="1389062"/>
                    </p:xfrm>
                    <a:graphic>
                      <a:graphicData uri="http://schemas.openxmlformats.org/presentationml/2006/ole">
                        <mc:AlternateContent xmlns:mc="http://schemas.openxmlformats.org/markup-compatibility/2006">
                          <mc:Choice xmlns:v="urn:schemas-microsoft-com:vml" Requires="v">
                            <p:oleObj name="Prism 8" r:id="rId20" imgW="2748916" imgH="3476207" progId="Prism8.Document">
                              <p:embed/>
                            </p:oleObj>
                          </mc:Choice>
                          <mc:Fallback>
                            <p:oleObj name="Prism 8" r:id="rId20" imgW="2748916" imgH="3476207" progId="Prism8.Document">
                              <p:embed/>
                              <p:pic>
                                <p:nvPicPr>
                                  <p:cNvPr id="73" name="Object 72">
                                    <a:extLst>
                                      <a:ext uri="{FF2B5EF4-FFF2-40B4-BE49-F238E27FC236}">
                                        <a16:creationId xmlns:a16="http://schemas.microsoft.com/office/drawing/2014/main" id="{92DA2BEE-7642-4148-A4F5-A16C5FD0C706}"/>
                                      </a:ext>
                                    </a:extLst>
                                  </p:cNvPr>
                                  <p:cNvPicPr/>
                                  <p:nvPr/>
                                </p:nvPicPr>
                                <p:blipFill>
                                  <a:blip r:embed="rId21"/>
                                  <a:stretch>
                                    <a:fillRect/>
                                  </a:stretch>
                                </p:blipFill>
                                <p:spPr>
                                  <a:xfrm>
                                    <a:off x="3985568" y="3185389"/>
                                    <a:ext cx="1100138" cy="1389062"/>
                                  </a:xfrm>
                                  <a:prstGeom prst="rect">
                                    <a:avLst/>
                                  </a:prstGeom>
                                </p:spPr>
                              </p:pic>
                            </p:oleObj>
                          </mc:Fallback>
                        </mc:AlternateContent>
                      </a:graphicData>
                    </a:graphic>
                  </p:graphicFrame>
                  <p:sp>
                    <p:nvSpPr>
                      <p:cNvPr id="37" name="TextBox 36">
                        <a:extLst>
                          <a:ext uri="{FF2B5EF4-FFF2-40B4-BE49-F238E27FC236}">
                            <a16:creationId xmlns:a16="http://schemas.microsoft.com/office/drawing/2014/main" id="{6D61198B-DD6C-3740-9695-4932DD40C6F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53113" y="3029658"/>
                        <a:ext cx="1275037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Z Activity</a:t>
                        </a:r>
                      </a:p>
                    </p:txBody>
                  </p:sp>
                  <p:sp>
                    <p:nvSpPr>
                      <p:cNvPr id="38" name="TextBox 37">
                        <a:extLst>
                          <a:ext uri="{FF2B5EF4-FFF2-40B4-BE49-F238E27FC236}">
                            <a16:creationId xmlns:a16="http://schemas.microsoft.com/office/drawing/2014/main" id="{8D7860B0-5658-AD47-76F8-AD4077B7DD64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3369451" y="3645762"/>
                        <a:ext cx="1208493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Z Activity (Events/hr)</a:t>
                        </a:r>
                        <a:endPara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35" name="TextBox 34">
                      <a:extLst>
                        <a:ext uri="{FF2B5EF4-FFF2-40B4-BE49-F238E27FC236}">
                          <a16:creationId xmlns:a16="http://schemas.microsoft.com/office/drawing/2014/main" id="{5351FD73-7B82-2A22-96CE-7510AF12756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06190" y="5318160"/>
                      <a:ext cx="38030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</a:p>
                  </p:txBody>
                </p:sp>
              </p:grpSp>
              <p:grpSp>
                <p:nvGrpSpPr>
                  <p:cNvPr id="24" name="Group 23">
                    <a:extLst>
                      <a:ext uri="{FF2B5EF4-FFF2-40B4-BE49-F238E27FC236}">
                        <a16:creationId xmlns:a16="http://schemas.microsoft.com/office/drawing/2014/main" id="{671F695F-4786-1B75-B132-4A8FE078FC3E}"/>
                      </a:ext>
                    </a:extLst>
                  </p:cNvPr>
                  <p:cNvGrpSpPr/>
                  <p:nvPr/>
                </p:nvGrpSpPr>
                <p:grpSpPr>
                  <a:xfrm>
                    <a:off x="3632737" y="6421030"/>
                    <a:ext cx="1417939" cy="473209"/>
                    <a:chOff x="2263792" y="4528237"/>
                    <a:chExt cx="1417939" cy="473209"/>
                  </a:xfrm>
                </p:grpSpPr>
                <p:sp>
                  <p:nvSpPr>
                    <p:cNvPr id="25" name="TextBox 24">
                      <a:extLst>
                        <a:ext uri="{FF2B5EF4-FFF2-40B4-BE49-F238E27FC236}">
                          <a16:creationId xmlns:a16="http://schemas.microsoft.com/office/drawing/2014/main" id="{A3B190BB-E63C-8EA3-3BC4-C4BD0E370F2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4558" y="4784031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ght</a:t>
                      </a:r>
                    </a:p>
                  </p:txBody>
                </p:sp>
                <p:grpSp>
                  <p:nvGrpSpPr>
                    <p:cNvPr id="26" name="Group 25">
                      <a:extLst>
                        <a:ext uri="{FF2B5EF4-FFF2-40B4-BE49-F238E27FC236}">
                          <a16:creationId xmlns:a16="http://schemas.microsoft.com/office/drawing/2014/main" id="{F9057DDB-E882-C6A8-117E-4BFD45CD004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263792" y="4528237"/>
                      <a:ext cx="1079492" cy="473209"/>
                      <a:chOff x="2263792" y="4528237"/>
                      <a:chExt cx="1079492" cy="473209"/>
                    </a:xfrm>
                  </p:grpSpPr>
                  <p:sp>
                    <p:nvSpPr>
                      <p:cNvPr id="27" name="TextBox 26">
                        <a:extLst>
                          <a:ext uri="{FF2B5EF4-FFF2-40B4-BE49-F238E27FC236}">
                            <a16:creationId xmlns:a16="http://schemas.microsoft.com/office/drawing/2014/main" id="{ECBB9C3F-9C20-A55D-7711-F07DE425CA95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10338">
                        <a:off x="2263792" y="4557935"/>
                        <a:ext cx="383082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WT</a:t>
                        </a:r>
                        <a:endPara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8" name="TextBox 27">
                        <a:extLst>
                          <a:ext uri="{FF2B5EF4-FFF2-40B4-BE49-F238E27FC236}">
                            <a16:creationId xmlns:a16="http://schemas.microsoft.com/office/drawing/2014/main" id="{6BA63E37-D372-6BA6-2522-7CC8E6F859E2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10338">
                        <a:off x="2632845" y="4564076"/>
                        <a:ext cx="383082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WT</a:t>
                        </a:r>
                        <a:endPara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9" name="TextBox 28">
                        <a:extLst>
                          <a:ext uri="{FF2B5EF4-FFF2-40B4-BE49-F238E27FC236}">
                            <a16:creationId xmlns:a16="http://schemas.microsoft.com/office/drawing/2014/main" id="{3235347C-5A60-D50A-6BF7-E0C87407C096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10338">
                        <a:off x="2740719" y="4569740"/>
                        <a:ext cx="485750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⍺OT</a:t>
                        </a:r>
                        <a:r>
                          <a:rPr lang="en-US" sz="799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O</a:t>
                        </a:r>
                      </a:p>
                    </p:txBody>
                  </p:sp>
                  <p:sp>
                    <p:nvSpPr>
                      <p:cNvPr id="30" name="TextBox 29">
                        <a:extLst>
                          <a:ext uri="{FF2B5EF4-FFF2-40B4-BE49-F238E27FC236}">
                            <a16:creationId xmlns:a16="http://schemas.microsoft.com/office/drawing/2014/main" id="{97CA87DD-B17E-97D5-C8B2-945BF3300EE5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510338">
                        <a:off x="2382292" y="4528237"/>
                        <a:ext cx="466748" cy="29726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⍺OT</a:t>
                        </a:r>
                        <a:r>
                          <a:rPr lang="en-US" sz="799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O</a:t>
                        </a:r>
                      </a:p>
                    </p:txBody>
                  </p:sp>
                  <p:cxnSp>
                    <p:nvCxnSpPr>
                      <p:cNvPr id="31" name="Straight Connector 30">
                        <a:extLst>
                          <a:ext uri="{FF2B5EF4-FFF2-40B4-BE49-F238E27FC236}">
                            <a16:creationId xmlns:a16="http://schemas.microsoft.com/office/drawing/2014/main" id="{07B3AA80-2A33-D102-43B9-32CED7CDD36F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419772" y="4803010"/>
                        <a:ext cx="294568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2" name="TextBox 31">
                        <a:extLst>
                          <a:ext uri="{FF2B5EF4-FFF2-40B4-BE49-F238E27FC236}">
                            <a16:creationId xmlns:a16="http://schemas.microsoft.com/office/drawing/2014/main" id="{35183AB2-9CF9-2212-B379-BCF02AB3B9C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76111" y="4786131"/>
                        <a:ext cx="967173" cy="2153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99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Day</a:t>
                        </a:r>
                      </a:p>
                    </p:txBody>
                  </p:sp>
                  <p:cxnSp>
                    <p:nvCxnSpPr>
                      <p:cNvPr id="33" name="Straight Connector 32">
                        <a:extLst>
                          <a:ext uri="{FF2B5EF4-FFF2-40B4-BE49-F238E27FC236}">
                            <a16:creationId xmlns:a16="http://schemas.microsoft.com/office/drawing/2014/main" id="{1900F040-489C-2010-279E-F8AB80DE97C3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781356" y="4804672"/>
                        <a:ext cx="294568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4B36797A-8979-0AB9-0820-D91F64B05E5B}"/>
                    </a:ext>
                  </a:extLst>
                </p:cNvPr>
                <p:cNvGrpSpPr/>
                <p:nvPr/>
              </p:nvGrpSpPr>
              <p:grpSpPr>
                <a:xfrm>
                  <a:off x="3561561" y="5128273"/>
                  <a:ext cx="1731053" cy="1826713"/>
                  <a:chOff x="1992063" y="5071939"/>
                  <a:chExt cx="1731053" cy="1826713"/>
                </a:xfrm>
              </p:grpSpPr>
              <p:graphicFrame>
                <p:nvGraphicFramePr>
                  <p:cNvPr id="40" name="Object 39">
                    <a:extLst>
                      <a:ext uri="{FF2B5EF4-FFF2-40B4-BE49-F238E27FC236}">
                        <a16:creationId xmlns:a16="http://schemas.microsoft.com/office/drawing/2014/main" id="{8E82A27B-E165-09F1-6DC6-93C994A34577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2062163" y="5224463"/>
                  <a:ext cx="1185862" cy="1389062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8" r:id="rId22" imgW="2968239" imgH="3476207" progId="Prism8.Document">
                          <p:embed/>
                        </p:oleObj>
                      </mc:Choice>
                      <mc:Fallback>
                        <p:oleObj name="Prism 8" r:id="rId22" imgW="2968239" imgH="3476207" progId="Prism8.Document">
                          <p:embed/>
                          <p:pic>
                            <p:nvPicPr>
                              <p:cNvPr id="245" name="Object 244">
                                <a:extLst>
                                  <a:ext uri="{FF2B5EF4-FFF2-40B4-BE49-F238E27FC236}">
                                    <a16:creationId xmlns:a16="http://schemas.microsoft.com/office/drawing/2014/main" id="{BCD2E661-9BE3-4912-BF5F-3A47AE38F3E4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3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2062163" y="5224463"/>
                                <a:ext cx="1185862" cy="1389062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pSp>
                <p:nvGrpSpPr>
                  <p:cNvPr id="41" name="Group 40">
                    <a:extLst>
                      <a:ext uri="{FF2B5EF4-FFF2-40B4-BE49-F238E27FC236}">
                        <a16:creationId xmlns:a16="http://schemas.microsoft.com/office/drawing/2014/main" id="{8DAB731A-49FC-F44D-6FE8-71223975FB9E}"/>
                      </a:ext>
                    </a:extLst>
                  </p:cNvPr>
                  <p:cNvGrpSpPr/>
                  <p:nvPr/>
                </p:nvGrpSpPr>
                <p:grpSpPr>
                  <a:xfrm>
                    <a:off x="1992063" y="5071939"/>
                    <a:ext cx="1731053" cy="1826713"/>
                    <a:chOff x="2612073" y="2971569"/>
                    <a:chExt cx="1731053" cy="1826713"/>
                  </a:xfrm>
                </p:grpSpPr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5FE1A0A4-9395-36C5-A1AF-9870E13B1F4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04489" y="4572793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</a:t>
                      </a:r>
                    </a:p>
                  </p:txBody>
                </p:sp>
                <p:cxnSp>
                  <p:nvCxnSpPr>
                    <p:cNvPr id="43" name="Straight Connector 42">
                      <a:extLst>
                        <a:ext uri="{FF2B5EF4-FFF2-40B4-BE49-F238E27FC236}">
                          <a16:creationId xmlns:a16="http://schemas.microsoft.com/office/drawing/2014/main" id="{73057A16-8C03-7CA0-D455-584A06C8E4A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037280" y="4597841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" name="Straight Connector 43">
                      <a:extLst>
                        <a:ext uri="{FF2B5EF4-FFF2-40B4-BE49-F238E27FC236}">
                          <a16:creationId xmlns:a16="http://schemas.microsoft.com/office/drawing/2014/main" id="{BB54FBEB-CCC7-E674-C3CF-A797E355E5C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408703" y="4597841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5" name="TextBox 44">
                      <a:extLst>
                        <a:ext uri="{FF2B5EF4-FFF2-40B4-BE49-F238E27FC236}">
                          <a16:creationId xmlns:a16="http://schemas.microsoft.com/office/drawing/2014/main" id="{D4E26A78-3A13-1B60-E8F7-C9606A5D173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37877" y="2971569"/>
                      <a:ext cx="127503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 Activity</a:t>
                      </a:r>
                    </a:p>
                  </p:txBody>
                </p:sp>
                <p:sp>
                  <p:nvSpPr>
                    <p:cNvPr id="46" name="TextBox 45">
                      <a:extLst>
                        <a:ext uri="{FF2B5EF4-FFF2-40B4-BE49-F238E27FC236}">
                          <a16:creationId xmlns:a16="http://schemas.microsoft.com/office/drawing/2014/main" id="{558D24B9-AF3D-B8ED-D5D4-18130DB67B13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2115484" y="3602880"/>
                      <a:ext cx="120849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 Activity (Events/hr)</a:t>
                      </a:r>
                      <a:endParaRPr lang="en-US" sz="799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" name="TextBox 51">
                      <a:extLst>
                        <a:ext uri="{FF2B5EF4-FFF2-40B4-BE49-F238E27FC236}">
                          <a16:creationId xmlns:a16="http://schemas.microsoft.com/office/drawing/2014/main" id="{D9D806F6-25A8-25B0-6B36-28DBC7B45564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2939796" y="4371242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799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0" name="TextBox 59">
                      <a:extLst>
                        <a:ext uri="{FF2B5EF4-FFF2-40B4-BE49-F238E27FC236}">
                          <a16:creationId xmlns:a16="http://schemas.microsoft.com/office/drawing/2014/main" id="{36D4DE23-7C8F-805F-E6A6-B12B75DA7AC8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3296533" y="4371225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799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1" name="TextBox 60">
                      <a:extLst>
                        <a:ext uri="{FF2B5EF4-FFF2-40B4-BE49-F238E27FC236}">
                          <a16:creationId xmlns:a16="http://schemas.microsoft.com/office/drawing/2014/main" id="{88BC8A8D-2282-C05E-2B79-231992E772AD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3415087" y="4321588"/>
                      <a:ext cx="575551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⍺OT</a:t>
                      </a:r>
                      <a:r>
                        <a: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O</a:t>
                      </a:r>
                    </a:p>
                  </p:txBody>
                </p:sp>
                <p:sp>
                  <p:nvSpPr>
                    <p:cNvPr id="62" name="TextBox 61">
                      <a:extLst>
                        <a:ext uri="{FF2B5EF4-FFF2-40B4-BE49-F238E27FC236}">
                          <a16:creationId xmlns:a16="http://schemas.microsoft.com/office/drawing/2014/main" id="{C2DC0EA5-66E1-E2A5-514E-CE06A95C2C55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3067318" y="4338488"/>
                      <a:ext cx="50629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⍺OT</a:t>
                      </a:r>
                      <a:r>
                        <a: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O</a:t>
                      </a:r>
                    </a:p>
                  </p:txBody>
                </p:sp>
                <p:sp>
                  <p:nvSpPr>
                    <p:cNvPr id="63" name="TextBox 62">
                      <a:extLst>
                        <a:ext uri="{FF2B5EF4-FFF2-40B4-BE49-F238E27FC236}">
                          <a16:creationId xmlns:a16="http://schemas.microsoft.com/office/drawing/2014/main" id="{174046E3-4902-F23D-1D32-B0BF69DDD66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75953" y="4582967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ght</a:t>
                      </a:r>
                    </a:p>
                  </p:txBody>
                </p:sp>
              </p:grpSp>
            </p:grpSp>
            <p:grpSp>
              <p:nvGrpSpPr>
                <p:cNvPr id="64" name="Group 63">
                  <a:extLst>
                    <a:ext uri="{FF2B5EF4-FFF2-40B4-BE49-F238E27FC236}">
                      <a16:creationId xmlns:a16="http://schemas.microsoft.com/office/drawing/2014/main" id="{4B67957B-0D2A-61AC-232C-604B2599128D}"/>
                    </a:ext>
                  </a:extLst>
                </p:cNvPr>
                <p:cNvGrpSpPr/>
                <p:nvPr/>
              </p:nvGrpSpPr>
              <p:grpSpPr>
                <a:xfrm>
                  <a:off x="5146597" y="5102656"/>
                  <a:ext cx="1692080" cy="1847036"/>
                  <a:chOff x="4617433" y="5071008"/>
                  <a:chExt cx="1692080" cy="1847036"/>
                </a:xfrm>
              </p:grpSpPr>
              <p:graphicFrame>
                <p:nvGraphicFramePr>
                  <p:cNvPr id="65" name="Object 64">
                    <a:extLst>
                      <a:ext uri="{FF2B5EF4-FFF2-40B4-BE49-F238E27FC236}">
                        <a16:creationId xmlns:a16="http://schemas.microsoft.com/office/drawing/2014/main" id="{45FCC879-6100-1E3D-5D9B-F1F34A787076}"/>
                      </a:ext>
                    </a:extLst>
                  </p:cNvPr>
                  <p:cNvGraphicFramePr>
                    <a:graphicFrameLocks noChangeAspect="1"/>
                  </p:cNvGraphicFramePr>
                  <p:nvPr/>
                </p:nvGraphicFramePr>
                <p:xfrm>
                  <a:off x="4714875" y="5227638"/>
                  <a:ext cx="1144588" cy="1389062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name="Prism 8" r:id="rId24" imgW="2858757" imgH="3476207" progId="Prism8.Document">
                          <p:embed/>
                        </p:oleObj>
                      </mc:Choice>
                      <mc:Fallback>
                        <p:oleObj name="Prism 8" r:id="rId24" imgW="2858757" imgH="3476207" progId="Prism8.Document">
                          <p:embed/>
                          <p:pic>
                            <p:nvPicPr>
                              <p:cNvPr id="303" name="Object 302">
                                <a:extLst>
                                  <a:ext uri="{FF2B5EF4-FFF2-40B4-BE49-F238E27FC236}">
                                    <a16:creationId xmlns:a16="http://schemas.microsoft.com/office/drawing/2014/main" id="{220D578E-EC54-4847-BF09-F39545F03FE3}"/>
                                  </a:ext>
                                </a:extLst>
                              </p:cNvPr>
                              <p:cNvPicPr/>
                              <p:nvPr/>
                            </p:nvPicPr>
                            <p:blipFill>
                              <a:blip r:embed="rId25"/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4714875" y="5227638"/>
                                <a:ext cx="1144588" cy="1389062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grpSp>
                <p:nvGrpSpPr>
                  <p:cNvPr id="66" name="Group 65">
                    <a:extLst>
                      <a:ext uri="{FF2B5EF4-FFF2-40B4-BE49-F238E27FC236}">
                        <a16:creationId xmlns:a16="http://schemas.microsoft.com/office/drawing/2014/main" id="{DF4E4586-DFF4-457C-53FA-48A0961B619B}"/>
                      </a:ext>
                    </a:extLst>
                  </p:cNvPr>
                  <p:cNvGrpSpPr/>
                  <p:nvPr/>
                </p:nvGrpSpPr>
                <p:grpSpPr>
                  <a:xfrm>
                    <a:off x="4617433" y="5071008"/>
                    <a:ext cx="1692080" cy="1847036"/>
                    <a:chOff x="3866040" y="2955694"/>
                    <a:chExt cx="1692080" cy="1847036"/>
                  </a:xfrm>
                </p:grpSpPr>
                <p:sp>
                  <p:nvSpPr>
                    <p:cNvPr id="68" name="TextBox 67">
                      <a:extLst>
                        <a:ext uri="{FF2B5EF4-FFF2-40B4-BE49-F238E27FC236}">
                          <a16:creationId xmlns:a16="http://schemas.microsoft.com/office/drawing/2014/main" id="{0DFF8DBA-6E64-6136-8D7E-CA127E62F99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32809" y="4576389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</a:t>
                      </a:r>
                    </a:p>
                  </p:txBody>
                </p:sp>
                <p:cxnSp>
                  <p:nvCxnSpPr>
                    <p:cNvPr id="69" name="Straight Connector 68">
                      <a:extLst>
                        <a:ext uri="{FF2B5EF4-FFF2-40B4-BE49-F238E27FC236}">
                          <a16:creationId xmlns:a16="http://schemas.microsoft.com/office/drawing/2014/main" id="{67D0DA89-168D-B3DD-B61B-3C9DE487BF8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265600" y="4601436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" name="Straight Connector 69">
                      <a:extLst>
                        <a:ext uri="{FF2B5EF4-FFF2-40B4-BE49-F238E27FC236}">
                          <a16:creationId xmlns:a16="http://schemas.microsoft.com/office/drawing/2014/main" id="{444CFAB1-7BC9-4487-6B01-91410B9E285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637023" y="4601436"/>
                      <a:ext cx="294568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72B36B0F-BE3E-9EC0-FAD0-870CC01F81D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6561" y="2955694"/>
                      <a:ext cx="127503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 Activity</a:t>
                      </a:r>
                    </a:p>
                  </p:txBody>
                </p:sp>
                <p:sp>
                  <p:nvSpPr>
                    <p:cNvPr id="72" name="TextBox 71">
                      <a:extLst>
                        <a:ext uri="{FF2B5EF4-FFF2-40B4-BE49-F238E27FC236}">
                          <a16:creationId xmlns:a16="http://schemas.microsoft.com/office/drawing/2014/main" id="{25A1A1B3-C3F0-DD3E-050C-454CA2052028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168116" y="4374837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799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3" name="TextBox 72">
                      <a:extLst>
                        <a:ext uri="{FF2B5EF4-FFF2-40B4-BE49-F238E27FC236}">
                          <a16:creationId xmlns:a16="http://schemas.microsoft.com/office/drawing/2014/main" id="{8A4FD861-FF8C-7934-91B9-6762977E1163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524853" y="4374820"/>
                      <a:ext cx="383082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799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7" name="TextBox 86">
                      <a:extLst>
                        <a:ext uri="{FF2B5EF4-FFF2-40B4-BE49-F238E27FC236}">
                          <a16:creationId xmlns:a16="http://schemas.microsoft.com/office/drawing/2014/main" id="{53DC1735-7CA6-250F-241A-4215F7467D3B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648447" y="4341250"/>
                      <a:ext cx="519284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⍺OT</a:t>
                      </a:r>
                      <a:r>
                        <a: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O</a:t>
                      </a:r>
                    </a:p>
                  </p:txBody>
                </p:sp>
                <p:sp>
                  <p:nvSpPr>
                    <p:cNvPr id="88" name="TextBox 87">
                      <a:extLst>
                        <a:ext uri="{FF2B5EF4-FFF2-40B4-BE49-F238E27FC236}">
                          <a16:creationId xmlns:a16="http://schemas.microsoft.com/office/drawing/2014/main" id="{B9048E2E-12EE-439F-7FDF-889D83CD77A0}"/>
                        </a:ext>
                      </a:extLst>
                    </p:cNvPr>
                    <p:cNvSpPr txBox="1"/>
                    <p:nvPr/>
                  </p:nvSpPr>
                  <p:spPr>
                    <a:xfrm rot="19510338">
                      <a:off x="4294662" y="4338968"/>
                      <a:ext cx="517201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⍺OT</a:t>
                      </a:r>
                      <a:r>
                        <a:rPr lang="en-US" sz="799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O</a:t>
                      </a:r>
                    </a:p>
                  </p:txBody>
                </p:sp>
                <p:sp>
                  <p:nvSpPr>
                    <p:cNvPr id="89" name="TextBox 88">
                      <a:extLst>
                        <a:ext uri="{FF2B5EF4-FFF2-40B4-BE49-F238E27FC236}">
                          <a16:creationId xmlns:a16="http://schemas.microsoft.com/office/drawing/2014/main" id="{629A9350-401F-1525-6CB3-C3947F6598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90947" y="4587415"/>
                      <a:ext cx="96717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ght</a:t>
                      </a:r>
                    </a:p>
                  </p:txBody>
                </p:sp>
                <p:sp>
                  <p:nvSpPr>
                    <p:cNvPr id="90" name="TextBox 89">
                      <a:extLst>
                        <a:ext uri="{FF2B5EF4-FFF2-40B4-BE49-F238E27FC236}">
                          <a16:creationId xmlns:a16="http://schemas.microsoft.com/office/drawing/2014/main" id="{4AF99A1E-D9E6-DAC0-9D5B-0C7A53333323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3369451" y="3580451"/>
                      <a:ext cx="1208493" cy="21531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799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 Activity (Events/hr)</a:t>
                      </a:r>
                      <a:endParaRPr lang="en-US" sz="799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451C7493-7B33-610F-0223-72236127CF92}"/>
                      </a:ext>
                    </a:extLst>
                  </p:cNvPr>
                  <p:cNvSpPr txBox="1"/>
                  <p:nvPr/>
                </p:nvSpPr>
                <p:spPr>
                  <a:xfrm>
                    <a:off x="5385657" y="5501029"/>
                    <a:ext cx="38030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</a:p>
                </p:txBody>
              </p:sp>
            </p:grp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5AAD5632-9D33-6653-862A-4E339F2BBE82}"/>
                    </a:ext>
                  </a:extLst>
                </p:cNvPr>
                <p:cNvSpPr txBox="1"/>
                <p:nvPr/>
              </p:nvSpPr>
              <p:spPr>
                <a:xfrm>
                  <a:off x="3738727" y="4726781"/>
                  <a:ext cx="28097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ocomotion of 15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old 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  <a:sym typeface="Symbol" pitchFamily="2" charset="2"/>
                    </a:rPr>
                    <a:t>OT</a:t>
                  </a:r>
                  <a:r>
                    <a:rPr lang="en-US" sz="10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 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emales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F1BF9525-1240-6D19-7F96-8FC5929F2D67}"/>
                    </a:ext>
                  </a:extLst>
                </p:cNvPr>
                <p:cNvSpPr txBox="1"/>
                <p:nvPr/>
              </p:nvSpPr>
              <p:spPr>
                <a:xfrm>
                  <a:off x="632364" y="4603262"/>
                  <a:ext cx="13559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180" name="TextBox 179">
                  <a:extLst>
                    <a:ext uri="{FF2B5EF4-FFF2-40B4-BE49-F238E27FC236}">
                      <a16:creationId xmlns:a16="http://schemas.microsoft.com/office/drawing/2014/main" id="{FCFF5BD0-DEE1-CE45-1128-F3B7F29109C2}"/>
                    </a:ext>
                  </a:extLst>
                </p:cNvPr>
                <p:cNvSpPr txBox="1"/>
                <p:nvPr/>
              </p:nvSpPr>
              <p:spPr>
                <a:xfrm>
                  <a:off x="3518439" y="4603262"/>
                  <a:ext cx="13559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7792522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084401A3-BE9B-86EE-D550-52BF78039B24}"/>
              </a:ext>
            </a:extLst>
          </p:cNvPr>
          <p:cNvGrpSpPr/>
          <p:nvPr/>
        </p:nvGrpSpPr>
        <p:grpSpPr>
          <a:xfrm>
            <a:off x="397164" y="894968"/>
            <a:ext cx="6144810" cy="6676552"/>
            <a:chOff x="397164" y="894968"/>
            <a:chExt cx="6144810" cy="6676552"/>
          </a:xfrm>
        </p:grpSpPr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E35A4D21-7C78-9649-9410-91F9C5BF1C5B}"/>
                </a:ext>
              </a:extLst>
            </p:cNvPr>
            <p:cNvSpPr txBox="1"/>
            <p:nvPr/>
          </p:nvSpPr>
          <p:spPr>
            <a:xfrm>
              <a:off x="397164" y="6925189"/>
              <a:ext cx="614481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4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ody weights and food intake in 6mo old of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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</a:t>
              </a:r>
              <a:r>
                <a:rPr lang="en-US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A), and 5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ld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</a:t>
              </a:r>
              <a:r>
                <a:rPr lang="en-US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B) male and female mice, and food intake in 15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ld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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T</a:t>
              </a:r>
              <a:r>
                <a:rPr lang="en-US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O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Symbol" pitchFamily="2" charset="2"/>
                </a:rPr>
                <a:t></a:t>
              </a:r>
              <a:r>
                <a:rPr kumimoji="0" lang="en-US" sz="1200" b="0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KO</a:t>
              </a: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(C)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e. n=4 per group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BA64166E-232A-4E3D-9484-20DC149DAAC6}"/>
                </a:ext>
              </a:extLst>
            </p:cNvPr>
            <p:cNvGrpSpPr/>
            <p:nvPr/>
          </p:nvGrpSpPr>
          <p:grpSpPr>
            <a:xfrm>
              <a:off x="550419" y="894968"/>
              <a:ext cx="5582755" cy="5747575"/>
              <a:chOff x="550419" y="894968"/>
              <a:chExt cx="5582755" cy="5747575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25FCF3C5-8EB6-CC4E-B3B8-EDE313F6C439}"/>
                  </a:ext>
                </a:extLst>
              </p:cNvPr>
              <p:cNvGrpSpPr/>
              <p:nvPr/>
            </p:nvGrpSpPr>
            <p:grpSpPr>
              <a:xfrm>
                <a:off x="550419" y="894968"/>
                <a:ext cx="5555295" cy="1952056"/>
                <a:chOff x="550419" y="954530"/>
                <a:chExt cx="5555295" cy="1952056"/>
              </a:xfrm>
            </p:grpSpPr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4C91C741-2EE4-4605-8CFE-126528AA055B}"/>
                    </a:ext>
                  </a:extLst>
                </p:cNvPr>
                <p:cNvSpPr txBox="1"/>
                <p:nvPr/>
              </p:nvSpPr>
              <p:spPr>
                <a:xfrm>
                  <a:off x="1166557" y="1204925"/>
                  <a:ext cx="63583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Weight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D8485B7C-82B3-468B-808C-DA46E04316DA}"/>
                    </a:ext>
                  </a:extLst>
                </p:cNvPr>
                <p:cNvSpPr txBox="1"/>
                <p:nvPr/>
              </p:nvSpPr>
              <p:spPr>
                <a:xfrm>
                  <a:off x="2345281" y="1228243"/>
                  <a:ext cx="7994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Food Intake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BD0C4E1D-07A4-4527-B2A3-0430D37F0CED}"/>
                    </a:ext>
                  </a:extLst>
                </p:cNvPr>
                <p:cNvSpPr txBox="1"/>
                <p:nvPr/>
              </p:nvSpPr>
              <p:spPr>
                <a:xfrm rot="16200000">
                  <a:off x="582520" y="1843140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grams</a:t>
                  </a:r>
                  <a:endParaRPr lang="en-US" sz="799" baseline="30000" dirty="0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BB50D863-101C-473E-855E-0948FDB0D806}"/>
                    </a:ext>
                  </a:extLst>
                </p:cNvPr>
                <p:cNvSpPr txBox="1"/>
                <p:nvPr/>
              </p:nvSpPr>
              <p:spPr>
                <a:xfrm rot="16200000">
                  <a:off x="1701332" y="1844670"/>
                  <a:ext cx="77607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grams/day</a:t>
                  </a:r>
                  <a:endParaRPr lang="en-US" sz="799" baseline="30000" dirty="0"/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A9927464-F14C-43CA-A7C4-3A1179DB96C1}"/>
                    </a:ext>
                  </a:extLst>
                </p:cNvPr>
                <p:cNvSpPr txBox="1"/>
                <p:nvPr/>
              </p:nvSpPr>
              <p:spPr>
                <a:xfrm>
                  <a:off x="2428334" y="2667953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C0144A49-7894-4946-9A08-157380211C87}"/>
                    </a:ext>
                  </a:extLst>
                </p:cNvPr>
                <p:cNvSpPr txBox="1"/>
                <p:nvPr/>
              </p:nvSpPr>
              <p:spPr>
                <a:xfrm>
                  <a:off x="2666034" y="2665341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0BEC3A4F-8945-4838-A59E-B96C045FFC48}"/>
                    </a:ext>
                  </a:extLst>
                </p:cNvPr>
                <p:cNvSpPr txBox="1"/>
                <p:nvPr/>
              </p:nvSpPr>
              <p:spPr>
                <a:xfrm>
                  <a:off x="1108075" y="2665341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5CD5465F-42F8-4AD1-A6B6-261F5AF34756}"/>
                    </a:ext>
                  </a:extLst>
                </p:cNvPr>
                <p:cNvSpPr txBox="1"/>
                <p:nvPr/>
              </p:nvSpPr>
              <p:spPr>
                <a:xfrm>
                  <a:off x="1339799" y="2662729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3F913DC3-64DA-47C1-A5A9-E2FD1109D59B}"/>
                    </a:ext>
                  </a:extLst>
                </p:cNvPr>
                <p:cNvSpPr txBox="1"/>
                <p:nvPr/>
              </p:nvSpPr>
              <p:spPr>
                <a:xfrm>
                  <a:off x="550419" y="1101775"/>
                  <a:ext cx="13559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A</a:t>
                  </a:r>
                </a:p>
              </p:txBody>
            </p:sp>
            <p:graphicFrame>
              <p:nvGraphicFramePr>
                <p:cNvPr id="25" name="Object 24">
                  <a:extLst>
                    <a:ext uri="{FF2B5EF4-FFF2-40B4-BE49-F238E27FC236}">
                      <a16:creationId xmlns:a16="http://schemas.microsoft.com/office/drawing/2014/main" id="{35E7FBE6-55E3-4847-981A-698547961A83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986859243"/>
                    </p:ext>
                  </p:extLst>
                </p:nvPr>
              </p:nvGraphicFramePr>
              <p:xfrm>
                <a:off x="874715" y="1384366"/>
                <a:ext cx="1011237" cy="13731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2" imgW="1681474" imgH="2289859" progId="Prism8.Document">
                        <p:embed/>
                      </p:oleObj>
                    </mc:Choice>
                    <mc:Fallback>
                      <p:oleObj name="Prism 8" r:id="rId2" imgW="1681474" imgH="2289859" progId="Prism8.Document">
                        <p:embed/>
                        <p:pic>
                          <p:nvPicPr>
                            <p:cNvPr id="25" name="Object 24">
                              <a:extLst>
                                <a:ext uri="{FF2B5EF4-FFF2-40B4-BE49-F238E27FC236}">
                                  <a16:creationId xmlns:a16="http://schemas.microsoft.com/office/drawing/2014/main" id="{35E7FBE6-55E3-4847-981A-698547961A8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74715" y="1384366"/>
                              <a:ext cx="1011237" cy="13731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6" name="Object 25">
                  <a:extLst>
                    <a:ext uri="{FF2B5EF4-FFF2-40B4-BE49-F238E27FC236}">
                      <a16:creationId xmlns:a16="http://schemas.microsoft.com/office/drawing/2014/main" id="{35118EC2-24F4-462E-8831-F5ED0FE190F3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61963675"/>
                    </p:ext>
                  </p:extLst>
                </p:nvPr>
              </p:nvGraphicFramePr>
              <p:xfrm>
                <a:off x="2195515" y="1384366"/>
                <a:ext cx="960437" cy="1373187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4" imgW="1599363" imgH="2289859" progId="Prism8.Document">
                        <p:embed/>
                      </p:oleObj>
                    </mc:Choice>
                    <mc:Fallback>
                      <p:oleObj name="Prism 8" r:id="rId4" imgW="1599363" imgH="2289859" progId="Prism8.Document">
                        <p:embed/>
                        <p:pic>
                          <p:nvPicPr>
                            <p:cNvPr id="26" name="Object 25">
                              <a:extLst>
                                <a:ext uri="{FF2B5EF4-FFF2-40B4-BE49-F238E27FC236}">
                                  <a16:creationId xmlns:a16="http://schemas.microsoft.com/office/drawing/2014/main" id="{35118EC2-24F4-462E-8831-F5ED0FE190F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195515" y="1384366"/>
                              <a:ext cx="960437" cy="1373187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E02C86FD-7863-4CF9-B698-C2FBA8DB7901}"/>
                    </a:ext>
                  </a:extLst>
                </p:cNvPr>
                <p:cNvSpPr txBox="1"/>
                <p:nvPr/>
              </p:nvSpPr>
              <p:spPr>
                <a:xfrm>
                  <a:off x="4099040" y="1228243"/>
                  <a:ext cx="63583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Weight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AF46C6BE-6106-48E2-A6A4-5C7BD19D27BC}"/>
                    </a:ext>
                  </a:extLst>
                </p:cNvPr>
                <p:cNvSpPr txBox="1"/>
                <p:nvPr/>
              </p:nvSpPr>
              <p:spPr>
                <a:xfrm>
                  <a:off x="5266613" y="1251561"/>
                  <a:ext cx="7994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Food Intake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62BE66A7-4C50-4CC4-8E2C-37FFDC3CBFC4}"/>
                    </a:ext>
                  </a:extLst>
                </p:cNvPr>
                <p:cNvSpPr txBox="1"/>
                <p:nvPr/>
              </p:nvSpPr>
              <p:spPr>
                <a:xfrm rot="16200000">
                  <a:off x="3503852" y="1866458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grams</a:t>
                  </a:r>
                  <a:endParaRPr lang="en-US" sz="799" baseline="30000" dirty="0"/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E32AC9E6-9310-4ACF-A058-FCE0C24A4AAC}"/>
                    </a:ext>
                  </a:extLst>
                </p:cNvPr>
                <p:cNvSpPr txBox="1"/>
                <p:nvPr/>
              </p:nvSpPr>
              <p:spPr>
                <a:xfrm rot="16200000">
                  <a:off x="4689063" y="1934385"/>
                  <a:ext cx="643277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grams/day</a:t>
                  </a:r>
                  <a:endParaRPr lang="en-US" sz="799" baseline="30000" dirty="0"/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4E3ED1D7-F835-4BE6-8B11-EDA917EB22B1}"/>
                    </a:ext>
                  </a:extLst>
                </p:cNvPr>
                <p:cNvSpPr txBox="1"/>
                <p:nvPr/>
              </p:nvSpPr>
              <p:spPr>
                <a:xfrm>
                  <a:off x="5349666" y="2691271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FBECD18C-9E86-476E-B231-79F17BE32040}"/>
                    </a:ext>
                  </a:extLst>
                </p:cNvPr>
                <p:cNvSpPr txBox="1"/>
                <p:nvPr/>
              </p:nvSpPr>
              <p:spPr>
                <a:xfrm>
                  <a:off x="5587366" y="2688659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2166C18D-E051-481F-90BE-817162A4ECC3}"/>
                    </a:ext>
                  </a:extLst>
                </p:cNvPr>
                <p:cNvSpPr txBox="1"/>
                <p:nvPr/>
              </p:nvSpPr>
              <p:spPr>
                <a:xfrm>
                  <a:off x="4029407" y="2688659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Ctrl</a:t>
                  </a:r>
                  <a:endParaRPr lang="en-US" sz="799" baseline="30000" dirty="0"/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73A81028-B7CD-487E-ABF6-40612031C89A}"/>
                    </a:ext>
                  </a:extLst>
                </p:cNvPr>
                <p:cNvSpPr txBox="1"/>
                <p:nvPr/>
              </p:nvSpPr>
              <p:spPr>
                <a:xfrm>
                  <a:off x="4261131" y="2686047"/>
                  <a:ext cx="518348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OT</a:t>
                  </a:r>
                  <a:r>
                    <a:rPr lang="en-US" sz="799" baseline="30000" dirty="0"/>
                    <a:t>KO</a:t>
                  </a:r>
                </a:p>
              </p:txBody>
            </p:sp>
            <p:graphicFrame>
              <p:nvGraphicFramePr>
                <p:cNvPr id="35" name="Object 34">
                  <a:extLst>
                    <a:ext uri="{FF2B5EF4-FFF2-40B4-BE49-F238E27FC236}">
                      <a16:creationId xmlns:a16="http://schemas.microsoft.com/office/drawing/2014/main" id="{B918D30E-1095-4F6A-ACEA-B547ACDECBB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494797801"/>
                    </p:ext>
                  </p:extLst>
                </p:nvPr>
              </p:nvGraphicFramePr>
              <p:xfrm>
                <a:off x="3795715" y="1408176"/>
                <a:ext cx="1011237" cy="137318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6" imgW="1681474" imgH="2289859" progId="Prism8.Document">
                        <p:embed/>
                      </p:oleObj>
                    </mc:Choice>
                    <mc:Fallback>
                      <p:oleObj name="Prism 8" r:id="rId6" imgW="1681474" imgH="2289859" progId="Prism8.Document">
                        <p:embed/>
                        <p:pic>
                          <p:nvPicPr>
                            <p:cNvPr id="35" name="Object 34">
                              <a:extLst>
                                <a:ext uri="{FF2B5EF4-FFF2-40B4-BE49-F238E27FC236}">
                                  <a16:creationId xmlns:a16="http://schemas.microsoft.com/office/drawing/2014/main" id="{B918D30E-1095-4F6A-ACEA-B547ACDECBB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795715" y="1408176"/>
                              <a:ext cx="1011237" cy="137318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6" name="Object 35">
                  <a:extLst>
                    <a:ext uri="{FF2B5EF4-FFF2-40B4-BE49-F238E27FC236}">
                      <a16:creationId xmlns:a16="http://schemas.microsoft.com/office/drawing/2014/main" id="{F12E3307-8A16-4C0A-A435-3340C6942C3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567429712"/>
                    </p:ext>
                  </p:extLst>
                </p:nvPr>
              </p:nvGraphicFramePr>
              <p:xfrm>
                <a:off x="5116513" y="1408176"/>
                <a:ext cx="958850" cy="137318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8" imgW="1599363" imgH="2289859" progId="Prism8.Document">
                        <p:embed/>
                      </p:oleObj>
                    </mc:Choice>
                    <mc:Fallback>
                      <p:oleObj name="Prism 8" r:id="rId8" imgW="1599363" imgH="2289859" progId="Prism8.Document">
                        <p:embed/>
                        <p:pic>
                          <p:nvPicPr>
                            <p:cNvPr id="36" name="Object 35">
                              <a:extLst>
                                <a:ext uri="{FF2B5EF4-FFF2-40B4-BE49-F238E27FC236}">
                                  <a16:creationId xmlns:a16="http://schemas.microsoft.com/office/drawing/2014/main" id="{F12E3307-8A16-4C0A-A435-3340C6942C3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116513" y="1408176"/>
                              <a:ext cx="958850" cy="137318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00734A6B-326E-4E34-85D4-273D4FB72BE9}"/>
                    </a:ext>
                  </a:extLst>
                </p:cNvPr>
                <p:cNvSpPr txBox="1"/>
                <p:nvPr/>
              </p:nvSpPr>
              <p:spPr>
                <a:xfrm>
                  <a:off x="1810751" y="955464"/>
                  <a:ext cx="84840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Male (6 </a:t>
                  </a:r>
                  <a:r>
                    <a:rPr lang="en-US" sz="1000" dirty="0" err="1"/>
                    <a:t>mo</a:t>
                  </a:r>
                  <a:r>
                    <a:rPr lang="en-US" sz="1000" dirty="0"/>
                    <a:t>)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A6E99247-9473-4419-8F24-69B8CF816D21}"/>
                    </a:ext>
                  </a:extLst>
                </p:cNvPr>
                <p:cNvSpPr txBox="1"/>
                <p:nvPr/>
              </p:nvSpPr>
              <p:spPr>
                <a:xfrm>
                  <a:off x="4729243" y="954530"/>
                  <a:ext cx="101880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Female (6 </a:t>
                  </a:r>
                  <a:r>
                    <a:rPr lang="en-US" sz="1000" dirty="0" err="1"/>
                    <a:t>mo</a:t>
                  </a:r>
                  <a:r>
                    <a:rPr lang="en-US" sz="1000" dirty="0"/>
                    <a:t>)</a:t>
                  </a:r>
                </a:p>
              </p:txBody>
            </p:sp>
          </p:grpSp>
          <p:graphicFrame>
            <p:nvGraphicFramePr>
              <p:cNvPr id="58" name="Object 57">
                <a:extLst>
                  <a:ext uri="{FF2B5EF4-FFF2-40B4-BE49-F238E27FC236}">
                    <a16:creationId xmlns:a16="http://schemas.microsoft.com/office/drawing/2014/main" id="{873A97D5-CD28-4AB2-9195-B859545F919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25440739"/>
                  </p:ext>
                </p:extLst>
              </p:nvPr>
            </p:nvGraphicFramePr>
            <p:xfrm>
              <a:off x="3859872" y="3352503"/>
              <a:ext cx="1008062" cy="1374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0" imgW="1681474" imgH="2289859" progId="Prism8.Document">
                      <p:embed/>
                    </p:oleObj>
                  </mc:Choice>
                  <mc:Fallback>
                    <p:oleObj name="Prism 8" r:id="rId10" imgW="1681474" imgH="2289859" progId="Prism8.Document">
                      <p:embed/>
                      <p:pic>
                        <p:nvPicPr>
                          <p:cNvPr id="58" name="Object 57">
                            <a:extLst>
                              <a:ext uri="{FF2B5EF4-FFF2-40B4-BE49-F238E27FC236}">
                                <a16:creationId xmlns:a16="http://schemas.microsoft.com/office/drawing/2014/main" id="{873A97D5-CD28-4AB2-9195-B859545F919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3859872" y="3352503"/>
                            <a:ext cx="1008062" cy="13747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7" name="Object 46">
                <a:extLst>
                  <a:ext uri="{FF2B5EF4-FFF2-40B4-BE49-F238E27FC236}">
                    <a16:creationId xmlns:a16="http://schemas.microsoft.com/office/drawing/2014/main" id="{7A3826B8-3F74-4276-9239-FCA527CC94E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849321212"/>
                  </p:ext>
                </p:extLst>
              </p:nvPr>
            </p:nvGraphicFramePr>
            <p:xfrm>
              <a:off x="908711" y="3330278"/>
              <a:ext cx="1008063" cy="1374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2" imgW="1681474" imgH="2289859" progId="Prism8.Document">
                      <p:embed/>
                    </p:oleObj>
                  </mc:Choice>
                  <mc:Fallback>
                    <p:oleObj name="Prism 8" r:id="rId12" imgW="1681474" imgH="2289859" progId="Prism8.Document">
                      <p:embed/>
                      <p:pic>
                        <p:nvPicPr>
                          <p:cNvPr id="47" name="Object 46">
                            <a:extLst>
                              <a:ext uri="{FF2B5EF4-FFF2-40B4-BE49-F238E27FC236}">
                                <a16:creationId xmlns:a16="http://schemas.microsoft.com/office/drawing/2014/main" id="{7A3826B8-3F74-4276-9239-FCA527CC94E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908711" y="3330278"/>
                            <a:ext cx="1008063" cy="13747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4088594-2FAD-4D9C-BBEA-3AF1608BFC55}"/>
                  </a:ext>
                </a:extLst>
              </p:cNvPr>
              <p:cNvSpPr txBox="1"/>
              <p:nvPr/>
            </p:nvSpPr>
            <p:spPr>
              <a:xfrm>
                <a:off x="550419" y="3194270"/>
                <a:ext cx="13559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B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5BAD16C7-7B23-4CF1-A248-870198798407}"/>
                  </a:ext>
                </a:extLst>
              </p:cNvPr>
              <p:cNvSpPr txBox="1"/>
              <p:nvPr/>
            </p:nvSpPr>
            <p:spPr>
              <a:xfrm rot="16200000">
                <a:off x="639234" y="3851213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grams</a:t>
                </a:r>
                <a:endParaRPr lang="en-US" sz="799" baseline="30000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21217EE4-6726-4D23-A97E-86CDF5C4B4AE}"/>
                  </a:ext>
                </a:extLst>
              </p:cNvPr>
              <p:cNvSpPr txBox="1"/>
              <p:nvPr/>
            </p:nvSpPr>
            <p:spPr>
              <a:xfrm>
                <a:off x="1163950" y="4602579"/>
                <a:ext cx="38308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WT</a:t>
                </a:r>
                <a:endParaRPr lang="en-US" sz="799" baseline="30000" dirty="0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220EF724-951A-43C6-9533-B1B472368B43}"/>
                  </a:ext>
                </a:extLst>
              </p:cNvPr>
              <p:cNvSpPr txBox="1"/>
              <p:nvPr/>
            </p:nvSpPr>
            <p:spPr>
              <a:xfrm>
                <a:off x="1496034" y="4599967"/>
                <a:ext cx="35611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⍺</a:t>
                </a:r>
                <a:r>
                  <a:rPr lang="en-US" sz="799" baseline="30000" dirty="0"/>
                  <a:t>KO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00836E9F-9F18-42BB-84F3-8600626660B2}"/>
                  </a:ext>
                </a:extLst>
              </p:cNvPr>
              <p:cNvSpPr txBox="1"/>
              <p:nvPr/>
            </p:nvSpPr>
            <p:spPr>
              <a:xfrm rot="16200000">
                <a:off x="1916253" y="3793650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grams</a:t>
                </a:r>
                <a:endParaRPr lang="en-US" sz="799" baseline="30000" dirty="0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46489E53-91E3-46B7-A98C-710C8CDE434D}"/>
                  </a:ext>
                </a:extLst>
              </p:cNvPr>
              <p:cNvSpPr txBox="1"/>
              <p:nvPr/>
            </p:nvSpPr>
            <p:spPr>
              <a:xfrm>
                <a:off x="2464309" y="4559765"/>
                <a:ext cx="38308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WT</a:t>
                </a:r>
                <a:endParaRPr lang="en-US" sz="799" baseline="30000" dirty="0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393655A7-8266-4287-BB86-44B71D008B17}"/>
                  </a:ext>
                </a:extLst>
              </p:cNvPr>
              <p:cNvSpPr txBox="1"/>
              <p:nvPr/>
            </p:nvSpPr>
            <p:spPr>
              <a:xfrm>
                <a:off x="2796393" y="4557153"/>
                <a:ext cx="35611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⍺</a:t>
                </a:r>
                <a:r>
                  <a:rPr lang="en-US" sz="799" baseline="30000" dirty="0"/>
                  <a:t>KO</a:t>
                </a:r>
              </a:p>
            </p:txBody>
          </p:sp>
          <p:graphicFrame>
            <p:nvGraphicFramePr>
              <p:cNvPr id="48" name="Object 47">
                <a:extLst>
                  <a:ext uri="{FF2B5EF4-FFF2-40B4-BE49-F238E27FC236}">
                    <a16:creationId xmlns:a16="http://schemas.microsoft.com/office/drawing/2014/main" id="{0025BED2-2E86-4F58-ACB3-F33BFD6B346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91813954"/>
                  </p:ext>
                </p:extLst>
              </p:nvPr>
            </p:nvGraphicFramePr>
            <p:xfrm>
              <a:off x="2218399" y="3308053"/>
              <a:ext cx="962025" cy="1374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4" imgW="1602244" imgH="2289859" progId="Prism8.Document">
                      <p:embed/>
                    </p:oleObj>
                  </mc:Choice>
                  <mc:Fallback>
                    <p:oleObj name="Prism 8" r:id="rId14" imgW="1602244" imgH="2289859" progId="Prism8.Document">
                      <p:embed/>
                      <p:pic>
                        <p:nvPicPr>
                          <p:cNvPr id="48" name="Object 47">
                            <a:extLst>
                              <a:ext uri="{FF2B5EF4-FFF2-40B4-BE49-F238E27FC236}">
                                <a16:creationId xmlns:a16="http://schemas.microsoft.com/office/drawing/2014/main" id="{0025BED2-2E86-4F58-ACB3-F33BFD6B346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2218399" y="3308053"/>
                            <a:ext cx="962025" cy="13747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D2AD6675-360E-4FCD-B892-446C1BF584FF}"/>
                  </a:ext>
                </a:extLst>
              </p:cNvPr>
              <p:cNvSpPr txBox="1"/>
              <p:nvPr/>
            </p:nvSpPr>
            <p:spPr>
              <a:xfrm>
                <a:off x="1136769" y="3120632"/>
                <a:ext cx="6358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Weight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7EB37EA3-55D4-4C33-94BE-EE2CEF43E892}"/>
                  </a:ext>
                </a:extLst>
              </p:cNvPr>
              <p:cNvSpPr txBox="1"/>
              <p:nvPr/>
            </p:nvSpPr>
            <p:spPr>
              <a:xfrm>
                <a:off x="2315493" y="3143950"/>
                <a:ext cx="799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Food Intake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6278B51D-53FE-476D-9DC2-628364998EC2}"/>
                  </a:ext>
                </a:extLst>
              </p:cNvPr>
              <p:cNvSpPr txBox="1"/>
              <p:nvPr/>
            </p:nvSpPr>
            <p:spPr>
              <a:xfrm rot="16200000">
                <a:off x="3590888" y="3873210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grams</a:t>
                </a:r>
                <a:endParaRPr lang="en-US" sz="799" baseline="30000" dirty="0"/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2D6E5274-20B6-4EF7-96CF-D5860090C071}"/>
                  </a:ext>
                </a:extLst>
              </p:cNvPr>
              <p:cNvSpPr txBox="1"/>
              <p:nvPr/>
            </p:nvSpPr>
            <p:spPr>
              <a:xfrm>
                <a:off x="4115604" y="4624576"/>
                <a:ext cx="38308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WT</a:t>
                </a:r>
                <a:endParaRPr lang="en-US" sz="799" baseline="30000" dirty="0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E8354E75-4DB6-4B51-B98D-7A07FB6354F3}"/>
                  </a:ext>
                </a:extLst>
              </p:cNvPr>
              <p:cNvSpPr txBox="1"/>
              <p:nvPr/>
            </p:nvSpPr>
            <p:spPr>
              <a:xfrm>
                <a:off x="4447688" y="4621964"/>
                <a:ext cx="356112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⍺</a:t>
                </a:r>
                <a:r>
                  <a:rPr lang="en-US" sz="799" baseline="30000" dirty="0"/>
                  <a:t>KO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CF8DB749-5E87-4236-8BD2-C77487F55A41}"/>
                  </a:ext>
                </a:extLst>
              </p:cNvPr>
              <p:cNvSpPr txBox="1"/>
              <p:nvPr/>
            </p:nvSpPr>
            <p:spPr>
              <a:xfrm rot="16200000">
                <a:off x="4867907" y="3815647"/>
                <a:ext cx="466903" cy="2153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99" dirty="0"/>
                  <a:t>grams</a:t>
                </a:r>
                <a:endParaRPr lang="en-US" sz="799" baseline="30000" dirty="0"/>
              </a:p>
            </p:txBody>
          </p:sp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67157569-2E10-5598-97A2-D3ED56F60B7E}"/>
                  </a:ext>
                </a:extLst>
              </p:cNvPr>
              <p:cNvGrpSpPr/>
              <p:nvPr/>
            </p:nvGrpSpPr>
            <p:grpSpPr>
              <a:xfrm>
                <a:off x="5415963" y="4579150"/>
                <a:ext cx="688196" cy="217927"/>
                <a:chOff x="5415963" y="4579150"/>
                <a:chExt cx="688196" cy="217927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02479F15-E41C-4520-A45A-B373683EA74C}"/>
                    </a:ext>
                  </a:extLst>
                </p:cNvPr>
                <p:cNvSpPr txBox="1"/>
                <p:nvPr/>
              </p:nvSpPr>
              <p:spPr>
                <a:xfrm>
                  <a:off x="5415963" y="4581762"/>
                  <a:ext cx="38308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WT</a:t>
                  </a:r>
                  <a:endParaRPr lang="en-US" sz="799" baseline="30000" dirty="0"/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FC6AF307-5189-4FF2-B300-30720F164A45}"/>
                    </a:ext>
                  </a:extLst>
                </p:cNvPr>
                <p:cNvSpPr txBox="1"/>
                <p:nvPr/>
              </p:nvSpPr>
              <p:spPr>
                <a:xfrm>
                  <a:off x="5748047" y="4579150"/>
                  <a:ext cx="356112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/>
                    <a:t>⍺</a:t>
                  </a:r>
                  <a:r>
                    <a:rPr lang="en-US" sz="799" baseline="30000" dirty="0"/>
                    <a:t>KO</a:t>
                  </a:r>
                </a:p>
              </p:txBody>
            </p:sp>
          </p:grpSp>
          <p:graphicFrame>
            <p:nvGraphicFramePr>
              <p:cNvPr id="59" name="Object 58">
                <a:extLst>
                  <a:ext uri="{FF2B5EF4-FFF2-40B4-BE49-F238E27FC236}">
                    <a16:creationId xmlns:a16="http://schemas.microsoft.com/office/drawing/2014/main" id="{1F96F364-F306-4EC5-86F7-861B63792F6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32914377"/>
                  </p:ext>
                </p:extLst>
              </p:nvPr>
            </p:nvGraphicFramePr>
            <p:xfrm>
              <a:off x="5171149" y="3330278"/>
              <a:ext cx="962025" cy="13747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6" imgW="1602244" imgH="2289859" progId="Prism8.Document">
                      <p:embed/>
                    </p:oleObj>
                  </mc:Choice>
                  <mc:Fallback>
                    <p:oleObj name="Prism 8" r:id="rId16" imgW="1602244" imgH="2289859" progId="Prism8.Document">
                      <p:embed/>
                      <p:pic>
                        <p:nvPicPr>
                          <p:cNvPr id="59" name="Object 58">
                            <a:extLst>
                              <a:ext uri="{FF2B5EF4-FFF2-40B4-BE49-F238E27FC236}">
                                <a16:creationId xmlns:a16="http://schemas.microsoft.com/office/drawing/2014/main" id="{1F96F364-F306-4EC5-86F7-861B63792F6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5171149" y="3330278"/>
                            <a:ext cx="962025" cy="13747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44B84847-64FF-4DE1-A2AF-067F1E93BE07}"/>
                  </a:ext>
                </a:extLst>
              </p:cNvPr>
              <p:cNvSpPr txBox="1"/>
              <p:nvPr/>
            </p:nvSpPr>
            <p:spPr>
              <a:xfrm>
                <a:off x="4088423" y="3142629"/>
                <a:ext cx="6358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Weight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607D1163-38C9-490B-A19A-3D7931466472}"/>
                  </a:ext>
                </a:extLst>
              </p:cNvPr>
              <p:cNvSpPr txBox="1"/>
              <p:nvPr/>
            </p:nvSpPr>
            <p:spPr>
              <a:xfrm>
                <a:off x="5267147" y="3165947"/>
                <a:ext cx="799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Food Intake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3EC0187F-C827-4E53-A784-DAE8B0F075A0}"/>
                  </a:ext>
                </a:extLst>
              </p:cNvPr>
              <p:cNvSpPr txBox="1"/>
              <p:nvPr/>
            </p:nvSpPr>
            <p:spPr>
              <a:xfrm>
                <a:off x="1831122" y="2916049"/>
                <a:ext cx="8349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Male (5 </a:t>
                </a:r>
                <a:r>
                  <a:rPr lang="en-US" sz="1000" dirty="0" err="1"/>
                  <a:t>mo</a:t>
                </a:r>
                <a:r>
                  <a:rPr lang="en-US" sz="1000" dirty="0"/>
                  <a:t>)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31580DDF-D4A0-4C08-B311-B7EC5C31F28A}"/>
                  </a:ext>
                </a:extLst>
              </p:cNvPr>
              <p:cNvSpPr txBox="1"/>
              <p:nvPr/>
            </p:nvSpPr>
            <p:spPr>
              <a:xfrm>
                <a:off x="4782776" y="2905416"/>
                <a:ext cx="9384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Female (5 </a:t>
                </a:r>
                <a:r>
                  <a:rPr lang="en-US" sz="1000" dirty="0" err="1"/>
                  <a:t>mo</a:t>
                </a:r>
                <a:r>
                  <a:rPr lang="en-US" sz="1000" dirty="0"/>
                  <a:t>)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638A497A-F741-44E8-BCFE-B9D0DDDDCE59}"/>
                  </a:ext>
                </a:extLst>
              </p:cNvPr>
              <p:cNvSpPr txBox="1"/>
              <p:nvPr/>
            </p:nvSpPr>
            <p:spPr>
              <a:xfrm>
                <a:off x="2786757" y="3672072"/>
                <a:ext cx="4441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*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A949F163-D698-DEBD-D572-80318025BFD2}"/>
                  </a:ext>
                </a:extLst>
              </p:cNvPr>
              <p:cNvSpPr txBox="1"/>
              <p:nvPr/>
            </p:nvSpPr>
            <p:spPr>
              <a:xfrm>
                <a:off x="550419" y="4878082"/>
                <a:ext cx="21531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FD590AA9-2DAD-B691-DA50-3E64E7A5E1C9}"/>
                  </a:ext>
                </a:extLst>
              </p:cNvPr>
              <p:cNvGrpSpPr/>
              <p:nvPr/>
            </p:nvGrpSpPr>
            <p:grpSpPr>
              <a:xfrm>
                <a:off x="725849" y="4970998"/>
                <a:ext cx="4861516" cy="1671545"/>
                <a:chOff x="725849" y="4791717"/>
                <a:chExt cx="4861516" cy="1671545"/>
              </a:xfrm>
            </p:grpSpPr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F432676D-ED36-0465-D413-E9E845FFB6C0}"/>
                    </a:ext>
                  </a:extLst>
                </p:cNvPr>
                <p:cNvSpPr txBox="1"/>
                <p:nvPr/>
              </p:nvSpPr>
              <p:spPr>
                <a:xfrm rot="16200000">
                  <a:off x="600055" y="5484305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/day</a:t>
                  </a:r>
                  <a:endParaRPr lang="en-US" sz="799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15" name="Object 14">
                  <a:extLst>
                    <a:ext uri="{FF2B5EF4-FFF2-40B4-BE49-F238E27FC236}">
                      <a16:creationId xmlns:a16="http://schemas.microsoft.com/office/drawing/2014/main" id="{CE068203-A511-4842-9018-3790E555D870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991786785"/>
                    </p:ext>
                  </p:extLst>
                </p:nvPr>
              </p:nvGraphicFramePr>
              <p:xfrm>
                <a:off x="910025" y="4974086"/>
                <a:ext cx="958850" cy="137318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18" imgW="1599363" imgH="2289859" progId="Prism8.Document">
                        <p:embed/>
                      </p:oleObj>
                    </mc:Choice>
                    <mc:Fallback>
                      <p:oleObj name="Prism 8" r:id="rId18" imgW="1599363" imgH="2289859" progId="Prism8.Document">
                        <p:embed/>
                        <p:pic>
                          <p:nvPicPr>
                            <p:cNvPr id="15" name="Object 14">
                              <a:extLst>
                                <a:ext uri="{FF2B5EF4-FFF2-40B4-BE49-F238E27FC236}">
                                  <a16:creationId xmlns:a16="http://schemas.microsoft.com/office/drawing/2014/main" id="{2B55A0F3-2415-D06D-6123-77B9D42ECD2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10025" y="4974086"/>
                              <a:ext cx="958850" cy="137318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A6A11BBD-6F97-B6B3-6692-CBDF1721E5A8}"/>
                    </a:ext>
                  </a:extLst>
                </p:cNvPr>
                <p:cNvSpPr txBox="1"/>
                <p:nvPr/>
              </p:nvSpPr>
              <p:spPr>
                <a:xfrm>
                  <a:off x="1441322" y="5453146"/>
                  <a:ext cx="44419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**</a:t>
                  </a:r>
                </a:p>
              </p:txBody>
            </p:sp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72F2CA5B-0DD4-CD30-286D-8E83EBAD4D3D}"/>
                    </a:ext>
                  </a:extLst>
                </p:cNvPr>
                <p:cNvGrpSpPr/>
                <p:nvPr/>
              </p:nvGrpSpPr>
              <p:grpSpPr>
                <a:xfrm>
                  <a:off x="1073189" y="6247947"/>
                  <a:ext cx="779007" cy="215315"/>
                  <a:chOff x="1047158" y="3250421"/>
                  <a:chExt cx="779007" cy="215315"/>
                </a:xfrm>
              </p:grpSpPr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3F3044FA-AE57-7CAC-8E9A-6E3464A93CD1}"/>
                      </a:ext>
                    </a:extLst>
                  </p:cNvPr>
                  <p:cNvSpPr txBox="1"/>
                  <p:nvPr/>
                </p:nvSpPr>
                <p:spPr>
                  <a:xfrm>
                    <a:off x="1047158" y="3250421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  <a:endParaRPr lang="en-US" sz="799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FE2CC111-ADB9-977B-1341-9BEBBBAD6A4A}"/>
                      </a:ext>
                    </a:extLst>
                  </p:cNvPr>
                  <p:cNvSpPr txBox="1"/>
                  <p:nvPr/>
                </p:nvSpPr>
                <p:spPr>
                  <a:xfrm>
                    <a:off x="1307817" y="3250421"/>
                    <a:ext cx="518348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⍺OT</a:t>
                    </a:r>
                    <a:r>
                      <a:rPr lang="en-US" sz="799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O</a:t>
                    </a:r>
                  </a:p>
                </p:txBody>
              </p:sp>
            </p:grp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2670EB25-A3DD-2A29-C86B-54A9009CEB14}"/>
                    </a:ext>
                  </a:extLst>
                </p:cNvPr>
                <p:cNvSpPr txBox="1"/>
                <p:nvPr/>
              </p:nvSpPr>
              <p:spPr>
                <a:xfrm>
                  <a:off x="1198089" y="4791717"/>
                  <a:ext cx="114719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ales (15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F976A8D0-71AB-379D-E492-CA4E805982F4}"/>
                    </a:ext>
                  </a:extLst>
                </p:cNvPr>
                <p:cNvSpPr txBox="1"/>
                <p:nvPr/>
              </p:nvSpPr>
              <p:spPr>
                <a:xfrm rot="16200000">
                  <a:off x="2134632" y="5484305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/day</a:t>
                  </a:r>
                  <a:endParaRPr lang="en-US" sz="799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6" name="Object 5">
                  <a:extLst>
                    <a:ext uri="{FF2B5EF4-FFF2-40B4-BE49-F238E27FC236}">
                      <a16:creationId xmlns:a16="http://schemas.microsoft.com/office/drawing/2014/main" id="{BAF9ACA1-7D73-5874-0317-797B4D8957C3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761536678"/>
                    </p:ext>
                  </p:extLst>
                </p:nvPr>
              </p:nvGraphicFramePr>
              <p:xfrm>
                <a:off x="2442683" y="4974044"/>
                <a:ext cx="960437" cy="137318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20" imgW="1599363" imgH="2289859" progId="Prism9.Document">
                        <p:embed/>
                      </p:oleObj>
                    </mc:Choice>
                    <mc:Fallback>
                      <p:oleObj name="Prism 9" r:id="rId20" imgW="1599363" imgH="2289859" progId="Prism9.Document">
                        <p:embed/>
                        <p:pic>
                          <p:nvPicPr>
                            <p:cNvPr id="8" name="Object 7">
                              <a:extLst>
                                <a:ext uri="{FF2B5EF4-FFF2-40B4-BE49-F238E27FC236}">
                                  <a16:creationId xmlns:a16="http://schemas.microsoft.com/office/drawing/2014/main" id="{AF37890B-A335-7875-339D-2410B854609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442683" y="4974044"/>
                              <a:ext cx="960437" cy="137318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308F20BB-38E3-D00F-9CFD-EC74B37C3783}"/>
                    </a:ext>
                  </a:extLst>
                </p:cNvPr>
                <p:cNvSpPr txBox="1"/>
                <p:nvPr/>
              </p:nvSpPr>
              <p:spPr>
                <a:xfrm>
                  <a:off x="3009306" y="5343762"/>
                  <a:ext cx="44419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/>
                    <a:t>*</a:t>
                  </a:r>
                </a:p>
              </p:txBody>
            </p:sp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4834E0ED-C94B-7435-7449-7040544A1490}"/>
                    </a:ext>
                  </a:extLst>
                </p:cNvPr>
                <p:cNvGrpSpPr/>
                <p:nvPr/>
              </p:nvGrpSpPr>
              <p:grpSpPr>
                <a:xfrm>
                  <a:off x="2601944" y="6234807"/>
                  <a:ext cx="779007" cy="215315"/>
                  <a:chOff x="1047158" y="3250421"/>
                  <a:chExt cx="779007" cy="215315"/>
                </a:xfrm>
              </p:grpSpPr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C1BF2C34-F90C-AB2E-D5D1-910B519E7BAF}"/>
                      </a:ext>
                    </a:extLst>
                  </p:cNvPr>
                  <p:cNvSpPr txBox="1"/>
                  <p:nvPr/>
                </p:nvSpPr>
                <p:spPr>
                  <a:xfrm>
                    <a:off x="1047158" y="3250421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  <a:endParaRPr lang="en-US" sz="799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FC218708-3EB4-B24D-0347-8C66F9D7E8F7}"/>
                      </a:ext>
                    </a:extLst>
                  </p:cNvPr>
                  <p:cNvSpPr txBox="1"/>
                  <p:nvPr/>
                </p:nvSpPr>
                <p:spPr>
                  <a:xfrm>
                    <a:off x="1307817" y="3250421"/>
                    <a:ext cx="518348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⍺OT</a:t>
                    </a:r>
                    <a:r>
                      <a:rPr lang="en-US" sz="799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O</a:t>
                    </a:r>
                  </a:p>
                </p:txBody>
              </p:sp>
            </p:grp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AF2A3D34-4838-BD4E-F239-0672C2928EC0}"/>
                    </a:ext>
                  </a:extLst>
                </p:cNvPr>
                <p:cNvSpPr txBox="1"/>
                <p:nvPr/>
              </p:nvSpPr>
              <p:spPr>
                <a:xfrm>
                  <a:off x="2659157" y="4791717"/>
                  <a:ext cx="128454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emales (15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graphicFrame>
              <p:nvGraphicFramePr>
                <p:cNvPr id="67" name="Object 66">
                  <a:extLst>
                    <a:ext uri="{FF2B5EF4-FFF2-40B4-BE49-F238E27FC236}">
                      <a16:creationId xmlns:a16="http://schemas.microsoft.com/office/drawing/2014/main" id="{68DC743E-30FB-66A8-1527-40EB03B2D7A5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68751310"/>
                    </p:ext>
                  </p:extLst>
                </p:nvPr>
              </p:nvGraphicFramePr>
              <p:xfrm>
                <a:off x="4086724" y="4996236"/>
                <a:ext cx="960437" cy="1305009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22" imgW="2393462" imgH="3246068" progId="Prism9.Document">
                        <p:embed/>
                      </p:oleObj>
                    </mc:Choice>
                    <mc:Fallback>
                      <p:oleObj name="Prism 9" r:id="rId22" imgW="2393462" imgH="3246068" progId="Prism9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2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086724" y="4996236"/>
                              <a:ext cx="960437" cy="1305009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pSp>
              <p:nvGrpSpPr>
                <p:cNvPr id="71" name="Group 70">
                  <a:extLst>
                    <a:ext uri="{FF2B5EF4-FFF2-40B4-BE49-F238E27FC236}">
                      <a16:creationId xmlns:a16="http://schemas.microsoft.com/office/drawing/2014/main" id="{FC318F1D-7699-5F31-BD6F-DF45C7C36A0B}"/>
                    </a:ext>
                  </a:extLst>
                </p:cNvPr>
                <p:cNvGrpSpPr/>
                <p:nvPr/>
              </p:nvGrpSpPr>
              <p:grpSpPr>
                <a:xfrm>
                  <a:off x="4256393" y="6242303"/>
                  <a:ext cx="688196" cy="217927"/>
                  <a:chOff x="5415963" y="4579150"/>
                  <a:chExt cx="688196" cy="217927"/>
                </a:xfrm>
              </p:grpSpPr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C42E5197-F312-196D-EA44-7C212ECAF6CF}"/>
                      </a:ext>
                    </a:extLst>
                  </p:cNvPr>
                  <p:cNvSpPr txBox="1"/>
                  <p:nvPr/>
                </p:nvSpPr>
                <p:spPr>
                  <a:xfrm>
                    <a:off x="5415963" y="4581762"/>
                    <a:ext cx="38308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WT</a:t>
                    </a:r>
                    <a:endParaRPr lang="en-US" sz="799" baseline="30000" dirty="0"/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371929BF-10C0-96E6-B8E5-4AED9CA26C3F}"/>
                      </a:ext>
                    </a:extLst>
                  </p:cNvPr>
                  <p:cNvSpPr txBox="1"/>
                  <p:nvPr/>
                </p:nvSpPr>
                <p:spPr>
                  <a:xfrm>
                    <a:off x="5748047" y="4579150"/>
                    <a:ext cx="356112" cy="2153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99" dirty="0"/>
                      <a:t>⍺</a:t>
                    </a:r>
                    <a:r>
                      <a:rPr lang="en-US" sz="799" baseline="30000" dirty="0"/>
                      <a:t>KO</a:t>
                    </a:r>
                  </a:p>
                </p:txBody>
              </p:sp>
            </p:grp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6BEED9CD-8B20-9529-5200-01FB9884021A}"/>
                    </a:ext>
                  </a:extLst>
                </p:cNvPr>
                <p:cNvSpPr txBox="1"/>
                <p:nvPr/>
              </p:nvSpPr>
              <p:spPr>
                <a:xfrm>
                  <a:off x="4363902" y="4791717"/>
                  <a:ext cx="122346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ales (15 </a:t>
                  </a:r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</a:t>
                  </a: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33688609-B42B-3C1E-D432-DCB1ECA2B578}"/>
                    </a:ext>
                  </a:extLst>
                </p:cNvPr>
                <p:cNvSpPr txBox="1"/>
                <p:nvPr/>
              </p:nvSpPr>
              <p:spPr>
                <a:xfrm rot="16200000">
                  <a:off x="3758022" y="5485636"/>
                  <a:ext cx="466903" cy="2153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9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/day</a:t>
                  </a:r>
                  <a:endParaRPr lang="en-US" sz="799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EEA201B3-908F-A137-7143-93DA4DA20695}"/>
                    </a:ext>
                  </a:extLst>
                </p:cNvPr>
                <p:cNvSpPr txBox="1"/>
                <p:nvPr/>
              </p:nvSpPr>
              <p:spPr>
                <a:xfrm>
                  <a:off x="4211301" y="4984640"/>
                  <a:ext cx="7994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Food Intake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B546BAAD-8EC3-373F-ACBA-5542F8DD157F}"/>
                    </a:ext>
                  </a:extLst>
                </p:cNvPr>
                <p:cNvSpPr txBox="1"/>
                <p:nvPr/>
              </p:nvSpPr>
              <p:spPr>
                <a:xfrm>
                  <a:off x="2629600" y="4984640"/>
                  <a:ext cx="7994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Food Intake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4E983560-FBA9-2324-E9B7-4BE539CE3C1C}"/>
                    </a:ext>
                  </a:extLst>
                </p:cNvPr>
                <p:cNvSpPr txBox="1"/>
                <p:nvPr/>
              </p:nvSpPr>
              <p:spPr>
                <a:xfrm>
                  <a:off x="1078487" y="4984640"/>
                  <a:ext cx="7994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Food Intake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241524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85</TotalTime>
  <Words>994</Words>
  <Application>Microsoft Office PowerPoint</Application>
  <PresentationFormat>Letter Paper (8.5x11 in)</PresentationFormat>
  <Paragraphs>294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4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Times New Roman</vt:lpstr>
      <vt:lpstr>Office Theme</vt:lpstr>
      <vt:lpstr>GraphPad Prism 9 Project</vt:lpstr>
      <vt:lpstr>Prism 8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eckac@outlook.com</dc:creator>
  <cp:lastModifiedBy>bleckac@outlook.com</cp:lastModifiedBy>
  <cp:revision>9</cp:revision>
  <cp:lastPrinted>2023-01-16T03:26:39Z</cp:lastPrinted>
  <dcterms:created xsi:type="dcterms:W3CDTF">2023-01-15T16:59:27Z</dcterms:created>
  <dcterms:modified xsi:type="dcterms:W3CDTF">2023-03-12T01:53:50Z</dcterms:modified>
</cp:coreProperties>
</file>